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notesMasterIdLst>
    <p:notesMasterId r:id="rId6"/>
  </p:notesMasterIdLst>
  <p:sldIdLst>
    <p:sldId id="257" r:id="rId5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200" d="100"/>
          <a:sy n="200" d="100"/>
        </p:scale>
        <p:origin x="-200" y="359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ustomXml" Target="../customXml/item3.xml"/><Relationship Id="rId4" Type="http://schemas.openxmlformats.org/officeDocument/2006/relationships/slideMaster" Target="slideMasters/slideMaster1.xml"/><Relationship Id="rId5" Type="http://schemas.openxmlformats.org/officeDocument/2006/relationships/slide" Target="slides/slide1.xml"/><Relationship Id="rId6" Type="http://schemas.openxmlformats.org/officeDocument/2006/relationships/notesMaster" Target="notesMasters/notesMaster1.xml"/><Relationship Id="rId7" Type="http://schemas.openxmlformats.org/officeDocument/2006/relationships/printerSettings" Target="printerSettings/printerSettings1.bin"/><Relationship Id="rId8" Type="http://schemas.openxmlformats.org/officeDocument/2006/relationships/presProps" Target="presProps.xml"/><Relationship Id="rId9" Type="http://schemas.openxmlformats.org/officeDocument/2006/relationships/viewProps" Target="viewProps.xml"/><Relationship Id="rId10" Type="http://schemas.openxmlformats.org/officeDocument/2006/relationships/theme" Target="theme/theme1.xml"/><Relationship Id="rId11" Type="http://schemas.openxmlformats.org/officeDocument/2006/relationships/tableStyles" Target="tableStyles.xml"/><Relationship Id="rId1" Type="http://schemas.openxmlformats.org/officeDocument/2006/relationships/customXml" Target="../customXml/item1.xml"/><Relationship Id="rId2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94141E1-2B82-45B1-A894-B1094BB568A6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9A9F4F0-92C0-4C3F-B5C3-C30C7B854696}" type="slidenum">
              <a:rPr lang="fr-FR" smtClean="0"/>
              <a:pPr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4986663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5A05D9E-4D1D-43C8-9D11-59366B3567A4}" type="slidenum">
              <a:rPr lang="fr-FR" smtClean="0"/>
              <a:pPr/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74AAB7-279F-45BF-896D-1654C2E73993}" type="datetimeFigureOut">
              <a:rPr lang="fr-FR" smtClean="0"/>
              <a:pPr/>
              <a:t>18/04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A9B511-704D-4FF0-8820-84E9B404F93E}" type="slidenum">
              <a:rPr lang="fr-FR" smtClean="0"/>
              <a:pPr/>
              <a:t>‹#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63" name="Groupe 362"/>
          <p:cNvGrpSpPr/>
          <p:nvPr/>
        </p:nvGrpSpPr>
        <p:grpSpPr>
          <a:xfrm>
            <a:off x="0" y="0"/>
            <a:ext cx="6764316" cy="7640114"/>
            <a:chOff x="0" y="0"/>
            <a:chExt cx="6764316" cy="7640114"/>
          </a:xfrm>
        </p:grpSpPr>
        <p:sp>
          <p:nvSpPr>
            <p:cNvPr id="89" name="ZoneTexte 88"/>
            <p:cNvSpPr txBox="1"/>
            <p:nvPr/>
          </p:nvSpPr>
          <p:spPr>
            <a:xfrm>
              <a:off x="1776211" y="1605782"/>
              <a:ext cx="730649" cy="566308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spc="-30" dirty="0" smtClean="0">
                  <a:solidFill>
                    <a:schemeClr val="bg1">
                      <a:lumMod val="50000"/>
                    </a:schemeClr>
                  </a:solidFill>
                  <a:latin typeface="Times New Roman" pitchFamily="18" charset="0"/>
                  <a:cs typeface="Times New Roman" pitchFamily="18" charset="0"/>
                </a:rPr>
                <a:t>Pv05Sk01110</a:t>
              </a:r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12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13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14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15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16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170</a:t>
              </a: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6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600" spc="-30" dirty="0">
                <a:latin typeface="Times New Roman" pitchFamily="18" charset="0"/>
                <a:cs typeface="Times New Roman" pitchFamily="18" charset="0"/>
              </a:endParaRPr>
            </a:p>
            <a:p>
              <a:endParaRPr lang="fr-FR" sz="800" spc="-30" dirty="0" smtClean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18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19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20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21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220</a:t>
              </a:r>
            </a:p>
            <a:p>
              <a:r>
                <a:rPr lang="fr-FR" sz="700" spc="-30" dirty="0" smtClean="0">
                  <a:solidFill>
                    <a:schemeClr val="bg1">
                      <a:lumMod val="50000"/>
                    </a:schemeClr>
                  </a:solidFill>
                  <a:latin typeface="Times New Roman" pitchFamily="18" charset="0"/>
                  <a:cs typeface="Times New Roman" pitchFamily="18" charset="0"/>
                </a:rPr>
                <a:t>Pv05Sk01230</a:t>
              </a:r>
              <a:endParaRPr lang="fr-FR" sz="700" spc="-30" dirty="0">
                <a:latin typeface="Times New Roman" pitchFamily="18" charset="0"/>
                <a:cs typeface="Times New Roman" pitchFamily="18" charset="0"/>
              </a:endParaRP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24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250</a:t>
              </a:r>
            </a:p>
            <a:p>
              <a:r>
                <a:rPr lang="fr-FR" sz="800" b="1" u="sng" spc="-3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05Sk01260</a:t>
              </a:r>
            </a:p>
          </p:txBody>
        </p:sp>
        <p:cxnSp>
          <p:nvCxnSpPr>
            <p:cNvPr id="281" name="Connecteur droit 280"/>
            <p:cNvCxnSpPr/>
            <p:nvPr/>
          </p:nvCxnSpPr>
          <p:spPr>
            <a:xfrm rot="5400000">
              <a:off x="1129587" y="6693108"/>
              <a:ext cx="129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Forme libre 5"/>
            <p:cNvSpPr/>
            <p:nvPr/>
          </p:nvSpPr>
          <p:spPr>
            <a:xfrm>
              <a:off x="997610" y="1752606"/>
              <a:ext cx="724446" cy="745791"/>
            </a:xfrm>
            <a:custGeom>
              <a:avLst/>
              <a:gdLst>
                <a:gd name="connsiteX0" fmla="*/ 0 w 968375"/>
                <a:gd name="connsiteY0" fmla="*/ 0 h 1143000"/>
                <a:gd name="connsiteX1" fmla="*/ 968375 w 968375"/>
                <a:gd name="connsiteY1" fmla="*/ 0 h 1143000"/>
                <a:gd name="connsiteX2" fmla="*/ 968375 w 968375"/>
                <a:gd name="connsiteY2" fmla="*/ 1139825 h 1143000"/>
                <a:gd name="connsiteX3" fmla="*/ 0 w 968375"/>
                <a:gd name="connsiteY3" fmla="*/ 1143000 h 1143000"/>
                <a:gd name="connsiteX4" fmla="*/ 0 w 968375"/>
                <a:gd name="connsiteY4" fmla="*/ 0 h 1143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68375" h="1143000">
                  <a:moveTo>
                    <a:pt x="0" y="0"/>
                  </a:moveTo>
                  <a:lnTo>
                    <a:pt x="968375" y="0"/>
                  </a:lnTo>
                  <a:lnTo>
                    <a:pt x="968375" y="1139825"/>
                  </a:lnTo>
                  <a:lnTo>
                    <a:pt x="0" y="114300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333FF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" name="Forme libre 6"/>
            <p:cNvSpPr/>
            <p:nvPr/>
          </p:nvSpPr>
          <p:spPr>
            <a:xfrm>
              <a:off x="994764" y="6812170"/>
              <a:ext cx="729220" cy="387909"/>
            </a:xfrm>
            <a:custGeom>
              <a:avLst/>
              <a:gdLst>
                <a:gd name="connsiteX0" fmla="*/ 0 w 974757"/>
                <a:gd name="connsiteY0" fmla="*/ 0 h 594511"/>
                <a:gd name="connsiteX1" fmla="*/ 974757 w 974757"/>
                <a:gd name="connsiteY1" fmla="*/ 404388 h 594511"/>
                <a:gd name="connsiteX2" fmla="*/ 974757 w 974757"/>
                <a:gd name="connsiteY2" fmla="*/ 594511 h 594511"/>
                <a:gd name="connsiteX3" fmla="*/ 3018 w 974757"/>
                <a:gd name="connsiteY3" fmla="*/ 190123 h 594511"/>
                <a:gd name="connsiteX4" fmla="*/ 0 w 974757"/>
                <a:gd name="connsiteY4" fmla="*/ 0 h 59451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74757" h="594511">
                  <a:moveTo>
                    <a:pt x="0" y="0"/>
                  </a:moveTo>
                  <a:lnTo>
                    <a:pt x="974757" y="404388"/>
                  </a:lnTo>
                  <a:lnTo>
                    <a:pt x="974757" y="594511"/>
                  </a:lnTo>
                  <a:lnTo>
                    <a:pt x="3018" y="19012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333FF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8" name="Forme libre 7"/>
            <p:cNvSpPr/>
            <p:nvPr/>
          </p:nvSpPr>
          <p:spPr>
            <a:xfrm>
              <a:off x="994764" y="6077702"/>
              <a:ext cx="731478" cy="998326"/>
            </a:xfrm>
            <a:custGeom>
              <a:avLst/>
              <a:gdLst>
                <a:gd name="connsiteX0" fmla="*/ 0 w 977775"/>
                <a:gd name="connsiteY0" fmla="*/ 0 h 1530035"/>
                <a:gd name="connsiteX1" fmla="*/ 3018 w 977775"/>
                <a:gd name="connsiteY1" fmla="*/ 745402 h 1530035"/>
                <a:gd name="connsiteX2" fmla="*/ 974757 w 977775"/>
                <a:gd name="connsiteY2" fmla="*/ 1530035 h 1530035"/>
                <a:gd name="connsiteX3" fmla="*/ 977775 w 977775"/>
                <a:gd name="connsiteY3" fmla="*/ 775580 h 1530035"/>
                <a:gd name="connsiteX4" fmla="*/ 0 w 977775"/>
                <a:gd name="connsiteY4" fmla="*/ 0 h 1530035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77775" h="1530035">
                  <a:moveTo>
                    <a:pt x="0" y="0"/>
                  </a:moveTo>
                  <a:lnTo>
                    <a:pt x="3018" y="745402"/>
                  </a:lnTo>
                  <a:lnTo>
                    <a:pt x="974757" y="1530035"/>
                  </a:lnTo>
                  <a:lnTo>
                    <a:pt x="977775" y="77558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3333FF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9" name="Forme libre 8"/>
            <p:cNvSpPr/>
            <p:nvPr/>
          </p:nvSpPr>
          <p:spPr>
            <a:xfrm>
              <a:off x="997022" y="5374739"/>
              <a:ext cx="729220" cy="1084967"/>
            </a:xfrm>
            <a:custGeom>
              <a:avLst/>
              <a:gdLst>
                <a:gd name="connsiteX0" fmla="*/ 971739 w 974757"/>
                <a:gd name="connsiteY0" fmla="*/ 1662820 h 1662820"/>
                <a:gd name="connsiteX1" fmla="*/ 974757 w 974757"/>
                <a:gd name="connsiteY1" fmla="*/ 1089434 h 1662820"/>
                <a:gd name="connsiteX2" fmla="*/ 0 w 974757"/>
                <a:gd name="connsiteY2" fmla="*/ 0 h 1662820"/>
                <a:gd name="connsiteX3" fmla="*/ 0 w 974757"/>
                <a:gd name="connsiteY3" fmla="*/ 567351 h 1662820"/>
                <a:gd name="connsiteX4" fmla="*/ 971739 w 974757"/>
                <a:gd name="connsiteY4" fmla="*/ 1662820 h 166282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74757" h="1662820">
                  <a:moveTo>
                    <a:pt x="971739" y="1662820"/>
                  </a:moveTo>
                  <a:lnTo>
                    <a:pt x="974757" y="1089434"/>
                  </a:lnTo>
                  <a:lnTo>
                    <a:pt x="0" y="0"/>
                  </a:lnTo>
                  <a:lnTo>
                    <a:pt x="0" y="567351"/>
                  </a:lnTo>
                  <a:lnTo>
                    <a:pt x="971739" y="1662820"/>
                  </a:lnTo>
                  <a:close/>
                </a:path>
              </a:pathLst>
            </a:custGeom>
            <a:solidFill>
              <a:srgbClr val="3333FF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11" name="Connecteur droit 10"/>
            <p:cNvCxnSpPr/>
            <p:nvPr/>
          </p:nvCxnSpPr>
          <p:spPr>
            <a:xfrm rot="5400000">
              <a:off x="-1953474" y="4384641"/>
              <a:ext cx="5796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Connecteur droit 11"/>
            <p:cNvCxnSpPr/>
            <p:nvPr/>
          </p:nvCxnSpPr>
          <p:spPr>
            <a:xfrm rot="5400000">
              <a:off x="1296383" y="1899243"/>
              <a:ext cx="963069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Rectangle 12"/>
            <p:cNvSpPr/>
            <p:nvPr/>
          </p:nvSpPr>
          <p:spPr>
            <a:xfrm rot="5400000">
              <a:off x="1712951" y="2132070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4" name="Rectangle 13"/>
            <p:cNvSpPr/>
            <p:nvPr/>
          </p:nvSpPr>
          <p:spPr>
            <a:xfrm rot="5400000">
              <a:off x="1712951" y="2255444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5" name="Rectangle 14"/>
            <p:cNvSpPr/>
            <p:nvPr/>
          </p:nvSpPr>
          <p:spPr>
            <a:xfrm rot="5400000">
              <a:off x="1712951" y="2379939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6" name="ZoneTexte 15"/>
            <p:cNvSpPr txBox="1"/>
            <p:nvPr/>
          </p:nvSpPr>
          <p:spPr>
            <a:xfrm>
              <a:off x="1213000" y="818505"/>
              <a:ext cx="11948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b="1" dirty="0" err="1" smtClean="0">
                  <a:latin typeface="Times New Roman" pitchFamily="18" charset="0"/>
                  <a:cs typeface="Times New Roman" pitchFamily="18" charset="0"/>
                </a:rPr>
                <a:t>Pseudomolecule</a:t>
              </a:r>
              <a:r>
                <a:rPr lang="fr-FR" sz="900" b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</a:p>
            <a:p>
              <a:pPr algn="ctr"/>
              <a:r>
                <a:rPr lang="fr-FR" sz="900" b="1" dirty="0" smtClean="0">
                  <a:latin typeface="Times New Roman" pitchFamily="18" charset="0"/>
                  <a:cs typeface="Times New Roman" pitchFamily="18" charset="0"/>
                </a:rPr>
                <a:t>Chr05S</a:t>
              </a:r>
              <a:endParaRPr lang="fr-FR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7" name="ZoneTexte 16"/>
            <p:cNvSpPr txBox="1"/>
            <p:nvPr/>
          </p:nvSpPr>
          <p:spPr>
            <a:xfrm>
              <a:off x="349796" y="817871"/>
              <a:ext cx="11401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b="1" dirty="0" smtClean="0">
                  <a:latin typeface="Times New Roman" pitchFamily="18" charset="0"/>
                  <a:cs typeface="Times New Roman" pitchFamily="18" charset="0"/>
                </a:rPr>
                <a:t>BAC Contig</a:t>
              </a:r>
            </a:p>
            <a:p>
              <a:pPr algn="ctr"/>
              <a:r>
                <a:rPr lang="fr-FR" sz="900" b="1" dirty="0" smtClean="0">
                  <a:latin typeface="Times New Roman" pitchFamily="18" charset="0"/>
                  <a:cs typeface="Times New Roman" pitchFamily="18" charset="0"/>
                </a:rPr>
                <a:t>PvA05A</a:t>
              </a:r>
              <a:endParaRPr lang="fr-FR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8" name="Rectangle 17"/>
            <p:cNvSpPr/>
            <p:nvPr/>
          </p:nvSpPr>
          <p:spPr>
            <a:xfrm rot="5400000">
              <a:off x="1713106" y="1759707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19" name="Rectangle 18"/>
            <p:cNvSpPr/>
            <p:nvPr/>
          </p:nvSpPr>
          <p:spPr>
            <a:xfrm rot="5400000">
              <a:off x="1713106" y="1883082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0" name="Rectangle 19"/>
            <p:cNvSpPr/>
            <p:nvPr/>
          </p:nvSpPr>
          <p:spPr>
            <a:xfrm rot="5400000">
              <a:off x="1713106" y="2007576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cxnSp>
          <p:nvCxnSpPr>
            <p:cNvPr id="21" name="Connecteur droit 20"/>
            <p:cNvCxnSpPr/>
            <p:nvPr/>
          </p:nvCxnSpPr>
          <p:spPr>
            <a:xfrm>
              <a:off x="1777916" y="2517735"/>
              <a:ext cx="0" cy="3683649"/>
            </a:xfrm>
            <a:prstGeom prst="line">
              <a:avLst/>
            </a:prstGeom>
            <a:ln w="25400"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Rectangle 21"/>
            <p:cNvSpPr/>
            <p:nvPr/>
          </p:nvSpPr>
          <p:spPr>
            <a:xfrm rot="5400000">
              <a:off x="1715670" y="6093710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3" name="Rectangle 22"/>
            <p:cNvSpPr/>
            <p:nvPr/>
          </p:nvSpPr>
          <p:spPr>
            <a:xfrm rot="5400000">
              <a:off x="1715670" y="6218205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4" name="Rectangle 23"/>
            <p:cNvSpPr/>
            <p:nvPr/>
          </p:nvSpPr>
          <p:spPr>
            <a:xfrm rot="5400000">
              <a:off x="1715670" y="6342699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5" name="Rectangle 24"/>
            <p:cNvSpPr/>
            <p:nvPr/>
          </p:nvSpPr>
          <p:spPr>
            <a:xfrm rot="5400000">
              <a:off x="1731897" y="1655261"/>
              <a:ext cx="86911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6" name="Rectangle 25"/>
            <p:cNvSpPr/>
            <p:nvPr/>
          </p:nvSpPr>
          <p:spPr>
            <a:xfrm rot="5400000">
              <a:off x="882125" y="2132070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7" name="Rectangle 26"/>
            <p:cNvSpPr/>
            <p:nvPr/>
          </p:nvSpPr>
          <p:spPr>
            <a:xfrm rot="5400000">
              <a:off x="882125" y="2255444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8" name="Rectangle 27"/>
            <p:cNvSpPr/>
            <p:nvPr/>
          </p:nvSpPr>
          <p:spPr>
            <a:xfrm rot="5400000">
              <a:off x="882125" y="2379939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29" name="Rectangle 28"/>
            <p:cNvSpPr/>
            <p:nvPr/>
          </p:nvSpPr>
          <p:spPr>
            <a:xfrm rot="5400000">
              <a:off x="882280" y="1759707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0" name="Rectangle 29"/>
            <p:cNvSpPr/>
            <p:nvPr/>
          </p:nvSpPr>
          <p:spPr>
            <a:xfrm rot="5400000">
              <a:off x="882280" y="1883082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1" name="Rectangle 30"/>
            <p:cNvSpPr/>
            <p:nvPr/>
          </p:nvSpPr>
          <p:spPr>
            <a:xfrm rot="5400000">
              <a:off x="882280" y="2007576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2" name="Rectangle 31"/>
            <p:cNvSpPr/>
            <p:nvPr/>
          </p:nvSpPr>
          <p:spPr>
            <a:xfrm rot="5400000">
              <a:off x="901071" y="1655261"/>
              <a:ext cx="86911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3" name="Rectangle 32"/>
            <p:cNvSpPr/>
            <p:nvPr/>
          </p:nvSpPr>
          <p:spPr>
            <a:xfrm rot="5400000">
              <a:off x="881970" y="2876797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4" name="Rectangle 33"/>
            <p:cNvSpPr/>
            <p:nvPr/>
          </p:nvSpPr>
          <p:spPr>
            <a:xfrm rot="5400000">
              <a:off x="881970" y="3000171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5" name="Rectangle 34"/>
            <p:cNvSpPr/>
            <p:nvPr/>
          </p:nvSpPr>
          <p:spPr>
            <a:xfrm rot="5400000">
              <a:off x="882125" y="2504433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6" name="Rectangle 35"/>
            <p:cNvSpPr/>
            <p:nvPr/>
          </p:nvSpPr>
          <p:spPr>
            <a:xfrm rot="5400000">
              <a:off x="882125" y="2627808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7" name="Rectangle 36"/>
            <p:cNvSpPr/>
            <p:nvPr/>
          </p:nvSpPr>
          <p:spPr>
            <a:xfrm rot="5400000">
              <a:off x="882125" y="2752302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8" name="Rectangle 37"/>
            <p:cNvSpPr/>
            <p:nvPr/>
          </p:nvSpPr>
          <p:spPr>
            <a:xfrm rot="5400000">
              <a:off x="896913" y="3108881"/>
              <a:ext cx="93958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39" name="Rectangle 38"/>
            <p:cNvSpPr/>
            <p:nvPr/>
          </p:nvSpPr>
          <p:spPr>
            <a:xfrm rot="5400000">
              <a:off x="888691" y="3211061"/>
              <a:ext cx="110400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0" name="Rectangle 39"/>
            <p:cNvSpPr/>
            <p:nvPr/>
          </p:nvSpPr>
          <p:spPr>
            <a:xfrm rot="5400000">
              <a:off x="909832" y="3300320"/>
              <a:ext cx="68119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1" name="Rectangle 40"/>
            <p:cNvSpPr/>
            <p:nvPr/>
          </p:nvSpPr>
          <p:spPr>
            <a:xfrm rot="5400000">
              <a:off x="881490" y="3768991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2" name="Rectangle 41"/>
            <p:cNvSpPr/>
            <p:nvPr/>
          </p:nvSpPr>
          <p:spPr>
            <a:xfrm rot="5400000">
              <a:off x="881490" y="3892365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3" name="Rectangle 42"/>
            <p:cNvSpPr/>
            <p:nvPr/>
          </p:nvSpPr>
          <p:spPr>
            <a:xfrm rot="5400000">
              <a:off x="881490" y="4016859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4" name="Rectangle 43"/>
            <p:cNvSpPr/>
            <p:nvPr/>
          </p:nvSpPr>
          <p:spPr>
            <a:xfrm rot="5400000">
              <a:off x="881644" y="3396627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5" name="Rectangle 44"/>
            <p:cNvSpPr/>
            <p:nvPr/>
          </p:nvSpPr>
          <p:spPr>
            <a:xfrm rot="5400000">
              <a:off x="881644" y="3520002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6" name="Rectangle 45"/>
            <p:cNvSpPr/>
            <p:nvPr/>
          </p:nvSpPr>
          <p:spPr>
            <a:xfrm rot="5400000">
              <a:off x="881644" y="3644496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7" name="Rectangle 46"/>
            <p:cNvSpPr/>
            <p:nvPr/>
          </p:nvSpPr>
          <p:spPr>
            <a:xfrm rot="5400000">
              <a:off x="881490" y="4141353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8" name="Rectangle 47"/>
            <p:cNvSpPr/>
            <p:nvPr/>
          </p:nvSpPr>
          <p:spPr>
            <a:xfrm rot="5400000">
              <a:off x="881490" y="4264728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49" name="Rectangle 48"/>
            <p:cNvSpPr/>
            <p:nvPr/>
          </p:nvSpPr>
          <p:spPr>
            <a:xfrm rot="5400000">
              <a:off x="881335" y="4637705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0" name="Rectangle 49"/>
            <p:cNvSpPr/>
            <p:nvPr/>
          </p:nvSpPr>
          <p:spPr>
            <a:xfrm rot="5400000">
              <a:off x="881335" y="4761080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1" name="Rectangle 50"/>
            <p:cNvSpPr/>
            <p:nvPr/>
          </p:nvSpPr>
          <p:spPr>
            <a:xfrm rot="5400000">
              <a:off x="881335" y="4885574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2" name="Rectangle 51"/>
            <p:cNvSpPr/>
            <p:nvPr/>
          </p:nvSpPr>
          <p:spPr>
            <a:xfrm rot="5400000">
              <a:off x="881490" y="4388716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3" name="Rectangle 52"/>
            <p:cNvSpPr/>
            <p:nvPr/>
          </p:nvSpPr>
          <p:spPr>
            <a:xfrm rot="5400000">
              <a:off x="881490" y="4513211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4" name="Rectangle 53"/>
            <p:cNvSpPr/>
            <p:nvPr/>
          </p:nvSpPr>
          <p:spPr>
            <a:xfrm rot="5400000">
              <a:off x="881335" y="5010068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5" name="Rectangle 54"/>
            <p:cNvSpPr/>
            <p:nvPr/>
          </p:nvSpPr>
          <p:spPr>
            <a:xfrm rot="5400000">
              <a:off x="881335" y="5133443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6" name="Rectangle 55"/>
            <p:cNvSpPr/>
            <p:nvPr/>
          </p:nvSpPr>
          <p:spPr>
            <a:xfrm rot="5400000">
              <a:off x="881335" y="5257937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7" name="Rectangle 56"/>
            <p:cNvSpPr/>
            <p:nvPr/>
          </p:nvSpPr>
          <p:spPr>
            <a:xfrm rot="5400000">
              <a:off x="881335" y="5381312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8" name="Rectangle 57"/>
            <p:cNvSpPr/>
            <p:nvPr/>
          </p:nvSpPr>
          <p:spPr>
            <a:xfrm rot="5400000">
              <a:off x="881335" y="5505806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59" name="Rectangle 58"/>
            <p:cNvSpPr/>
            <p:nvPr/>
          </p:nvSpPr>
          <p:spPr>
            <a:xfrm rot="5400000">
              <a:off x="881335" y="5630300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0" name="Rectangle 59"/>
            <p:cNvSpPr/>
            <p:nvPr/>
          </p:nvSpPr>
          <p:spPr>
            <a:xfrm rot="5400000">
              <a:off x="881335" y="5753675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1" name="Rectangle 60"/>
            <p:cNvSpPr/>
            <p:nvPr/>
          </p:nvSpPr>
          <p:spPr>
            <a:xfrm rot="5400000">
              <a:off x="884858" y="6201099"/>
              <a:ext cx="117447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2" name="Rectangle 61"/>
            <p:cNvSpPr/>
            <p:nvPr/>
          </p:nvSpPr>
          <p:spPr>
            <a:xfrm rot="5400000">
              <a:off x="881335" y="6322070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3" name="Rectangle 62"/>
            <p:cNvSpPr/>
            <p:nvPr/>
          </p:nvSpPr>
          <p:spPr>
            <a:xfrm rot="5400000">
              <a:off x="881335" y="6446563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4" name="Rectangle 63"/>
            <p:cNvSpPr/>
            <p:nvPr/>
          </p:nvSpPr>
          <p:spPr>
            <a:xfrm rot="5400000">
              <a:off x="881335" y="6571058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5" name="Rectangle 64"/>
            <p:cNvSpPr/>
            <p:nvPr/>
          </p:nvSpPr>
          <p:spPr>
            <a:xfrm rot="5400000">
              <a:off x="881335" y="6695552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6" name="Rectangle 65"/>
            <p:cNvSpPr/>
            <p:nvPr/>
          </p:nvSpPr>
          <p:spPr>
            <a:xfrm rot="5400000">
              <a:off x="881335" y="6820046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7" name="Rectangle 66"/>
            <p:cNvSpPr/>
            <p:nvPr/>
          </p:nvSpPr>
          <p:spPr>
            <a:xfrm rot="5400000">
              <a:off x="881335" y="7033046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8" name="Rectangle 67"/>
            <p:cNvSpPr/>
            <p:nvPr/>
          </p:nvSpPr>
          <p:spPr>
            <a:xfrm rot="5400000">
              <a:off x="884858" y="6083652"/>
              <a:ext cx="117447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69" name="Rectangle 68"/>
            <p:cNvSpPr/>
            <p:nvPr/>
          </p:nvSpPr>
          <p:spPr>
            <a:xfrm rot="5400000">
              <a:off x="1715670" y="6467192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0" name="Rectangle 69"/>
            <p:cNvSpPr/>
            <p:nvPr/>
          </p:nvSpPr>
          <p:spPr>
            <a:xfrm rot="5400000">
              <a:off x="1715670" y="6591687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1" name="Rectangle 70"/>
            <p:cNvSpPr/>
            <p:nvPr/>
          </p:nvSpPr>
          <p:spPr>
            <a:xfrm rot="5400000">
              <a:off x="1719193" y="6712657"/>
              <a:ext cx="117447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2" name="Rectangle 71"/>
            <p:cNvSpPr/>
            <p:nvPr/>
          </p:nvSpPr>
          <p:spPr>
            <a:xfrm rot="5400000">
              <a:off x="1715670" y="6834768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3" name="Rectangle 72"/>
            <p:cNvSpPr/>
            <p:nvPr/>
          </p:nvSpPr>
          <p:spPr>
            <a:xfrm rot="5400000">
              <a:off x="1715670" y="6959262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4" name="Rectangle 73"/>
            <p:cNvSpPr/>
            <p:nvPr/>
          </p:nvSpPr>
          <p:spPr>
            <a:xfrm rot="5400000">
              <a:off x="1715670" y="7083756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77" name="Forme libre 76"/>
            <p:cNvSpPr/>
            <p:nvPr/>
          </p:nvSpPr>
          <p:spPr>
            <a:xfrm>
              <a:off x="998401" y="5000941"/>
              <a:ext cx="726029" cy="1582735"/>
            </a:xfrm>
            <a:custGeom>
              <a:avLst/>
              <a:gdLst>
                <a:gd name="connsiteX0" fmla="*/ 2117 w 970492"/>
                <a:gd name="connsiteY0" fmla="*/ 0 h 2425700"/>
                <a:gd name="connsiteX1" fmla="*/ 970492 w 970492"/>
                <a:gd name="connsiteY1" fmla="*/ 2238375 h 2425700"/>
                <a:gd name="connsiteX2" fmla="*/ 970492 w 970492"/>
                <a:gd name="connsiteY2" fmla="*/ 2425700 h 2425700"/>
                <a:gd name="connsiteX3" fmla="*/ 2117 w 970492"/>
                <a:gd name="connsiteY3" fmla="*/ 190500 h 2425700"/>
                <a:gd name="connsiteX4" fmla="*/ 2117 w 970492"/>
                <a:gd name="connsiteY4" fmla="*/ 0 h 24257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970492" h="2425700">
                  <a:moveTo>
                    <a:pt x="2117" y="0"/>
                  </a:moveTo>
                  <a:lnTo>
                    <a:pt x="970492" y="2238375"/>
                  </a:lnTo>
                  <a:lnTo>
                    <a:pt x="970492" y="2425700"/>
                  </a:lnTo>
                  <a:lnTo>
                    <a:pt x="2117" y="190500"/>
                  </a:lnTo>
                  <a:cubicBezTo>
                    <a:pt x="1059" y="125942"/>
                    <a:pt x="0" y="61383"/>
                    <a:pt x="2117" y="0"/>
                  </a:cubicBezTo>
                  <a:close/>
                </a:path>
              </a:pathLst>
            </a:custGeom>
            <a:solidFill>
              <a:srgbClr val="3333FF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cxnSp>
          <p:nvCxnSpPr>
            <p:cNvPr id="78" name="Connecteur droit 77"/>
            <p:cNvCxnSpPr/>
            <p:nvPr/>
          </p:nvCxnSpPr>
          <p:spPr>
            <a:xfrm rot="5400000">
              <a:off x="1675017" y="4045303"/>
              <a:ext cx="97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Rectangle 78"/>
            <p:cNvSpPr/>
            <p:nvPr/>
          </p:nvSpPr>
          <p:spPr>
            <a:xfrm rot="5400000">
              <a:off x="2098770" y="3894225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80" name="Rectangle 79"/>
            <p:cNvSpPr/>
            <p:nvPr/>
          </p:nvSpPr>
          <p:spPr>
            <a:xfrm rot="5400000">
              <a:off x="2098770" y="4017599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81" name="Rectangle 80"/>
            <p:cNvSpPr/>
            <p:nvPr/>
          </p:nvSpPr>
          <p:spPr>
            <a:xfrm rot="5400000">
              <a:off x="2098770" y="4142094"/>
              <a:ext cx="124494" cy="107739"/>
            </a:xfrm>
            <a:prstGeom prst="rect">
              <a:avLst/>
            </a:prstGeom>
            <a:solidFill>
              <a:srgbClr val="3333FF"/>
            </a:solidFill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dirty="0"/>
            </a:p>
          </p:txBody>
        </p:sp>
        <p:sp>
          <p:nvSpPr>
            <p:cNvPr id="82" name="Rectangle 81"/>
            <p:cNvSpPr/>
            <p:nvPr/>
          </p:nvSpPr>
          <p:spPr>
            <a:xfrm>
              <a:off x="2150113" y="3849129"/>
              <a:ext cx="929200" cy="46166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800" b="1" spc="-50" dirty="0" smtClean="0">
                  <a:latin typeface="Times New Roman" pitchFamily="18" charset="0"/>
                  <a:cs typeface="Times New Roman" pitchFamily="18" charset="0"/>
                </a:rPr>
                <a:t>Pv08Ck00100</a:t>
              </a:r>
            </a:p>
            <a:p>
              <a:r>
                <a:rPr lang="fr-FR" sz="800" b="1" spc="-50" dirty="0" smtClean="0">
                  <a:latin typeface="Times New Roman" pitchFamily="18" charset="0"/>
                  <a:cs typeface="Times New Roman" pitchFamily="18" charset="0"/>
                </a:rPr>
                <a:t>Pv08Ck00090</a:t>
              </a:r>
            </a:p>
            <a:p>
              <a:r>
                <a:rPr lang="fr-FR" sz="800" b="1" spc="-50" dirty="0" smtClean="0">
                  <a:latin typeface="Times New Roman" pitchFamily="18" charset="0"/>
                  <a:cs typeface="Times New Roman" pitchFamily="18" charset="0"/>
                </a:rPr>
                <a:t>Pv08Ck00080</a:t>
              </a:r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1694934" y="2871426"/>
              <a:ext cx="114011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900" b="1" dirty="0" err="1" smtClean="0">
                  <a:latin typeface="Times New Roman" pitchFamily="18" charset="0"/>
                  <a:cs typeface="Times New Roman" pitchFamily="18" charset="0"/>
                </a:rPr>
                <a:t>Pseudomolecule</a:t>
              </a:r>
              <a:r>
                <a:rPr lang="fr-FR" sz="900" b="1" dirty="0" smtClean="0">
                  <a:latin typeface="Times New Roman" pitchFamily="18" charset="0"/>
                  <a:cs typeface="Times New Roman" pitchFamily="18" charset="0"/>
                </a:rPr>
                <a:t> Chr08C</a:t>
              </a:r>
              <a:endParaRPr lang="fr-FR" sz="9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69" name="Connecteur droit 268"/>
            <p:cNvCxnSpPr/>
            <p:nvPr/>
          </p:nvCxnSpPr>
          <p:spPr>
            <a:xfrm rot="5400000">
              <a:off x="819248" y="1298412"/>
              <a:ext cx="252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Connecteur droit 272"/>
            <p:cNvCxnSpPr/>
            <p:nvPr/>
          </p:nvCxnSpPr>
          <p:spPr>
            <a:xfrm>
              <a:off x="860257" y="1371105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Connecteur droit 273"/>
            <p:cNvCxnSpPr/>
            <p:nvPr/>
          </p:nvCxnSpPr>
          <p:spPr>
            <a:xfrm>
              <a:off x="860257" y="1437541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Connecteur droit 274"/>
            <p:cNvCxnSpPr/>
            <p:nvPr/>
          </p:nvCxnSpPr>
          <p:spPr>
            <a:xfrm rot="5400000">
              <a:off x="1687586" y="1256749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Connecteur droit 275"/>
            <p:cNvCxnSpPr/>
            <p:nvPr/>
          </p:nvCxnSpPr>
          <p:spPr>
            <a:xfrm>
              <a:off x="1692595" y="1299210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Connecteur droit 276"/>
            <p:cNvCxnSpPr/>
            <p:nvPr/>
          </p:nvCxnSpPr>
          <p:spPr>
            <a:xfrm>
              <a:off x="1692595" y="1365646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8" name="Connecteur droit 277"/>
            <p:cNvCxnSpPr/>
            <p:nvPr/>
          </p:nvCxnSpPr>
          <p:spPr>
            <a:xfrm rot="5400000">
              <a:off x="1687585" y="7508702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9" name="Connecteur droit 278"/>
            <p:cNvCxnSpPr/>
            <p:nvPr/>
          </p:nvCxnSpPr>
          <p:spPr>
            <a:xfrm>
              <a:off x="1692594" y="7293235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0" name="Connecteur droit 279"/>
            <p:cNvCxnSpPr/>
            <p:nvPr/>
          </p:nvCxnSpPr>
          <p:spPr>
            <a:xfrm>
              <a:off x="1692594" y="7359671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2" name="Connecteur droit 281"/>
            <p:cNvCxnSpPr/>
            <p:nvPr/>
          </p:nvCxnSpPr>
          <p:spPr>
            <a:xfrm rot="5400000">
              <a:off x="855247" y="7448102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3" name="Connecteur droit 282"/>
            <p:cNvCxnSpPr/>
            <p:nvPr/>
          </p:nvCxnSpPr>
          <p:spPr>
            <a:xfrm>
              <a:off x="860256" y="7232635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4" name="Connecteur droit 283"/>
            <p:cNvCxnSpPr/>
            <p:nvPr/>
          </p:nvCxnSpPr>
          <p:spPr>
            <a:xfrm>
              <a:off x="860256" y="7299071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4" name="Groupe 289"/>
            <p:cNvGrpSpPr/>
            <p:nvPr/>
          </p:nvGrpSpPr>
          <p:grpSpPr>
            <a:xfrm>
              <a:off x="2564868" y="7164665"/>
              <a:ext cx="144000" cy="396000"/>
              <a:chOff x="2418907" y="6881997"/>
              <a:chExt cx="183908" cy="472865"/>
            </a:xfrm>
          </p:grpSpPr>
          <p:cxnSp>
            <p:nvCxnSpPr>
              <p:cNvPr id="285" name="Connecteur droit 284"/>
              <p:cNvCxnSpPr/>
              <p:nvPr/>
            </p:nvCxnSpPr>
            <p:spPr>
              <a:xfrm rot="5400000">
                <a:off x="2282077" y="7116459"/>
                <a:ext cx="453601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6" name="Connecteur droit 285"/>
              <p:cNvCxnSpPr/>
              <p:nvPr/>
            </p:nvCxnSpPr>
            <p:spPr>
              <a:xfrm rot="10800000">
                <a:off x="2418907" y="6881997"/>
                <a:ext cx="180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9" name="Connecteur droit 288"/>
              <p:cNvCxnSpPr/>
              <p:nvPr/>
            </p:nvCxnSpPr>
            <p:spPr>
              <a:xfrm rot="10800000">
                <a:off x="2422815" y="7354862"/>
                <a:ext cx="180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91" name="ZoneTexte 290"/>
            <p:cNvSpPr txBox="1"/>
            <p:nvPr/>
          </p:nvSpPr>
          <p:spPr>
            <a:xfrm>
              <a:off x="2647044" y="7363115"/>
              <a:ext cx="53926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200" dirty="0" smtClean="0">
                  <a:latin typeface="Times New Roman" pitchFamily="18" charset="0"/>
                  <a:cs typeface="Times New Roman" pitchFamily="18" charset="0"/>
                </a:rPr>
                <a:t>2 kb</a:t>
              </a:r>
              <a:endParaRPr lang="fr-F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2" name="ZoneTexte 291"/>
            <p:cNvSpPr txBox="1"/>
            <p:nvPr/>
          </p:nvSpPr>
          <p:spPr>
            <a:xfrm>
              <a:off x="214413" y="870225"/>
              <a:ext cx="23853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dirty="0" smtClean="0">
                  <a:latin typeface="Times New Roman" pitchFamily="18" charset="0"/>
                  <a:cs typeface="Times New Roman" pitchFamily="18" charset="0"/>
                </a:rPr>
                <a:t>A</a:t>
              </a:r>
              <a:endParaRPr lang="fr-F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3" name="ZoneTexte 292"/>
            <p:cNvSpPr txBox="1"/>
            <p:nvPr/>
          </p:nvSpPr>
          <p:spPr>
            <a:xfrm flipH="1">
              <a:off x="2959986" y="863875"/>
              <a:ext cx="2531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dirty="0" smtClean="0">
                  <a:latin typeface="Times New Roman" pitchFamily="18" charset="0"/>
                  <a:cs typeface="Times New Roman" pitchFamily="18" charset="0"/>
                </a:rPr>
                <a:t>B</a:t>
              </a:r>
              <a:endParaRPr lang="fr-F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94" name="ZoneTexte 293"/>
            <p:cNvSpPr txBox="1"/>
            <p:nvPr/>
          </p:nvSpPr>
          <p:spPr>
            <a:xfrm flipH="1">
              <a:off x="2990104" y="3853676"/>
              <a:ext cx="25311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400" b="1" dirty="0" smtClean="0">
                  <a:latin typeface="Times New Roman" pitchFamily="18" charset="0"/>
                  <a:cs typeface="Times New Roman" pitchFamily="18" charset="0"/>
                </a:rPr>
                <a:t>C</a:t>
              </a:r>
              <a:endParaRPr lang="fr-FR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298" name="Connecteur droit 297"/>
            <p:cNvCxnSpPr/>
            <p:nvPr/>
          </p:nvCxnSpPr>
          <p:spPr>
            <a:xfrm>
              <a:off x="1686076" y="1168575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9" name="ZoneTexte 298"/>
            <p:cNvSpPr txBox="1"/>
            <p:nvPr/>
          </p:nvSpPr>
          <p:spPr>
            <a:xfrm>
              <a:off x="1828472" y="1072170"/>
              <a:ext cx="101097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Times New Roman" pitchFamily="18" charset="0"/>
                  <a:cs typeface="Times New Roman" pitchFamily="18" charset="0"/>
                </a:rPr>
                <a:t>0 Mb</a:t>
              </a:r>
              <a:endParaRPr lang="fr-FR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303" name="Connecteur droit 302"/>
            <p:cNvCxnSpPr/>
            <p:nvPr/>
          </p:nvCxnSpPr>
          <p:spPr>
            <a:xfrm>
              <a:off x="1687010" y="7601569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4" name="Connecteur droit 303"/>
            <p:cNvCxnSpPr/>
            <p:nvPr/>
          </p:nvCxnSpPr>
          <p:spPr>
            <a:xfrm>
              <a:off x="852082" y="7549889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5" name="Connecteur droit 304"/>
            <p:cNvCxnSpPr/>
            <p:nvPr/>
          </p:nvCxnSpPr>
          <p:spPr>
            <a:xfrm>
              <a:off x="851148" y="1172043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7" name="Connecteur droit 306"/>
            <p:cNvCxnSpPr/>
            <p:nvPr/>
          </p:nvCxnSpPr>
          <p:spPr>
            <a:xfrm rot="5400000">
              <a:off x="2069529" y="3392095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8" name="Connecteur droit 307"/>
            <p:cNvCxnSpPr/>
            <p:nvPr/>
          </p:nvCxnSpPr>
          <p:spPr>
            <a:xfrm>
              <a:off x="2074538" y="3434556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9" name="Connecteur droit 308"/>
            <p:cNvCxnSpPr/>
            <p:nvPr/>
          </p:nvCxnSpPr>
          <p:spPr>
            <a:xfrm>
              <a:off x="2074538" y="3500992"/>
              <a:ext cx="180000" cy="10800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Connecteur droit 309"/>
            <p:cNvCxnSpPr/>
            <p:nvPr/>
          </p:nvCxnSpPr>
          <p:spPr>
            <a:xfrm>
              <a:off x="2068019" y="3303921"/>
              <a:ext cx="1800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5" name="Groupe 314"/>
            <p:cNvGrpSpPr/>
            <p:nvPr/>
          </p:nvGrpSpPr>
          <p:grpSpPr>
            <a:xfrm flipH="1" flipV="1">
              <a:off x="2061983" y="4482468"/>
              <a:ext cx="186519" cy="306897"/>
              <a:chOff x="2433311" y="2842287"/>
              <a:chExt cx="186519" cy="306897"/>
            </a:xfrm>
          </p:grpSpPr>
          <p:cxnSp>
            <p:nvCxnSpPr>
              <p:cNvPr id="311" name="Connecteur droit 310"/>
              <p:cNvCxnSpPr/>
              <p:nvPr/>
            </p:nvCxnSpPr>
            <p:spPr>
              <a:xfrm rot="5400000">
                <a:off x="2434821" y="2932287"/>
                <a:ext cx="180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2" name="Connecteur droit 311"/>
              <p:cNvCxnSpPr/>
              <p:nvPr/>
            </p:nvCxnSpPr>
            <p:spPr>
              <a:xfrm>
                <a:off x="2439830" y="2974748"/>
                <a:ext cx="180000" cy="108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3" name="Connecteur droit 312"/>
              <p:cNvCxnSpPr/>
              <p:nvPr/>
            </p:nvCxnSpPr>
            <p:spPr>
              <a:xfrm>
                <a:off x="2439830" y="3041184"/>
                <a:ext cx="180000" cy="10800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4" name="Connecteur droit 313"/>
              <p:cNvCxnSpPr/>
              <p:nvPr/>
            </p:nvCxnSpPr>
            <p:spPr>
              <a:xfrm>
                <a:off x="2433311" y="2844113"/>
                <a:ext cx="1800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70" name="Connecteur droit avec flèche 269"/>
            <p:cNvCxnSpPr/>
            <p:nvPr/>
          </p:nvCxnSpPr>
          <p:spPr>
            <a:xfrm flipH="1" flipV="1">
              <a:off x="2163283" y="3772776"/>
              <a:ext cx="175676" cy="0"/>
            </a:xfrm>
            <a:prstGeom prst="straightConnector1">
              <a:avLst/>
            </a:prstGeom>
            <a:ln w="254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1" name="ZoneTexte 270"/>
            <p:cNvSpPr txBox="1"/>
            <p:nvPr/>
          </p:nvSpPr>
          <p:spPr>
            <a:xfrm flipH="1">
              <a:off x="2281871" y="3640933"/>
              <a:ext cx="73904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900" dirty="0" smtClean="0">
                  <a:latin typeface="Times New Roman" pitchFamily="18" charset="0"/>
                  <a:cs typeface="Times New Roman" pitchFamily="18" charset="0"/>
                </a:rPr>
                <a:t>28.950 Mb</a:t>
              </a:r>
              <a:endParaRPr lang="fr-FR" sz="9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62" name="Connecteur droit avec flèche 461"/>
            <p:cNvCxnSpPr/>
            <p:nvPr/>
          </p:nvCxnSpPr>
          <p:spPr>
            <a:xfrm>
              <a:off x="1390849" y="1572677"/>
              <a:ext cx="0" cy="5796000"/>
            </a:xfrm>
            <a:prstGeom prst="straightConnector1">
              <a:avLst/>
            </a:prstGeom>
            <a:ln w="28575">
              <a:solidFill>
                <a:schemeClr val="tx1"/>
              </a:solidFill>
              <a:headEnd type="triangl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3" name="ZoneTexte 462"/>
            <p:cNvSpPr txBox="1"/>
            <p:nvPr/>
          </p:nvSpPr>
          <p:spPr>
            <a:xfrm rot="5400000">
              <a:off x="1117549" y="4096488"/>
              <a:ext cx="588623" cy="307777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fr-FR" sz="1400" dirty="0" smtClean="0">
                  <a:latin typeface="Times New Roman" pitchFamily="18" charset="0"/>
                  <a:cs typeface="Times New Roman" pitchFamily="18" charset="0"/>
                </a:rPr>
                <a:t>29 kb</a:t>
              </a:r>
              <a:endParaRPr lang="fr-FR" sz="1400" dirty="0"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67" name="Connecteur droit avec flèche 466"/>
            <p:cNvCxnSpPr/>
            <p:nvPr/>
          </p:nvCxnSpPr>
          <p:spPr>
            <a:xfrm>
              <a:off x="3477438" y="5623952"/>
              <a:ext cx="252000" cy="0"/>
            </a:xfrm>
            <a:prstGeom prst="straightConnector1">
              <a:avLst/>
            </a:prstGeom>
            <a:ln w="57150">
              <a:solidFill>
                <a:srgbClr val="00B050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8" name="ZoneTexte 467"/>
            <p:cNvSpPr txBox="1"/>
            <p:nvPr/>
          </p:nvSpPr>
          <p:spPr>
            <a:xfrm>
              <a:off x="2829970" y="5408616"/>
              <a:ext cx="82983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Clade D</a:t>
              </a:r>
            </a:p>
            <a:p>
              <a:pPr algn="ctr"/>
              <a:r>
                <a:rPr lang="fr-FR" sz="1000" b="1" dirty="0" smtClean="0">
                  <a:solidFill>
                    <a:srgbClr val="00B050"/>
                  </a:solidFill>
                  <a:latin typeface="Times New Roman" pitchFamily="18" charset="0"/>
                  <a:cs typeface="Times New Roman" pitchFamily="18" charset="0"/>
                </a:rPr>
                <a:t>Figure 1</a:t>
              </a:r>
            </a:p>
            <a:p>
              <a:pPr algn="ctr"/>
              <a:endParaRPr lang="fr-FR" sz="1000" b="1" dirty="0">
                <a:solidFill>
                  <a:srgbClr val="00B050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cxnSp>
          <p:nvCxnSpPr>
            <p:cNvPr id="473" name="Connecteur droit avec flèche 472"/>
            <p:cNvCxnSpPr/>
            <p:nvPr/>
          </p:nvCxnSpPr>
          <p:spPr>
            <a:xfrm>
              <a:off x="3548772" y="2557149"/>
              <a:ext cx="252000" cy="0"/>
            </a:xfrm>
            <a:prstGeom prst="straightConnector1">
              <a:avLst/>
            </a:prstGeom>
            <a:ln w="57150">
              <a:solidFill>
                <a:srgbClr val="00D7D2"/>
              </a:solidFill>
              <a:headEnd type="none" w="med" len="med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74" name="ZoneTexte 473"/>
            <p:cNvSpPr txBox="1"/>
            <p:nvPr/>
          </p:nvSpPr>
          <p:spPr>
            <a:xfrm>
              <a:off x="2888604" y="2341813"/>
              <a:ext cx="829831" cy="55399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1000" b="1" dirty="0" smtClean="0">
                  <a:solidFill>
                    <a:srgbClr val="00D7D2"/>
                  </a:solidFill>
                  <a:latin typeface="Times New Roman" pitchFamily="18" charset="0"/>
                  <a:cs typeface="Times New Roman" pitchFamily="18" charset="0"/>
                </a:rPr>
                <a:t>Clade E</a:t>
              </a:r>
            </a:p>
            <a:p>
              <a:pPr algn="ctr"/>
              <a:r>
                <a:rPr lang="fr-FR" sz="1000" b="1" dirty="0" smtClean="0">
                  <a:solidFill>
                    <a:srgbClr val="00D7D2"/>
                  </a:solidFill>
                  <a:latin typeface="Times New Roman" pitchFamily="18" charset="0"/>
                  <a:cs typeface="Times New Roman" pitchFamily="18" charset="0"/>
                </a:rPr>
                <a:t>Figure 1</a:t>
              </a:r>
            </a:p>
            <a:p>
              <a:pPr algn="ctr"/>
              <a:endParaRPr lang="fr-FR" sz="1000" b="1" dirty="0">
                <a:solidFill>
                  <a:srgbClr val="00D7D2"/>
                </a:solidFill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498" name="Forme libre 497"/>
            <p:cNvSpPr/>
            <p:nvPr/>
          </p:nvSpPr>
          <p:spPr>
            <a:xfrm>
              <a:off x="997461" y="2621002"/>
              <a:ext cx="1113576" cy="1638677"/>
            </a:xfrm>
            <a:custGeom>
              <a:avLst/>
              <a:gdLst>
                <a:gd name="connsiteX0" fmla="*/ 0 w 1113576"/>
                <a:gd name="connsiteY0" fmla="*/ 0 h 1638677"/>
                <a:gd name="connsiteX1" fmla="*/ 1109049 w 1113576"/>
                <a:gd name="connsiteY1" fmla="*/ 1262958 h 1638677"/>
                <a:gd name="connsiteX2" fmla="*/ 1113576 w 1113576"/>
                <a:gd name="connsiteY2" fmla="*/ 1638677 h 1638677"/>
                <a:gd name="connsiteX3" fmla="*/ 4526 w 1113576"/>
                <a:gd name="connsiteY3" fmla="*/ 371192 h 1638677"/>
                <a:gd name="connsiteX4" fmla="*/ 0 w 1113576"/>
                <a:gd name="connsiteY4" fmla="*/ 0 h 1638677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</a:cxnLst>
              <a:rect l="l" t="t" r="r" b="b"/>
              <a:pathLst>
                <a:path w="1113576" h="1638677">
                  <a:moveTo>
                    <a:pt x="0" y="0"/>
                  </a:moveTo>
                  <a:lnTo>
                    <a:pt x="1109049" y="1262958"/>
                  </a:lnTo>
                  <a:lnTo>
                    <a:pt x="1113576" y="1638677"/>
                  </a:lnTo>
                  <a:lnTo>
                    <a:pt x="4526" y="371192"/>
                  </a:lnTo>
                  <a:cubicBezTo>
                    <a:pt x="3017" y="247461"/>
                    <a:pt x="1509" y="123731"/>
                    <a:pt x="0" y="0"/>
                  </a:cubicBezTo>
                  <a:close/>
                </a:path>
              </a:pathLst>
            </a:custGeom>
            <a:solidFill>
              <a:srgbClr val="3333FF">
                <a:alpha val="40000"/>
              </a:srgb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99" name="Forme libre 498"/>
            <p:cNvSpPr/>
            <p:nvPr/>
          </p:nvSpPr>
          <p:spPr>
            <a:xfrm>
              <a:off x="237161" y="1747342"/>
              <a:ext cx="2617152" cy="2553078"/>
            </a:xfrm>
            <a:custGeom>
              <a:avLst/>
              <a:gdLst>
                <a:gd name="connsiteX0" fmla="*/ 0 w 2602871"/>
                <a:gd name="connsiteY0" fmla="*/ 4527 h 2553078"/>
                <a:gd name="connsiteX1" fmla="*/ 2186412 w 2602871"/>
                <a:gd name="connsiteY1" fmla="*/ 0 h 2553078"/>
                <a:gd name="connsiteX2" fmla="*/ 2177358 w 2602871"/>
                <a:gd name="connsiteY2" fmla="*/ 774072 h 2553078"/>
                <a:gd name="connsiteX3" fmla="*/ 1557196 w 2602871"/>
                <a:gd name="connsiteY3" fmla="*/ 774072 h 2553078"/>
                <a:gd name="connsiteX4" fmla="*/ 1557196 w 2602871"/>
                <a:gd name="connsiteY4" fmla="*/ 1760899 h 2553078"/>
                <a:gd name="connsiteX5" fmla="*/ 1851433 w 2602871"/>
                <a:gd name="connsiteY5" fmla="*/ 2104931 h 2553078"/>
                <a:gd name="connsiteX6" fmla="*/ 2598344 w 2602871"/>
                <a:gd name="connsiteY6" fmla="*/ 2100404 h 2553078"/>
                <a:gd name="connsiteX7" fmla="*/ 2602871 w 2602871"/>
                <a:gd name="connsiteY7" fmla="*/ 2548551 h 2553078"/>
                <a:gd name="connsiteX8" fmla="*/ 1837853 w 2602871"/>
                <a:gd name="connsiteY8" fmla="*/ 2553078 h 2553078"/>
                <a:gd name="connsiteX9" fmla="*/ 751437 w 2602871"/>
                <a:gd name="connsiteY9" fmla="*/ 1367074 h 2553078"/>
                <a:gd name="connsiteX10" fmla="*/ 9053 w 2602871"/>
                <a:gd name="connsiteY10" fmla="*/ 1371600 h 2553078"/>
                <a:gd name="connsiteX11" fmla="*/ 0 w 2602871"/>
                <a:gd name="connsiteY11" fmla="*/ 4527 h 2553078"/>
                <a:gd name="connsiteX0" fmla="*/ 0 w 2602871"/>
                <a:gd name="connsiteY0" fmla="*/ 4527 h 2553078"/>
                <a:gd name="connsiteX1" fmla="*/ 2186412 w 2602871"/>
                <a:gd name="connsiteY1" fmla="*/ 0 h 2553078"/>
                <a:gd name="connsiteX2" fmla="*/ 2191646 w 2602871"/>
                <a:gd name="connsiteY2" fmla="*/ 776453 h 2553078"/>
                <a:gd name="connsiteX3" fmla="*/ 1557196 w 2602871"/>
                <a:gd name="connsiteY3" fmla="*/ 774072 h 2553078"/>
                <a:gd name="connsiteX4" fmla="*/ 1557196 w 2602871"/>
                <a:gd name="connsiteY4" fmla="*/ 1760899 h 2553078"/>
                <a:gd name="connsiteX5" fmla="*/ 1851433 w 2602871"/>
                <a:gd name="connsiteY5" fmla="*/ 2104931 h 2553078"/>
                <a:gd name="connsiteX6" fmla="*/ 2598344 w 2602871"/>
                <a:gd name="connsiteY6" fmla="*/ 2100404 h 2553078"/>
                <a:gd name="connsiteX7" fmla="*/ 2602871 w 2602871"/>
                <a:gd name="connsiteY7" fmla="*/ 2548551 h 2553078"/>
                <a:gd name="connsiteX8" fmla="*/ 1837853 w 2602871"/>
                <a:gd name="connsiteY8" fmla="*/ 2553078 h 2553078"/>
                <a:gd name="connsiteX9" fmla="*/ 751437 w 2602871"/>
                <a:gd name="connsiteY9" fmla="*/ 1367074 h 2553078"/>
                <a:gd name="connsiteX10" fmla="*/ 9053 w 2602871"/>
                <a:gd name="connsiteY10" fmla="*/ 1371600 h 2553078"/>
                <a:gd name="connsiteX11" fmla="*/ 0 w 2602871"/>
                <a:gd name="connsiteY11" fmla="*/ 4527 h 2553078"/>
                <a:gd name="connsiteX0" fmla="*/ 0 w 2602871"/>
                <a:gd name="connsiteY0" fmla="*/ 4527 h 2553078"/>
                <a:gd name="connsiteX1" fmla="*/ 2186412 w 2602871"/>
                <a:gd name="connsiteY1" fmla="*/ 0 h 2553078"/>
                <a:gd name="connsiteX2" fmla="*/ 2184502 w 2602871"/>
                <a:gd name="connsiteY2" fmla="*/ 776453 h 2553078"/>
                <a:gd name="connsiteX3" fmla="*/ 1557196 w 2602871"/>
                <a:gd name="connsiteY3" fmla="*/ 774072 h 2553078"/>
                <a:gd name="connsiteX4" fmla="*/ 1557196 w 2602871"/>
                <a:gd name="connsiteY4" fmla="*/ 1760899 h 2553078"/>
                <a:gd name="connsiteX5" fmla="*/ 1851433 w 2602871"/>
                <a:gd name="connsiteY5" fmla="*/ 2104931 h 2553078"/>
                <a:gd name="connsiteX6" fmla="*/ 2598344 w 2602871"/>
                <a:gd name="connsiteY6" fmla="*/ 2100404 h 2553078"/>
                <a:gd name="connsiteX7" fmla="*/ 2602871 w 2602871"/>
                <a:gd name="connsiteY7" fmla="*/ 2548551 h 2553078"/>
                <a:gd name="connsiteX8" fmla="*/ 1837853 w 2602871"/>
                <a:gd name="connsiteY8" fmla="*/ 2553078 h 2553078"/>
                <a:gd name="connsiteX9" fmla="*/ 751437 w 2602871"/>
                <a:gd name="connsiteY9" fmla="*/ 1367074 h 2553078"/>
                <a:gd name="connsiteX10" fmla="*/ 9053 w 2602871"/>
                <a:gd name="connsiteY10" fmla="*/ 1371600 h 2553078"/>
                <a:gd name="connsiteX11" fmla="*/ 0 w 2602871"/>
                <a:gd name="connsiteY11" fmla="*/ 4527 h 2553078"/>
                <a:gd name="connsiteX0" fmla="*/ 0 w 2602871"/>
                <a:gd name="connsiteY0" fmla="*/ 4527 h 2553078"/>
                <a:gd name="connsiteX1" fmla="*/ 2186412 w 2602871"/>
                <a:gd name="connsiteY1" fmla="*/ 0 h 2553078"/>
                <a:gd name="connsiteX2" fmla="*/ 2186884 w 2602871"/>
                <a:gd name="connsiteY2" fmla="*/ 774072 h 2553078"/>
                <a:gd name="connsiteX3" fmla="*/ 1557196 w 2602871"/>
                <a:gd name="connsiteY3" fmla="*/ 774072 h 2553078"/>
                <a:gd name="connsiteX4" fmla="*/ 1557196 w 2602871"/>
                <a:gd name="connsiteY4" fmla="*/ 1760899 h 2553078"/>
                <a:gd name="connsiteX5" fmla="*/ 1851433 w 2602871"/>
                <a:gd name="connsiteY5" fmla="*/ 2104931 h 2553078"/>
                <a:gd name="connsiteX6" fmla="*/ 2598344 w 2602871"/>
                <a:gd name="connsiteY6" fmla="*/ 2100404 h 2553078"/>
                <a:gd name="connsiteX7" fmla="*/ 2602871 w 2602871"/>
                <a:gd name="connsiteY7" fmla="*/ 2548551 h 2553078"/>
                <a:gd name="connsiteX8" fmla="*/ 1837853 w 2602871"/>
                <a:gd name="connsiteY8" fmla="*/ 2553078 h 2553078"/>
                <a:gd name="connsiteX9" fmla="*/ 751437 w 2602871"/>
                <a:gd name="connsiteY9" fmla="*/ 1367074 h 2553078"/>
                <a:gd name="connsiteX10" fmla="*/ 9053 w 2602871"/>
                <a:gd name="connsiteY10" fmla="*/ 1371600 h 2553078"/>
                <a:gd name="connsiteX11" fmla="*/ 0 w 2602871"/>
                <a:gd name="connsiteY11" fmla="*/ 4527 h 2553078"/>
                <a:gd name="connsiteX0" fmla="*/ 0 w 2598108"/>
                <a:gd name="connsiteY0" fmla="*/ 4527 h 2553078"/>
                <a:gd name="connsiteX1" fmla="*/ 2181649 w 2598108"/>
                <a:gd name="connsiteY1" fmla="*/ 0 h 2553078"/>
                <a:gd name="connsiteX2" fmla="*/ 2182121 w 2598108"/>
                <a:gd name="connsiteY2" fmla="*/ 774072 h 2553078"/>
                <a:gd name="connsiteX3" fmla="*/ 1552433 w 2598108"/>
                <a:gd name="connsiteY3" fmla="*/ 774072 h 2553078"/>
                <a:gd name="connsiteX4" fmla="*/ 1552433 w 2598108"/>
                <a:gd name="connsiteY4" fmla="*/ 1760899 h 2553078"/>
                <a:gd name="connsiteX5" fmla="*/ 1846670 w 2598108"/>
                <a:gd name="connsiteY5" fmla="*/ 2104931 h 2553078"/>
                <a:gd name="connsiteX6" fmla="*/ 2593581 w 2598108"/>
                <a:gd name="connsiteY6" fmla="*/ 2100404 h 2553078"/>
                <a:gd name="connsiteX7" fmla="*/ 2598108 w 2598108"/>
                <a:gd name="connsiteY7" fmla="*/ 2548551 h 2553078"/>
                <a:gd name="connsiteX8" fmla="*/ 1833090 w 2598108"/>
                <a:gd name="connsiteY8" fmla="*/ 2553078 h 2553078"/>
                <a:gd name="connsiteX9" fmla="*/ 746674 w 2598108"/>
                <a:gd name="connsiteY9" fmla="*/ 1367074 h 2553078"/>
                <a:gd name="connsiteX10" fmla="*/ 4290 w 2598108"/>
                <a:gd name="connsiteY10" fmla="*/ 1371600 h 2553078"/>
                <a:gd name="connsiteX11" fmla="*/ 0 w 2598108"/>
                <a:gd name="connsiteY11" fmla="*/ 4527 h 2553078"/>
                <a:gd name="connsiteX0" fmla="*/ 0 w 2598108"/>
                <a:gd name="connsiteY0" fmla="*/ 4527 h 2553078"/>
                <a:gd name="connsiteX1" fmla="*/ 2181649 w 2598108"/>
                <a:gd name="connsiteY1" fmla="*/ 0 h 2553078"/>
                <a:gd name="connsiteX2" fmla="*/ 2182121 w 2598108"/>
                <a:gd name="connsiteY2" fmla="*/ 774072 h 2553078"/>
                <a:gd name="connsiteX3" fmla="*/ 1552433 w 2598108"/>
                <a:gd name="connsiteY3" fmla="*/ 774072 h 2553078"/>
                <a:gd name="connsiteX4" fmla="*/ 1552433 w 2598108"/>
                <a:gd name="connsiteY4" fmla="*/ 1760899 h 2553078"/>
                <a:gd name="connsiteX5" fmla="*/ 1846670 w 2598108"/>
                <a:gd name="connsiteY5" fmla="*/ 2104931 h 2553078"/>
                <a:gd name="connsiteX6" fmla="*/ 2540418 w 2598108"/>
                <a:gd name="connsiteY6" fmla="*/ 2100404 h 2553078"/>
                <a:gd name="connsiteX7" fmla="*/ 2598108 w 2598108"/>
                <a:gd name="connsiteY7" fmla="*/ 2548551 h 2553078"/>
                <a:gd name="connsiteX8" fmla="*/ 1833090 w 2598108"/>
                <a:gd name="connsiteY8" fmla="*/ 2553078 h 2553078"/>
                <a:gd name="connsiteX9" fmla="*/ 746674 w 2598108"/>
                <a:gd name="connsiteY9" fmla="*/ 1367074 h 2553078"/>
                <a:gd name="connsiteX10" fmla="*/ 4290 w 2598108"/>
                <a:gd name="connsiteY10" fmla="*/ 1371600 h 2553078"/>
                <a:gd name="connsiteX11" fmla="*/ 0 w 2598108"/>
                <a:gd name="connsiteY11" fmla="*/ 4527 h 2553078"/>
                <a:gd name="connsiteX0" fmla="*/ 0 w 2544946"/>
                <a:gd name="connsiteY0" fmla="*/ 4527 h 2553078"/>
                <a:gd name="connsiteX1" fmla="*/ 2181649 w 2544946"/>
                <a:gd name="connsiteY1" fmla="*/ 0 h 2553078"/>
                <a:gd name="connsiteX2" fmla="*/ 2182121 w 2544946"/>
                <a:gd name="connsiteY2" fmla="*/ 774072 h 2553078"/>
                <a:gd name="connsiteX3" fmla="*/ 1552433 w 2544946"/>
                <a:gd name="connsiteY3" fmla="*/ 774072 h 2553078"/>
                <a:gd name="connsiteX4" fmla="*/ 1552433 w 2544946"/>
                <a:gd name="connsiteY4" fmla="*/ 1760899 h 2553078"/>
                <a:gd name="connsiteX5" fmla="*/ 1846670 w 2544946"/>
                <a:gd name="connsiteY5" fmla="*/ 2104931 h 2553078"/>
                <a:gd name="connsiteX6" fmla="*/ 2540418 w 2544946"/>
                <a:gd name="connsiteY6" fmla="*/ 2100404 h 2553078"/>
                <a:gd name="connsiteX7" fmla="*/ 2544946 w 2544946"/>
                <a:gd name="connsiteY7" fmla="*/ 2545893 h 2553078"/>
                <a:gd name="connsiteX8" fmla="*/ 1833090 w 2544946"/>
                <a:gd name="connsiteY8" fmla="*/ 2553078 h 2553078"/>
                <a:gd name="connsiteX9" fmla="*/ 746674 w 2544946"/>
                <a:gd name="connsiteY9" fmla="*/ 1367074 h 2553078"/>
                <a:gd name="connsiteX10" fmla="*/ 4290 w 2544946"/>
                <a:gd name="connsiteY10" fmla="*/ 1371600 h 2553078"/>
                <a:gd name="connsiteX11" fmla="*/ 0 w 2544946"/>
                <a:gd name="connsiteY11" fmla="*/ 4527 h 2553078"/>
                <a:gd name="connsiteX0" fmla="*/ 0 w 2544946"/>
                <a:gd name="connsiteY0" fmla="*/ 4527 h 2553078"/>
                <a:gd name="connsiteX1" fmla="*/ 2181649 w 2544946"/>
                <a:gd name="connsiteY1" fmla="*/ 0 h 2553078"/>
                <a:gd name="connsiteX2" fmla="*/ 2182121 w 2544946"/>
                <a:gd name="connsiteY2" fmla="*/ 774072 h 2553078"/>
                <a:gd name="connsiteX3" fmla="*/ 1552433 w 2544946"/>
                <a:gd name="connsiteY3" fmla="*/ 774072 h 2553078"/>
                <a:gd name="connsiteX4" fmla="*/ 1552433 w 2544946"/>
                <a:gd name="connsiteY4" fmla="*/ 1760899 h 2553078"/>
                <a:gd name="connsiteX5" fmla="*/ 1846670 w 2544946"/>
                <a:gd name="connsiteY5" fmla="*/ 2104931 h 2553078"/>
                <a:gd name="connsiteX6" fmla="*/ 2532443 w 2544946"/>
                <a:gd name="connsiteY6" fmla="*/ 2100404 h 2553078"/>
                <a:gd name="connsiteX7" fmla="*/ 2544946 w 2544946"/>
                <a:gd name="connsiteY7" fmla="*/ 2545893 h 2553078"/>
                <a:gd name="connsiteX8" fmla="*/ 1833090 w 2544946"/>
                <a:gd name="connsiteY8" fmla="*/ 2553078 h 2553078"/>
                <a:gd name="connsiteX9" fmla="*/ 746674 w 2544946"/>
                <a:gd name="connsiteY9" fmla="*/ 1367074 h 2553078"/>
                <a:gd name="connsiteX10" fmla="*/ 4290 w 2544946"/>
                <a:gd name="connsiteY10" fmla="*/ 1371600 h 2553078"/>
                <a:gd name="connsiteX11" fmla="*/ 0 w 2544946"/>
                <a:gd name="connsiteY11" fmla="*/ 4527 h 2553078"/>
                <a:gd name="connsiteX0" fmla="*/ 0 w 2534314"/>
                <a:gd name="connsiteY0" fmla="*/ 4527 h 2553078"/>
                <a:gd name="connsiteX1" fmla="*/ 2181649 w 2534314"/>
                <a:gd name="connsiteY1" fmla="*/ 0 h 2553078"/>
                <a:gd name="connsiteX2" fmla="*/ 2182121 w 2534314"/>
                <a:gd name="connsiteY2" fmla="*/ 774072 h 2553078"/>
                <a:gd name="connsiteX3" fmla="*/ 1552433 w 2534314"/>
                <a:gd name="connsiteY3" fmla="*/ 774072 h 2553078"/>
                <a:gd name="connsiteX4" fmla="*/ 1552433 w 2534314"/>
                <a:gd name="connsiteY4" fmla="*/ 1760899 h 2553078"/>
                <a:gd name="connsiteX5" fmla="*/ 1846670 w 2534314"/>
                <a:gd name="connsiteY5" fmla="*/ 2104931 h 2553078"/>
                <a:gd name="connsiteX6" fmla="*/ 2532443 w 2534314"/>
                <a:gd name="connsiteY6" fmla="*/ 2100404 h 2553078"/>
                <a:gd name="connsiteX7" fmla="*/ 2534314 w 2534314"/>
                <a:gd name="connsiteY7" fmla="*/ 2545893 h 2553078"/>
                <a:gd name="connsiteX8" fmla="*/ 1833090 w 2534314"/>
                <a:gd name="connsiteY8" fmla="*/ 2553078 h 2553078"/>
                <a:gd name="connsiteX9" fmla="*/ 746674 w 2534314"/>
                <a:gd name="connsiteY9" fmla="*/ 1367074 h 2553078"/>
                <a:gd name="connsiteX10" fmla="*/ 4290 w 2534314"/>
                <a:gd name="connsiteY10" fmla="*/ 1371600 h 2553078"/>
                <a:gd name="connsiteX11" fmla="*/ 0 w 2534314"/>
                <a:gd name="connsiteY11" fmla="*/ 4527 h 2553078"/>
                <a:gd name="connsiteX0" fmla="*/ 0 w 2545821"/>
                <a:gd name="connsiteY0" fmla="*/ 4527 h 2553078"/>
                <a:gd name="connsiteX1" fmla="*/ 2181649 w 2545821"/>
                <a:gd name="connsiteY1" fmla="*/ 0 h 2553078"/>
                <a:gd name="connsiteX2" fmla="*/ 2182121 w 2545821"/>
                <a:gd name="connsiteY2" fmla="*/ 774072 h 2553078"/>
                <a:gd name="connsiteX3" fmla="*/ 1552433 w 2545821"/>
                <a:gd name="connsiteY3" fmla="*/ 774072 h 2553078"/>
                <a:gd name="connsiteX4" fmla="*/ 1552433 w 2545821"/>
                <a:gd name="connsiteY4" fmla="*/ 1760899 h 2553078"/>
                <a:gd name="connsiteX5" fmla="*/ 1846670 w 2545821"/>
                <a:gd name="connsiteY5" fmla="*/ 2104931 h 2553078"/>
                <a:gd name="connsiteX6" fmla="*/ 2544312 w 2545821"/>
                <a:gd name="connsiteY6" fmla="*/ 2100404 h 2553078"/>
                <a:gd name="connsiteX7" fmla="*/ 2534314 w 2545821"/>
                <a:gd name="connsiteY7" fmla="*/ 2545893 h 2553078"/>
                <a:gd name="connsiteX8" fmla="*/ 1833090 w 2545821"/>
                <a:gd name="connsiteY8" fmla="*/ 2553078 h 2553078"/>
                <a:gd name="connsiteX9" fmla="*/ 746674 w 2545821"/>
                <a:gd name="connsiteY9" fmla="*/ 1367074 h 2553078"/>
                <a:gd name="connsiteX10" fmla="*/ 4290 w 2545821"/>
                <a:gd name="connsiteY10" fmla="*/ 1371600 h 2553078"/>
                <a:gd name="connsiteX11" fmla="*/ 0 w 2545821"/>
                <a:gd name="connsiteY11" fmla="*/ 4527 h 2553078"/>
                <a:gd name="connsiteX0" fmla="*/ 0 w 2550931"/>
                <a:gd name="connsiteY0" fmla="*/ 4527 h 2553078"/>
                <a:gd name="connsiteX1" fmla="*/ 2181649 w 2550931"/>
                <a:gd name="connsiteY1" fmla="*/ 0 h 2553078"/>
                <a:gd name="connsiteX2" fmla="*/ 2182121 w 2550931"/>
                <a:gd name="connsiteY2" fmla="*/ 774072 h 2553078"/>
                <a:gd name="connsiteX3" fmla="*/ 1552433 w 2550931"/>
                <a:gd name="connsiteY3" fmla="*/ 774072 h 2553078"/>
                <a:gd name="connsiteX4" fmla="*/ 1552433 w 2550931"/>
                <a:gd name="connsiteY4" fmla="*/ 1760899 h 2553078"/>
                <a:gd name="connsiteX5" fmla="*/ 1846670 w 2550931"/>
                <a:gd name="connsiteY5" fmla="*/ 2104931 h 2553078"/>
                <a:gd name="connsiteX6" fmla="*/ 2544312 w 2550931"/>
                <a:gd name="connsiteY6" fmla="*/ 2100404 h 2553078"/>
                <a:gd name="connsiteX7" fmla="*/ 2550931 w 2550931"/>
                <a:gd name="connsiteY7" fmla="*/ 2545893 h 2553078"/>
                <a:gd name="connsiteX8" fmla="*/ 1833090 w 2550931"/>
                <a:gd name="connsiteY8" fmla="*/ 2553078 h 2553078"/>
                <a:gd name="connsiteX9" fmla="*/ 746674 w 2550931"/>
                <a:gd name="connsiteY9" fmla="*/ 1367074 h 2553078"/>
                <a:gd name="connsiteX10" fmla="*/ 4290 w 2550931"/>
                <a:gd name="connsiteY10" fmla="*/ 1371600 h 2553078"/>
                <a:gd name="connsiteX11" fmla="*/ 0 w 2550931"/>
                <a:gd name="connsiteY11" fmla="*/ 4527 h 2553078"/>
                <a:gd name="connsiteX0" fmla="*/ 0 w 2545821"/>
                <a:gd name="connsiteY0" fmla="*/ 4527 h 2553078"/>
                <a:gd name="connsiteX1" fmla="*/ 2181649 w 2545821"/>
                <a:gd name="connsiteY1" fmla="*/ 0 h 2553078"/>
                <a:gd name="connsiteX2" fmla="*/ 2182121 w 2545821"/>
                <a:gd name="connsiteY2" fmla="*/ 774072 h 2553078"/>
                <a:gd name="connsiteX3" fmla="*/ 1552433 w 2545821"/>
                <a:gd name="connsiteY3" fmla="*/ 774072 h 2553078"/>
                <a:gd name="connsiteX4" fmla="*/ 1552433 w 2545821"/>
                <a:gd name="connsiteY4" fmla="*/ 1760899 h 2553078"/>
                <a:gd name="connsiteX5" fmla="*/ 1846670 w 2545821"/>
                <a:gd name="connsiteY5" fmla="*/ 2104931 h 2553078"/>
                <a:gd name="connsiteX6" fmla="*/ 2544312 w 2545821"/>
                <a:gd name="connsiteY6" fmla="*/ 2100404 h 2553078"/>
                <a:gd name="connsiteX7" fmla="*/ 2541435 w 2545821"/>
                <a:gd name="connsiteY7" fmla="*/ 2543512 h 2553078"/>
                <a:gd name="connsiteX8" fmla="*/ 1833090 w 2545821"/>
                <a:gd name="connsiteY8" fmla="*/ 2553078 h 2553078"/>
                <a:gd name="connsiteX9" fmla="*/ 746674 w 2545821"/>
                <a:gd name="connsiteY9" fmla="*/ 1367074 h 2553078"/>
                <a:gd name="connsiteX10" fmla="*/ 4290 w 2545821"/>
                <a:gd name="connsiteY10" fmla="*/ 1371600 h 2553078"/>
                <a:gd name="connsiteX11" fmla="*/ 0 w 2545821"/>
                <a:gd name="connsiteY11" fmla="*/ 4527 h 2553078"/>
                <a:gd name="connsiteX0" fmla="*/ 0 w 2550931"/>
                <a:gd name="connsiteY0" fmla="*/ 4527 h 2553078"/>
                <a:gd name="connsiteX1" fmla="*/ 2181649 w 2550931"/>
                <a:gd name="connsiteY1" fmla="*/ 0 h 2553078"/>
                <a:gd name="connsiteX2" fmla="*/ 2182121 w 2550931"/>
                <a:gd name="connsiteY2" fmla="*/ 774072 h 2553078"/>
                <a:gd name="connsiteX3" fmla="*/ 1552433 w 2550931"/>
                <a:gd name="connsiteY3" fmla="*/ 774072 h 2553078"/>
                <a:gd name="connsiteX4" fmla="*/ 1552433 w 2550931"/>
                <a:gd name="connsiteY4" fmla="*/ 1760899 h 2553078"/>
                <a:gd name="connsiteX5" fmla="*/ 1846670 w 2550931"/>
                <a:gd name="connsiteY5" fmla="*/ 2104931 h 2553078"/>
                <a:gd name="connsiteX6" fmla="*/ 2544312 w 2550931"/>
                <a:gd name="connsiteY6" fmla="*/ 2100404 h 2553078"/>
                <a:gd name="connsiteX7" fmla="*/ 2550931 w 2550931"/>
                <a:gd name="connsiteY7" fmla="*/ 2543512 h 2553078"/>
                <a:gd name="connsiteX8" fmla="*/ 1833090 w 2550931"/>
                <a:gd name="connsiteY8" fmla="*/ 2553078 h 2553078"/>
                <a:gd name="connsiteX9" fmla="*/ 746674 w 2550931"/>
                <a:gd name="connsiteY9" fmla="*/ 1367074 h 2553078"/>
                <a:gd name="connsiteX10" fmla="*/ 4290 w 2550931"/>
                <a:gd name="connsiteY10" fmla="*/ 1371600 h 2553078"/>
                <a:gd name="connsiteX11" fmla="*/ 0 w 2550931"/>
                <a:gd name="connsiteY11" fmla="*/ 4527 h 2553078"/>
                <a:gd name="connsiteX0" fmla="*/ 0 w 2555317"/>
                <a:gd name="connsiteY0" fmla="*/ 4527 h 2553078"/>
                <a:gd name="connsiteX1" fmla="*/ 2181649 w 2555317"/>
                <a:gd name="connsiteY1" fmla="*/ 0 h 2553078"/>
                <a:gd name="connsiteX2" fmla="*/ 2182121 w 2555317"/>
                <a:gd name="connsiteY2" fmla="*/ 774072 h 2553078"/>
                <a:gd name="connsiteX3" fmla="*/ 1552433 w 2555317"/>
                <a:gd name="connsiteY3" fmla="*/ 774072 h 2553078"/>
                <a:gd name="connsiteX4" fmla="*/ 1552433 w 2555317"/>
                <a:gd name="connsiteY4" fmla="*/ 1760899 h 2553078"/>
                <a:gd name="connsiteX5" fmla="*/ 1846670 w 2555317"/>
                <a:gd name="connsiteY5" fmla="*/ 2104931 h 2553078"/>
                <a:gd name="connsiteX6" fmla="*/ 2553808 w 2555317"/>
                <a:gd name="connsiteY6" fmla="*/ 2095641 h 2553078"/>
                <a:gd name="connsiteX7" fmla="*/ 2550931 w 2555317"/>
                <a:gd name="connsiteY7" fmla="*/ 2543512 h 2553078"/>
                <a:gd name="connsiteX8" fmla="*/ 1833090 w 2555317"/>
                <a:gd name="connsiteY8" fmla="*/ 2553078 h 2553078"/>
                <a:gd name="connsiteX9" fmla="*/ 746674 w 2555317"/>
                <a:gd name="connsiteY9" fmla="*/ 1367074 h 2553078"/>
                <a:gd name="connsiteX10" fmla="*/ 4290 w 2555317"/>
                <a:gd name="connsiteY10" fmla="*/ 1371600 h 2553078"/>
                <a:gd name="connsiteX11" fmla="*/ 0 w 2555317"/>
                <a:gd name="connsiteY11" fmla="*/ 4527 h 2553078"/>
                <a:gd name="connsiteX0" fmla="*/ 0 w 2550931"/>
                <a:gd name="connsiteY0" fmla="*/ 4527 h 2553078"/>
                <a:gd name="connsiteX1" fmla="*/ 2181649 w 2550931"/>
                <a:gd name="connsiteY1" fmla="*/ 0 h 2553078"/>
                <a:gd name="connsiteX2" fmla="*/ 2182121 w 2550931"/>
                <a:gd name="connsiteY2" fmla="*/ 774072 h 2553078"/>
                <a:gd name="connsiteX3" fmla="*/ 1552433 w 2550931"/>
                <a:gd name="connsiteY3" fmla="*/ 774072 h 2553078"/>
                <a:gd name="connsiteX4" fmla="*/ 1552433 w 2550931"/>
                <a:gd name="connsiteY4" fmla="*/ 1760899 h 2553078"/>
                <a:gd name="connsiteX5" fmla="*/ 1846670 w 2550931"/>
                <a:gd name="connsiteY5" fmla="*/ 2104931 h 2553078"/>
                <a:gd name="connsiteX6" fmla="*/ 2549060 w 2550931"/>
                <a:gd name="connsiteY6" fmla="*/ 2095641 h 2553078"/>
                <a:gd name="connsiteX7" fmla="*/ 2550931 w 2550931"/>
                <a:gd name="connsiteY7" fmla="*/ 2543512 h 2553078"/>
                <a:gd name="connsiteX8" fmla="*/ 1833090 w 2550931"/>
                <a:gd name="connsiteY8" fmla="*/ 2553078 h 2553078"/>
                <a:gd name="connsiteX9" fmla="*/ 746674 w 2550931"/>
                <a:gd name="connsiteY9" fmla="*/ 1367074 h 2553078"/>
                <a:gd name="connsiteX10" fmla="*/ 4290 w 2550931"/>
                <a:gd name="connsiteY10" fmla="*/ 1371600 h 2553078"/>
                <a:gd name="connsiteX11" fmla="*/ 0 w 2550931"/>
                <a:gd name="connsiteY11" fmla="*/ 4527 h 2553078"/>
                <a:gd name="connsiteX0" fmla="*/ 0 w 2550931"/>
                <a:gd name="connsiteY0" fmla="*/ 4527 h 2553078"/>
                <a:gd name="connsiteX1" fmla="*/ 2181649 w 2550931"/>
                <a:gd name="connsiteY1" fmla="*/ 0 h 2553078"/>
                <a:gd name="connsiteX2" fmla="*/ 2182121 w 2550931"/>
                <a:gd name="connsiteY2" fmla="*/ 774072 h 2553078"/>
                <a:gd name="connsiteX3" fmla="*/ 1552433 w 2550931"/>
                <a:gd name="connsiteY3" fmla="*/ 774072 h 2553078"/>
                <a:gd name="connsiteX4" fmla="*/ 1552433 w 2550931"/>
                <a:gd name="connsiteY4" fmla="*/ 1760899 h 2553078"/>
                <a:gd name="connsiteX5" fmla="*/ 1846670 w 2550931"/>
                <a:gd name="connsiteY5" fmla="*/ 2104931 h 2553078"/>
                <a:gd name="connsiteX6" fmla="*/ 2541938 w 2550931"/>
                <a:gd name="connsiteY6" fmla="*/ 2093260 h 2553078"/>
                <a:gd name="connsiteX7" fmla="*/ 2550931 w 2550931"/>
                <a:gd name="connsiteY7" fmla="*/ 2543512 h 2553078"/>
                <a:gd name="connsiteX8" fmla="*/ 1833090 w 2550931"/>
                <a:gd name="connsiteY8" fmla="*/ 2553078 h 2553078"/>
                <a:gd name="connsiteX9" fmla="*/ 746674 w 2550931"/>
                <a:gd name="connsiteY9" fmla="*/ 1367074 h 2553078"/>
                <a:gd name="connsiteX10" fmla="*/ 4290 w 2550931"/>
                <a:gd name="connsiteY10" fmla="*/ 1371600 h 2553078"/>
                <a:gd name="connsiteX11" fmla="*/ 0 w 2550931"/>
                <a:gd name="connsiteY11" fmla="*/ 4527 h 2553078"/>
                <a:gd name="connsiteX0" fmla="*/ 0 w 2552943"/>
                <a:gd name="connsiteY0" fmla="*/ 4527 h 2553078"/>
                <a:gd name="connsiteX1" fmla="*/ 2181649 w 2552943"/>
                <a:gd name="connsiteY1" fmla="*/ 0 h 2553078"/>
                <a:gd name="connsiteX2" fmla="*/ 2182121 w 2552943"/>
                <a:gd name="connsiteY2" fmla="*/ 774072 h 2553078"/>
                <a:gd name="connsiteX3" fmla="*/ 1552433 w 2552943"/>
                <a:gd name="connsiteY3" fmla="*/ 774072 h 2553078"/>
                <a:gd name="connsiteX4" fmla="*/ 1552433 w 2552943"/>
                <a:gd name="connsiteY4" fmla="*/ 1760899 h 2553078"/>
                <a:gd name="connsiteX5" fmla="*/ 1846670 w 2552943"/>
                <a:gd name="connsiteY5" fmla="*/ 2104931 h 2553078"/>
                <a:gd name="connsiteX6" fmla="*/ 2551434 w 2552943"/>
                <a:gd name="connsiteY6" fmla="*/ 2093260 h 2553078"/>
                <a:gd name="connsiteX7" fmla="*/ 2550931 w 2552943"/>
                <a:gd name="connsiteY7" fmla="*/ 2543512 h 2553078"/>
                <a:gd name="connsiteX8" fmla="*/ 1833090 w 2552943"/>
                <a:gd name="connsiteY8" fmla="*/ 2553078 h 2553078"/>
                <a:gd name="connsiteX9" fmla="*/ 746674 w 2552943"/>
                <a:gd name="connsiteY9" fmla="*/ 1367074 h 2553078"/>
                <a:gd name="connsiteX10" fmla="*/ 4290 w 2552943"/>
                <a:gd name="connsiteY10" fmla="*/ 1371600 h 2553078"/>
                <a:gd name="connsiteX11" fmla="*/ 0 w 2552943"/>
                <a:gd name="connsiteY11" fmla="*/ 4527 h 2553078"/>
                <a:gd name="connsiteX0" fmla="*/ 0 w 2553305"/>
                <a:gd name="connsiteY0" fmla="*/ 4527 h 2553078"/>
                <a:gd name="connsiteX1" fmla="*/ 2181649 w 2553305"/>
                <a:gd name="connsiteY1" fmla="*/ 0 h 2553078"/>
                <a:gd name="connsiteX2" fmla="*/ 2182121 w 2553305"/>
                <a:gd name="connsiteY2" fmla="*/ 774072 h 2553078"/>
                <a:gd name="connsiteX3" fmla="*/ 1552433 w 2553305"/>
                <a:gd name="connsiteY3" fmla="*/ 774072 h 2553078"/>
                <a:gd name="connsiteX4" fmla="*/ 1552433 w 2553305"/>
                <a:gd name="connsiteY4" fmla="*/ 1760899 h 2553078"/>
                <a:gd name="connsiteX5" fmla="*/ 1846670 w 2553305"/>
                <a:gd name="connsiteY5" fmla="*/ 2104931 h 2553078"/>
                <a:gd name="connsiteX6" fmla="*/ 2551434 w 2553305"/>
                <a:gd name="connsiteY6" fmla="*/ 2093260 h 2553078"/>
                <a:gd name="connsiteX7" fmla="*/ 2553305 w 2553305"/>
                <a:gd name="connsiteY7" fmla="*/ 2545893 h 2553078"/>
                <a:gd name="connsiteX8" fmla="*/ 1833090 w 2553305"/>
                <a:gd name="connsiteY8" fmla="*/ 2553078 h 2553078"/>
                <a:gd name="connsiteX9" fmla="*/ 746674 w 2553305"/>
                <a:gd name="connsiteY9" fmla="*/ 1367074 h 2553078"/>
                <a:gd name="connsiteX10" fmla="*/ 4290 w 2553305"/>
                <a:gd name="connsiteY10" fmla="*/ 1371600 h 2553078"/>
                <a:gd name="connsiteX11" fmla="*/ 0 w 2553305"/>
                <a:gd name="connsiteY11" fmla="*/ 4527 h 2553078"/>
                <a:gd name="connsiteX0" fmla="*/ 0 w 2553305"/>
                <a:gd name="connsiteY0" fmla="*/ 4527 h 2553078"/>
                <a:gd name="connsiteX1" fmla="*/ 2181649 w 2553305"/>
                <a:gd name="connsiteY1" fmla="*/ 0 h 2553078"/>
                <a:gd name="connsiteX2" fmla="*/ 2182121 w 2553305"/>
                <a:gd name="connsiteY2" fmla="*/ 774072 h 2553078"/>
                <a:gd name="connsiteX3" fmla="*/ 1552433 w 2553305"/>
                <a:gd name="connsiteY3" fmla="*/ 774072 h 2553078"/>
                <a:gd name="connsiteX4" fmla="*/ 1552433 w 2553305"/>
                <a:gd name="connsiteY4" fmla="*/ 1760899 h 2553078"/>
                <a:gd name="connsiteX5" fmla="*/ 1846670 w 2553305"/>
                <a:gd name="connsiteY5" fmla="*/ 2104931 h 2553078"/>
                <a:gd name="connsiteX6" fmla="*/ 2551434 w 2553305"/>
                <a:gd name="connsiteY6" fmla="*/ 2093260 h 2553078"/>
                <a:gd name="connsiteX7" fmla="*/ 2553305 w 2553305"/>
                <a:gd name="connsiteY7" fmla="*/ 2536368 h 2553078"/>
                <a:gd name="connsiteX8" fmla="*/ 1833090 w 2553305"/>
                <a:gd name="connsiteY8" fmla="*/ 2553078 h 2553078"/>
                <a:gd name="connsiteX9" fmla="*/ 746674 w 2553305"/>
                <a:gd name="connsiteY9" fmla="*/ 1367074 h 2553078"/>
                <a:gd name="connsiteX10" fmla="*/ 4290 w 2553305"/>
                <a:gd name="connsiteY10" fmla="*/ 1371600 h 2553078"/>
                <a:gd name="connsiteX11" fmla="*/ 0 w 2553305"/>
                <a:gd name="connsiteY11" fmla="*/ 4527 h 255307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</a:cxnLst>
              <a:rect l="l" t="t" r="r" b="b"/>
              <a:pathLst>
                <a:path w="2553305" h="2553078">
                  <a:moveTo>
                    <a:pt x="0" y="4527"/>
                  </a:moveTo>
                  <a:lnTo>
                    <a:pt x="2181649" y="0"/>
                  </a:lnTo>
                  <a:cubicBezTo>
                    <a:pt x="2183394" y="258818"/>
                    <a:pt x="2180376" y="515254"/>
                    <a:pt x="2182121" y="774072"/>
                  </a:cubicBezTo>
                  <a:lnTo>
                    <a:pt x="1552433" y="774072"/>
                  </a:lnTo>
                  <a:lnTo>
                    <a:pt x="1552433" y="1760899"/>
                  </a:lnTo>
                  <a:lnTo>
                    <a:pt x="1846670" y="2104931"/>
                  </a:lnTo>
                  <a:lnTo>
                    <a:pt x="2551434" y="2093260"/>
                  </a:lnTo>
                  <a:cubicBezTo>
                    <a:pt x="2552943" y="2241756"/>
                    <a:pt x="2551796" y="2387872"/>
                    <a:pt x="2553305" y="2536368"/>
                  </a:cubicBezTo>
                  <a:lnTo>
                    <a:pt x="1833090" y="2553078"/>
                  </a:lnTo>
                  <a:lnTo>
                    <a:pt x="746674" y="1367074"/>
                  </a:lnTo>
                  <a:lnTo>
                    <a:pt x="4290" y="1371600"/>
                  </a:lnTo>
                  <a:cubicBezTo>
                    <a:pt x="1272" y="915909"/>
                    <a:pt x="3018" y="460218"/>
                    <a:pt x="0" y="4527"/>
                  </a:cubicBezTo>
                  <a:close/>
                </a:path>
              </a:pathLst>
            </a:custGeom>
            <a:noFill/>
            <a:ln>
              <a:solidFill>
                <a:srgbClr val="00D7D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00" name="Forme libre 499"/>
            <p:cNvSpPr/>
            <p:nvPr/>
          </p:nvSpPr>
          <p:spPr>
            <a:xfrm>
              <a:off x="230328" y="3422520"/>
              <a:ext cx="2240528" cy="3779513"/>
            </a:xfrm>
            <a:custGeom>
              <a:avLst/>
              <a:gdLst>
                <a:gd name="connsiteX0" fmla="*/ 23751 w 2190998"/>
                <a:gd name="connsiteY0" fmla="*/ 0 h 3782291"/>
                <a:gd name="connsiteX1" fmla="*/ 795647 w 2190998"/>
                <a:gd name="connsiteY1" fmla="*/ 5938 h 3782291"/>
                <a:gd name="connsiteX2" fmla="*/ 813460 w 2190998"/>
                <a:gd name="connsiteY2" fmla="*/ 1549730 h 3782291"/>
                <a:gd name="connsiteX3" fmla="*/ 1549730 w 2190998"/>
                <a:gd name="connsiteY3" fmla="*/ 2654135 h 3782291"/>
                <a:gd name="connsiteX4" fmla="*/ 2185060 w 2190998"/>
                <a:gd name="connsiteY4" fmla="*/ 2666011 h 3782291"/>
                <a:gd name="connsiteX5" fmla="*/ 2190998 w 2190998"/>
                <a:gd name="connsiteY5" fmla="*/ 3776354 h 3782291"/>
                <a:gd name="connsiteX6" fmla="*/ 0 w 2190998"/>
                <a:gd name="connsiteY6" fmla="*/ 3782291 h 3782291"/>
                <a:gd name="connsiteX7" fmla="*/ 23751 w 2190998"/>
                <a:gd name="connsiteY7" fmla="*/ 0 h 3782291"/>
                <a:gd name="connsiteX0" fmla="*/ 14226 w 2190998"/>
                <a:gd name="connsiteY0" fmla="*/ 0 h 3782291"/>
                <a:gd name="connsiteX1" fmla="*/ 795647 w 2190998"/>
                <a:gd name="connsiteY1" fmla="*/ 5938 h 3782291"/>
                <a:gd name="connsiteX2" fmla="*/ 813460 w 2190998"/>
                <a:gd name="connsiteY2" fmla="*/ 1549730 h 3782291"/>
                <a:gd name="connsiteX3" fmla="*/ 1549730 w 2190998"/>
                <a:gd name="connsiteY3" fmla="*/ 2654135 h 3782291"/>
                <a:gd name="connsiteX4" fmla="*/ 2185060 w 2190998"/>
                <a:gd name="connsiteY4" fmla="*/ 2666011 h 3782291"/>
                <a:gd name="connsiteX5" fmla="*/ 2190998 w 2190998"/>
                <a:gd name="connsiteY5" fmla="*/ 3776354 h 3782291"/>
                <a:gd name="connsiteX6" fmla="*/ 0 w 2190998"/>
                <a:gd name="connsiteY6" fmla="*/ 3782291 h 3782291"/>
                <a:gd name="connsiteX7" fmla="*/ 14226 w 2190998"/>
                <a:gd name="connsiteY7" fmla="*/ 0 h 3782291"/>
                <a:gd name="connsiteX0" fmla="*/ 14226 w 2190998"/>
                <a:gd name="connsiteY0" fmla="*/ 0 h 3782291"/>
                <a:gd name="connsiteX1" fmla="*/ 795647 w 2190998"/>
                <a:gd name="connsiteY1" fmla="*/ 5938 h 3782291"/>
                <a:gd name="connsiteX2" fmla="*/ 809000 w 2190998"/>
                <a:gd name="connsiteY2" fmla="*/ 1545269 h 3782291"/>
                <a:gd name="connsiteX3" fmla="*/ 1549730 w 2190998"/>
                <a:gd name="connsiteY3" fmla="*/ 2654135 h 3782291"/>
                <a:gd name="connsiteX4" fmla="*/ 2185060 w 2190998"/>
                <a:gd name="connsiteY4" fmla="*/ 2666011 h 3782291"/>
                <a:gd name="connsiteX5" fmla="*/ 2190998 w 2190998"/>
                <a:gd name="connsiteY5" fmla="*/ 3776354 h 3782291"/>
                <a:gd name="connsiteX6" fmla="*/ 0 w 2190998"/>
                <a:gd name="connsiteY6" fmla="*/ 3782291 h 3782291"/>
                <a:gd name="connsiteX7" fmla="*/ 14226 w 2190998"/>
                <a:gd name="connsiteY7" fmla="*/ 0 h 3782291"/>
                <a:gd name="connsiteX0" fmla="*/ 0 w 2203535"/>
                <a:gd name="connsiteY0" fmla="*/ 0 h 3777830"/>
                <a:gd name="connsiteX1" fmla="*/ 808184 w 2203535"/>
                <a:gd name="connsiteY1" fmla="*/ 1477 h 3777830"/>
                <a:gd name="connsiteX2" fmla="*/ 821537 w 2203535"/>
                <a:gd name="connsiteY2" fmla="*/ 1540808 h 3777830"/>
                <a:gd name="connsiteX3" fmla="*/ 1562267 w 2203535"/>
                <a:gd name="connsiteY3" fmla="*/ 2649674 h 3777830"/>
                <a:gd name="connsiteX4" fmla="*/ 2197597 w 2203535"/>
                <a:gd name="connsiteY4" fmla="*/ 2661550 h 3777830"/>
                <a:gd name="connsiteX5" fmla="*/ 2203535 w 2203535"/>
                <a:gd name="connsiteY5" fmla="*/ 3771893 h 3777830"/>
                <a:gd name="connsiteX6" fmla="*/ 12537 w 2203535"/>
                <a:gd name="connsiteY6" fmla="*/ 3777830 h 3777830"/>
                <a:gd name="connsiteX7" fmla="*/ 0 w 2203535"/>
                <a:gd name="connsiteY7" fmla="*/ 0 h 3777830"/>
                <a:gd name="connsiteX0" fmla="*/ 5305 w 2190998"/>
                <a:gd name="connsiteY0" fmla="*/ 0 h 3777830"/>
                <a:gd name="connsiteX1" fmla="*/ 795647 w 2190998"/>
                <a:gd name="connsiteY1" fmla="*/ 1477 h 3777830"/>
                <a:gd name="connsiteX2" fmla="*/ 809000 w 2190998"/>
                <a:gd name="connsiteY2" fmla="*/ 1540808 h 3777830"/>
                <a:gd name="connsiteX3" fmla="*/ 1549730 w 2190998"/>
                <a:gd name="connsiteY3" fmla="*/ 2649674 h 3777830"/>
                <a:gd name="connsiteX4" fmla="*/ 2185060 w 2190998"/>
                <a:gd name="connsiteY4" fmla="*/ 2661550 h 3777830"/>
                <a:gd name="connsiteX5" fmla="*/ 2190998 w 2190998"/>
                <a:gd name="connsiteY5" fmla="*/ 3771893 h 3777830"/>
                <a:gd name="connsiteX6" fmla="*/ 0 w 2190998"/>
                <a:gd name="connsiteY6" fmla="*/ 3777830 h 3777830"/>
                <a:gd name="connsiteX7" fmla="*/ 5305 w 2190998"/>
                <a:gd name="connsiteY7" fmla="*/ 0 h 3777830"/>
                <a:gd name="connsiteX0" fmla="*/ 5305 w 2190998"/>
                <a:gd name="connsiteY0" fmla="*/ 0 h 3777830"/>
                <a:gd name="connsiteX1" fmla="*/ 795647 w 2190998"/>
                <a:gd name="connsiteY1" fmla="*/ 1477 h 3777830"/>
                <a:gd name="connsiteX2" fmla="*/ 809000 w 2190998"/>
                <a:gd name="connsiteY2" fmla="*/ 1540808 h 3777830"/>
                <a:gd name="connsiteX3" fmla="*/ 1549730 w 2190998"/>
                <a:gd name="connsiteY3" fmla="*/ 2649674 h 3777830"/>
                <a:gd name="connsiteX4" fmla="*/ 2185060 w 2190998"/>
                <a:gd name="connsiteY4" fmla="*/ 2643708 h 3777830"/>
                <a:gd name="connsiteX5" fmla="*/ 2190998 w 2190998"/>
                <a:gd name="connsiteY5" fmla="*/ 3771893 h 3777830"/>
                <a:gd name="connsiteX6" fmla="*/ 0 w 2190998"/>
                <a:gd name="connsiteY6" fmla="*/ 3777830 h 3777830"/>
                <a:gd name="connsiteX7" fmla="*/ 5305 w 2190998"/>
                <a:gd name="connsiteY7" fmla="*/ 0 h 3777830"/>
                <a:gd name="connsiteX0" fmla="*/ 5305 w 2190998"/>
                <a:gd name="connsiteY0" fmla="*/ 0 h 3777830"/>
                <a:gd name="connsiteX1" fmla="*/ 795647 w 2190998"/>
                <a:gd name="connsiteY1" fmla="*/ 1477 h 3777830"/>
                <a:gd name="connsiteX2" fmla="*/ 809000 w 2190998"/>
                <a:gd name="connsiteY2" fmla="*/ 1540808 h 3777830"/>
                <a:gd name="connsiteX3" fmla="*/ 1549730 w 2190998"/>
                <a:gd name="connsiteY3" fmla="*/ 2636293 h 3777830"/>
                <a:gd name="connsiteX4" fmla="*/ 2185060 w 2190998"/>
                <a:gd name="connsiteY4" fmla="*/ 2643708 h 3777830"/>
                <a:gd name="connsiteX5" fmla="*/ 2190998 w 2190998"/>
                <a:gd name="connsiteY5" fmla="*/ 3771893 h 3777830"/>
                <a:gd name="connsiteX6" fmla="*/ 0 w 2190998"/>
                <a:gd name="connsiteY6" fmla="*/ 3777830 h 3777830"/>
                <a:gd name="connsiteX7" fmla="*/ 5305 w 2190998"/>
                <a:gd name="connsiteY7" fmla="*/ 0 h 3777830"/>
                <a:gd name="connsiteX0" fmla="*/ 5305 w 2190998"/>
                <a:gd name="connsiteY0" fmla="*/ 0 h 3777830"/>
                <a:gd name="connsiteX1" fmla="*/ 795647 w 2190998"/>
                <a:gd name="connsiteY1" fmla="*/ 1477 h 3777830"/>
                <a:gd name="connsiteX2" fmla="*/ 809000 w 2190998"/>
                <a:gd name="connsiteY2" fmla="*/ 1540808 h 3777830"/>
                <a:gd name="connsiteX3" fmla="*/ 1549730 w 2190998"/>
                <a:gd name="connsiteY3" fmla="*/ 2636293 h 3777830"/>
                <a:gd name="connsiteX4" fmla="*/ 2185060 w 2190998"/>
                <a:gd name="connsiteY4" fmla="*/ 2639248 h 3777830"/>
                <a:gd name="connsiteX5" fmla="*/ 2190998 w 2190998"/>
                <a:gd name="connsiteY5" fmla="*/ 3771893 h 3777830"/>
                <a:gd name="connsiteX6" fmla="*/ 0 w 2190998"/>
                <a:gd name="connsiteY6" fmla="*/ 3777830 h 3777830"/>
                <a:gd name="connsiteX7" fmla="*/ 5305 w 2190998"/>
                <a:gd name="connsiteY7" fmla="*/ 0 h 3777830"/>
                <a:gd name="connsiteX0" fmla="*/ 5305 w 2190998"/>
                <a:gd name="connsiteY0" fmla="*/ 2983 h 3780813"/>
                <a:gd name="connsiteX1" fmla="*/ 800108 w 2190998"/>
                <a:gd name="connsiteY1" fmla="*/ 0 h 3780813"/>
                <a:gd name="connsiteX2" fmla="*/ 809000 w 2190998"/>
                <a:gd name="connsiteY2" fmla="*/ 1543791 h 3780813"/>
                <a:gd name="connsiteX3" fmla="*/ 1549730 w 2190998"/>
                <a:gd name="connsiteY3" fmla="*/ 2639276 h 3780813"/>
                <a:gd name="connsiteX4" fmla="*/ 2185060 w 2190998"/>
                <a:gd name="connsiteY4" fmla="*/ 2642231 h 3780813"/>
                <a:gd name="connsiteX5" fmla="*/ 2190998 w 2190998"/>
                <a:gd name="connsiteY5" fmla="*/ 3774876 h 3780813"/>
                <a:gd name="connsiteX6" fmla="*/ 0 w 2190998"/>
                <a:gd name="connsiteY6" fmla="*/ 3780813 h 3780813"/>
                <a:gd name="connsiteX7" fmla="*/ 5305 w 2190998"/>
                <a:gd name="connsiteY7" fmla="*/ 2983 h 3780813"/>
                <a:gd name="connsiteX0" fmla="*/ 5305 w 2190998"/>
                <a:gd name="connsiteY0" fmla="*/ 7444 h 3785274"/>
                <a:gd name="connsiteX1" fmla="*/ 804568 w 2190998"/>
                <a:gd name="connsiteY1" fmla="*/ 0 h 3785274"/>
                <a:gd name="connsiteX2" fmla="*/ 809000 w 2190998"/>
                <a:gd name="connsiteY2" fmla="*/ 1548252 h 3785274"/>
                <a:gd name="connsiteX3" fmla="*/ 1549730 w 2190998"/>
                <a:gd name="connsiteY3" fmla="*/ 2643737 h 3785274"/>
                <a:gd name="connsiteX4" fmla="*/ 2185060 w 2190998"/>
                <a:gd name="connsiteY4" fmla="*/ 2646692 h 3785274"/>
                <a:gd name="connsiteX5" fmla="*/ 2190998 w 2190998"/>
                <a:gd name="connsiteY5" fmla="*/ 3779337 h 3785274"/>
                <a:gd name="connsiteX6" fmla="*/ 0 w 2190998"/>
                <a:gd name="connsiteY6" fmla="*/ 3785274 h 3785274"/>
                <a:gd name="connsiteX7" fmla="*/ 5305 w 2190998"/>
                <a:gd name="connsiteY7" fmla="*/ 7444 h 3785274"/>
                <a:gd name="connsiteX0" fmla="*/ 5305 w 2190998"/>
                <a:gd name="connsiteY0" fmla="*/ 7444 h 3785274"/>
                <a:gd name="connsiteX1" fmla="*/ 804568 w 2190998"/>
                <a:gd name="connsiteY1" fmla="*/ 0 h 3785274"/>
                <a:gd name="connsiteX2" fmla="*/ 809000 w 2190998"/>
                <a:gd name="connsiteY2" fmla="*/ 1548252 h 3785274"/>
                <a:gd name="connsiteX3" fmla="*/ 1549730 w 2190998"/>
                <a:gd name="connsiteY3" fmla="*/ 2643737 h 3785274"/>
                <a:gd name="connsiteX4" fmla="*/ 2185060 w 2190998"/>
                <a:gd name="connsiteY4" fmla="*/ 2646692 h 3785274"/>
                <a:gd name="connsiteX5" fmla="*/ 2190998 w 2190998"/>
                <a:gd name="connsiteY5" fmla="*/ 3779337 h 3785274"/>
                <a:gd name="connsiteX6" fmla="*/ 0 w 2190998"/>
                <a:gd name="connsiteY6" fmla="*/ 3785274 h 3785274"/>
                <a:gd name="connsiteX7" fmla="*/ 5305 w 2190998"/>
                <a:gd name="connsiteY7" fmla="*/ 7444 h 3785274"/>
                <a:gd name="connsiteX0" fmla="*/ 5305 w 2190998"/>
                <a:gd name="connsiteY0" fmla="*/ 0 h 3777830"/>
                <a:gd name="connsiteX1" fmla="*/ 809029 w 2190998"/>
                <a:gd name="connsiteY1" fmla="*/ 1477 h 3777830"/>
                <a:gd name="connsiteX2" fmla="*/ 809000 w 2190998"/>
                <a:gd name="connsiteY2" fmla="*/ 1540808 h 3777830"/>
                <a:gd name="connsiteX3" fmla="*/ 1549730 w 2190998"/>
                <a:gd name="connsiteY3" fmla="*/ 2636293 h 3777830"/>
                <a:gd name="connsiteX4" fmla="*/ 2185060 w 2190998"/>
                <a:gd name="connsiteY4" fmla="*/ 2639248 h 3777830"/>
                <a:gd name="connsiteX5" fmla="*/ 2190998 w 2190998"/>
                <a:gd name="connsiteY5" fmla="*/ 3771893 h 3777830"/>
                <a:gd name="connsiteX6" fmla="*/ 0 w 2190998"/>
                <a:gd name="connsiteY6" fmla="*/ 3777830 h 3777830"/>
                <a:gd name="connsiteX7" fmla="*/ 5305 w 2190998"/>
                <a:gd name="connsiteY7" fmla="*/ 0 h 3777830"/>
                <a:gd name="connsiteX0" fmla="*/ 5305 w 2240379"/>
                <a:gd name="connsiteY0" fmla="*/ 0 h 3777830"/>
                <a:gd name="connsiteX1" fmla="*/ 809029 w 2240379"/>
                <a:gd name="connsiteY1" fmla="*/ 1477 h 3777830"/>
                <a:gd name="connsiteX2" fmla="*/ 809000 w 2240379"/>
                <a:gd name="connsiteY2" fmla="*/ 1540808 h 3777830"/>
                <a:gd name="connsiteX3" fmla="*/ 1549730 w 2240379"/>
                <a:gd name="connsiteY3" fmla="*/ 2636293 h 3777830"/>
                <a:gd name="connsiteX4" fmla="*/ 2238400 w 2240379"/>
                <a:gd name="connsiteY4" fmla="*/ 2639248 h 3777830"/>
                <a:gd name="connsiteX5" fmla="*/ 2190998 w 2240379"/>
                <a:gd name="connsiteY5" fmla="*/ 3771893 h 3777830"/>
                <a:gd name="connsiteX6" fmla="*/ 0 w 2240379"/>
                <a:gd name="connsiteY6" fmla="*/ 3777830 h 3777830"/>
                <a:gd name="connsiteX7" fmla="*/ 5305 w 2240379"/>
                <a:gd name="connsiteY7" fmla="*/ 0 h 3777830"/>
                <a:gd name="connsiteX0" fmla="*/ 5305 w 2240528"/>
                <a:gd name="connsiteY0" fmla="*/ 0 h 3779513"/>
                <a:gd name="connsiteX1" fmla="*/ 809029 w 2240528"/>
                <a:gd name="connsiteY1" fmla="*/ 1477 h 3779513"/>
                <a:gd name="connsiteX2" fmla="*/ 809000 w 2240528"/>
                <a:gd name="connsiteY2" fmla="*/ 1540808 h 3779513"/>
                <a:gd name="connsiteX3" fmla="*/ 1549730 w 2240528"/>
                <a:gd name="connsiteY3" fmla="*/ 2636293 h 3779513"/>
                <a:gd name="connsiteX4" fmla="*/ 2238400 w 2240528"/>
                <a:gd name="connsiteY4" fmla="*/ 2639248 h 3779513"/>
                <a:gd name="connsiteX5" fmla="*/ 2240528 w 2240528"/>
                <a:gd name="connsiteY5" fmla="*/ 3779513 h 3779513"/>
                <a:gd name="connsiteX6" fmla="*/ 0 w 2240528"/>
                <a:gd name="connsiteY6" fmla="*/ 3777830 h 3779513"/>
                <a:gd name="connsiteX7" fmla="*/ 5305 w 2240528"/>
                <a:gd name="connsiteY7" fmla="*/ 0 h 3779513"/>
                <a:gd name="connsiteX0" fmla="*/ 5305 w 2251958"/>
                <a:gd name="connsiteY0" fmla="*/ 0 h 3779513"/>
                <a:gd name="connsiteX1" fmla="*/ 809029 w 2251958"/>
                <a:gd name="connsiteY1" fmla="*/ 1477 h 3779513"/>
                <a:gd name="connsiteX2" fmla="*/ 809000 w 2251958"/>
                <a:gd name="connsiteY2" fmla="*/ 1540808 h 3779513"/>
                <a:gd name="connsiteX3" fmla="*/ 1549730 w 2251958"/>
                <a:gd name="connsiteY3" fmla="*/ 2636293 h 3779513"/>
                <a:gd name="connsiteX4" fmla="*/ 2238400 w 2251958"/>
                <a:gd name="connsiteY4" fmla="*/ 2639248 h 3779513"/>
                <a:gd name="connsiteX5" fmla="*/ 2251958 w 2251958"/>
                <a:gd name="connsiteY5" fmla="*/ 3779513 h 3779513"/>
                <a:gd name="connsiteX6" fmla="*/ 0 w 2251958"/>
                <a:gd name="connsiteY6" fmla="*/ 3777830 h 3779513"/>
                <a:gd name="connsiteX7" fmla="*/ 5305 w 2251958"/>
                <a:gd name="connsiteY7" fmla="*/ 0 h 3779513"/>
                <a:gd name="connsiteX0" fmla="*/ 5305 w 2240528"/>
                <a:gd name="connsiteY0" fmla="*/ 0 h 3779513"/>
                <a:gd name="connsiteX1" fmla="*/ 809029 w 2240528"/>
                <a:gd name="connsiteY1" fmla="*/ 1477 h 3779513"/>
                <a:gd name="connsiteX2" fmla="*/ 809000 w 2240528"/>
                <a:gd name="connsiteY2" fmla="*/ 1540808 h 3779513"/>
                <a:gd name="connsiteX3" fmla="*/ 1549730 w 2240528"/>
                <a:gd name="connsiteY3" fmla="*/ 2636293 h 3779513"/>
                <a:gd name="connsiteX4" fmla="*/ 2238400 w 2240528"/>
                <a:gd name="connsiteY4" fmla="*/ 2639248 h 3779513"/>
                <a:gd name="connsiteX5" fmla="*/ 2240528 w 2240528"/>
                <a:gd name="connsiteY5" fmla="*/ 3779513 h 3779513"/>
                <a:gd name="connsiteX6" fmla="*/ 0 w 2240528"/>
                <a:gd name="connsiteY6" fmla="*/ 3777830 h 3779513"/>
                <a:gd name="connsiteX7" fmla="*/ 5305 w 2240528"/>
                <a:gd name="connsiteY7" fmla="*/ 0 h 3779513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</a:cxnLst>
              <a:rect l="l" t="t" r="r" b="b"/>
              <a:pathLst>
                <a:path w="2240528" h="3779513">
                  <a:moveTo>
                    <a:pt x="5305" y="0"/>
                  </a:moveTo>
                  <a:lnTo>
                    <a:pt x="809029" y="1477"/>
                  </a:lnTo>
                  <a:cubicBezTo>
                    <a:pt x="810506" y="517561"/>
                    <a:pt x="807523" y="1024724"/>
                    <a:pt x="809000" y="1540808"/>
                  </a:cubicBezTo>
                  <a:lnTo>
                    <a:pt x="1549730" y="2636293"/>
                  </a:lnTo>
                  <a:lnTo>
                    <a:pt x="2238400" y="2639248"/>
                  </a:lnTo>
                  <a:cubicBezTo>
                    <a:pt x="2240379" y="3009362"/>
                    <a:pt x="2238549" y="3409399"/>
                    <a:pt x="2240528" y="3779513"/>
                  </a:cubicBezTo>
                  <a:lnTo>
                    <a:pt x="0" y="3777830"/>
                  </a:lnTo>
                  <a:cubicBezTo>
                    <a:pt x="1768" y="2518553"/>
                    <a:pt x="3537" y="1259277"/>
                    <a:pt x="5305" y="0"/>
                  </a:cubicBezTo>
                  <a:close/>
                </a:path>
              </a:pathLst>
            </a:custGeom>
            <a:noFill/>
            <a:ln>
              <a:solidFill>
                <a:srgbClr val="00B05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61" name="ZoneTexte 179"/>
            <p:cNvSpPr txBox="1">
              <a:spLocks noChangeArrowheads="1"/>
            </p:cNvSpPr>
            <p:nvPr/>
          </p:nvSpPr>
          <p:spPr bwMode="auto">
            <a:xfrm>
              <a:off x="0" y="0"/>
              <a:ext cx="235814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fr-FR" sz="1200" i="1" dirty="0" smtClean="0">
                  <a:latin typeface="Times New Roman" pitchFamily="18" charset="0"/>
                  <a:cs typeface="Times New Roman" pitchFamily="18" charset="0"/>
                </a:rPr>
                <a:t>Richard et al</a:t>
              </a:r>
              <a:r>
                <a:rPr lang="fr-FR" sz="1200" dirty="0" smtClean="0">
                  <a:latin typeface="Times New Roman" pitchFamily="18" charset="0"/>
                  <a:cs typeface="Times New Roman" pitchFamily="18" charset="0"/>
                </a:rPr>
                <a:t>. </a:t>
              </a:r>
              <a:r>
                <a:rPr lang="fr-FR" sz="1200" dirty="0" err="1" smtClean="0">
                  <a:latin typeface="Times New Roman" pitchFamily="18" charset="0"/>
                  <a:cs typeface="Times New Roman" pitchFamily="18" charset="0"/>
                </a:rPr>
                <a:t>Appendix</a:t>
              </a:r>
              <a:r>
                <a:rPr lang="fr-FR" sz="1200" dirty="0" smtClean="0">
                  <a:latin typeface="Times New Roman" pitchFamily="18" charset="0"/>
                  <a:cs typeface="Times New Roman" pitchFamily="18" charset="0"/>
                </a:rPr>
                <a:t> Figure A1</a:t>
              </a:r>
              <a:endParaRPr lang="fr-FR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grpSp>
          <p:nvGrpSpPr>
            <p:cNvPr id="464" name="Groupe 463"/>
            <p:cNvGrpSpPr/>
            <p:nvPr/>
          </p:nvGrpSpPr>
          <p:grpSpPr>
            <a:xfrm>
              <a:off x="3445877" y="3621890"/>
              <a:ext cx="3318439" cy="3914706"/>
              <a:chOff x="14287" y="4011968"/>
              <a:chExt cx="7151715" cy="4575607"/>
            </a:xfrm>
          </p:grpSpPr>
          <p:sp>
            <p:nvSpPr>
              <p:cNvPr id="465" name="Rectangle 294"/>
              <p:cNvSpPr>
                <a:spLocks noChangeArrowheads="1"/>
              </p:cNvSpPr>
              <p:nvPr/>
            </p:nvSpPr>
            <p:spPr bwMode="auto">
              <a:xfrm>
                <a:off x="4765676" y="4011968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340</a:t>
                </a:r>
              </a:p>
            </p:txBody>
          </p:sp>
          <p:sp>
            <p:nvSpPr>
              <p:cNvPr id="466" name="Freeform 295"/>
              <p:cNvSpPr>
                <a:spLocks/>
              </p:cNvSpPr>
              <p:nvPr/>
            </p:nvSpPr>
            <p:spPr bwMode="auto">
              <a:xfrm>
                <a:off x="3560763" y="4097338"/>
                <a:ext cx="1200150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756" y="0"/>
                  </a:cxn>
                </a:cxnLst>
                <a:rect l="0" t="0" r="r" b="b"/>
                <a:pathLst>
                  <a:path w="756" h="33">
                    <a:moveTo>
                      <a:pt x="0" y="33"/>
                    </a:moveTo>
                    <a:lnTo>
                      <a:pt x="0" y="0"/>
                    </a:lnTo>
                    <a:lnTo>
                      <a:pt x="75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69" name="Rectangle 296"/>
              <p:cNvSpPr>
                <a:spLocks noChangeArrowheads="1"/>
              </p:cNvSpPr>
              <p:nvPr/>
            </p:nvSpPr>
            <p:spPr bwMode="auto">
              <a:xfrm>
                <a:off x="4451350" y="4108339"/>
                <a:ext cx="1278014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200</a:t>
                </a:r>
              </a:p>
            </p:txBody>
          </p:sp>
          <p:sp>
            <p:nvSpPr>
              <p:cNvPr id="470" name="Freeform 297"/>
              <p:cNvSpPr>
                <a:spLocks/>
              </p:cNvSpPr>
              <p:nvPr/>
            </p:nvSpPr>
            <p:spPr bwMode="auto">
              <a:xfrm>
                <a:off x="3560763" y="4159250"/>
                <a:ext cx="885825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558" y="33"/>
                  </a:cxn>
                </a:cxnLst>
                <a:rect l="0" t="0" r="r" b="b"/>
                <a:pathLst>
                  <a:path w="558" h="33">
                    <a:moveTo>
                      <a:pt x="0" y="0"/>
                    </a:moveTo>
                    <a:lnTo>
                      <a:pt x="0" y="33"/>
                    </a:lnTo>
                    <a:lnTo>
                      <a:pt x="558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1" name="Freeform 298"/>
              <p:cNvSpPr>
                <a:spLocks/>
              </p:cNvSpPr>
              <p:nvPr/>
            </p:nvSpPr>
            <p:spPr bwMode="auto">
              <a:xfrm>
                <a:off x="2647950" y="4154488"/>
                <a:ext cx="912813" cy="109538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575" y="0"/>
                  </a:cxn>
                </a:cxnLst>
                <a:rect l="0" t="0" r="r" b="b"/>
                <a:pathLst>
                  <a:path w="575" h="69">
                    <a:moveTo>
                      <a:pt x="0" y="69"/>
                    </a:moveTo>
                    <a:lnTo>
                      <a:pt x="0" y="0"/>
                    </a:lnTo>
                    <a:lnTo>
                      <a:pt x="57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2" name="Rectangle 299"/>
              <p:cNvSpPr>
                <a:spLocks noChangeArrowheads="1"/>
              </p:cNvSpPr>
              <p:nvPr/>
            </p:nvSpPr>
            <p:spPr bwMode="auto">
              <a:xfrm>
                <a:off x="4638675" y="4247740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360</a:t>
                </a:r>
              </a:p>
            </p:txBody>
          </p:sp>
          <p:sp>
            <p:nvSpPr>
              <p:cNvPr id="475" name="Freeform 300"/>
              <p:cNvSpPr>
                <a:spLocks/>
              </p:cNvSpPr>
              <p:nvPr/>
            </p:nvSpPr>
            <p:spPr bwMode="auto">
              <a:xfrm>
                <a:off x="4541838" y="4325938"/>
                <a:ext cx="92075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58" y="0"/>
                  </a:cxn>
                </a:cxnLst>
                <a:rect l="0" t="0" r="r" b="b"/>
                <a:pathLst>
                  <a:path w="58" h="33">
                    <a:moveTo>
                      <a:pt x="0" y="33"/>
                    </a:moveTo>
                    <a:lnTo>
                      <a:pt x="0" y="0"/>
                    </a:lnTo>
                    <a:lnTo>
                      <a:pt x="5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6" name="Rectangle 301"/>
              <p:cNvSpPr>
                <a:spLocks noChangeArrowheads="1"/>
              </p:cNvSpPr>
              <p:nvPr/>
            </p:nvSpPr>
            <p:spPr bwMode="auto">
              <a:xfrm>
                <a:off x="4863838" y="4354868"/>
                <a:ext cx="1278014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220</a:t>
                </a:r>
              </a:p>
            </p:txBody>
          </p:sp>
          <p:sp>
            <p:nvSpPr>
              <p:cNvPr id="477" name="Freeform 302"/>
              <p:cNvSpPr>
                <a:spLocks/>
              </p:cNvSpPr>
              <p:nvPr/>
            </p:nvSpPr>
            <p:spPr bwMode="auto">
              <a:xfrm>
                <a:off x="4541838" y="4387850"/>
                <a:ext cx="323850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204" y="33"/>
                  </a:cxn>
                </a:cxnLst>
                <a:rect l="0" t="0" r="r" b="b"/>
                <a:pathLst>
                  <a:path w="204" h="33">
                    <a:moveTo>
                      <a:pt x="0" y="0"/>
                    </a:moveTo>
                    <a:lnTo>
                      <a:pt x="0" y="33"/>
                    </a:lnTo>
                    <a:lnTo>
                      <a:pt x="204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8" name="Freeform 303"/>
              <p:cNvSpPr>
                <a:spLocks/>
              </p:cNvSpPr>
              <p:nvPr/>
            </p:nvSpPr>
            <p:spPr bwMode="auto">
              <a:xfrm>
                <a:off x="2647950" y="4273550"/>
                <a:ext cx="1893888" cy="1095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1193" y="69"/>
                  </a:cxn>
                </a:cxnLst>
                <a:rect l="0" t="0" r="r" b="b"/>
                <a:pathLst>
                  <a:path w="1193" h="69">
                    <a:moveTo>
                      <a:pt x="0" y="0"/>
                    </a:moveTo>
                    <a:lnTo>
                      <a:pt x="0" y="69"/>
                    </a:lnTo>
                    <a:lnTo>
                      <a:pt x="1193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79" name="Freeform 304"/>
              <p:cNvSpPr>
                <a:spLocks/>
              </p:cNvSpPr>
              <p:nvPr/>
            </p:nvSpPr>
            <p:spPr bwMode="auto">
              <a:xfrm>
                <a:off x="2066925" y="4268788"/>
                <a:ext cx="581025" cy="138113"/>
              </a:xfrm>
              <a:custGeom>
                <a:avLst/>
                <a:gdLst/>
                <a:ahLst/>
                <a:cxnLst>
                  <a:cxn ang="0">
                    <a:pos x="0" y="87"/>
                  </a:cxn>
                  <a:cxn ang="0">
                    <a:pos x="0" y="0"/>
                  </a:cxn>
                  <a:cxn ang="0">
                    <a:pos x="366" y="0"/>
                  </a:cxn>
                </a:cxnLst>
                <a:rect l="0" t="0" r="r" b="b"/>
                <a:pathLst>
                  <a:path w="366" h="87">
                    <a:moveTo>
                      <a:pt x="0" y="87"/>
                    </a:moveTo>
                    <a:lnTo>
                      <a:pt x="0" y="0"/>
                    </a:lnTo>
                    <a:lnTo>
                      <a:pt x="36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0" name="Rectangle 305"/>
              <p:cNvSpPr>
                <a:spLocks noChangeArrowheads="1"/>
              </p:cNvSpPr>
              <p:nvPr/>
            </p:nvSpPr>
            <p:spPr bwMode="auto">
              <a:xfrm>
                <a:off x="3833815" y="4472752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70</a:t>
                </a:r>
              </a:p>
            </p:txBody>
          </p:sp>
          <p:sp>
            <p:nvSpPr>
              <p:cNvPr id="481" name="Freeform 306"/>
              <p:cNvSpPr>
                <a:spLocks/>
              </p:cNvSpPr>
              <p:nvPr/>
            </p:nvSpPr>
            <p:spPr bwMode="auto">
              <a:xfrm>
                <a:off x="2066925" y="4416425"/>
                <a:ext cx="1762125" cy="1381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7"/>
                  </a:cxn>
                  <a:cxn ang="0">
                    <a:pos x="1110" y="87"/>
                  </a:cxn>
                </a:cxnLst>
                <a:rect l="0" t="0" r="r" b="b"/>
                <a:pathLst>
                  <a:path w="1110" h="87">
                    <a:moveTo>
                      <a:pt x="0" y="0"/>
                    </a:moveTo>
                    <a:lnTo>
                      <a:pt x="0" y="87"/>
                    </a:lnTo>
                    <a:lnTo>
                      <a:pt x="1110" y="8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2" name="Freeform 307"/>
              <p:cNvSpPr>
                <a:spLocks/>
              </p:cNvSpPr>
              <p:nvPr/>
            </p:nvSpPr>
            <p:spPr bwMode="auto">
              <a:xfrm>
                <a:off x="1360487" y="4411663"/>
                <a:ext cx="706438" cy="152400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445" y="0"/>
                  </a:cxn>
                </a:cxnLst>
                <a:rect l="0" t="0" r="r" b="b"/>
                <a:pathLst>
                  <a:path w="445" h="96">
                    <a:moveTo>
                      <a:pt x="0" y="96"/>
                    </a:moveTo>
                    <a:lnTo>
                      <a:pt x="0" y="0"/>
                    </a:lnTo>
                    <a:lnTo>
                      <a:pt x="44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3" name="Rectangle 308"/>
              <p:cNvSpPr>
                <a:spLocks noChangeArrowheads="1"/>
              </p:cNvSpPr>
              <p:nvPr/>
            </p:nvSpPr>
            <p:spPr bwMode="auto">
              <a:xfrm>
                <a:off x="3527424" y="4583468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390</a:t>
                </a:r>
              </a:p>
            </p:txBody>
          </p:sp>
          <p:sp>
            <p:nvSpPr>
              <p:cNvPr id="484" name="Freeform 309"/>
              <p:cNvSpPr>
                <a:spLocks/>
              </p:cNvSpPr>
              <p:nvPr/>
            </p:nvSpPr>
            <p:spPr bwMode="auto">
              <a:xfrm>
                <a:off x="3513138" y="4668838"/>
                <a:ext cx="9525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6" y="0"/>
                  </a:cxn>
                </a:cxnLst>
                <a:rect l="0" t="0" r="r" b="b"/>
                <a:pathLst>
                  <a:path w="6" h="33">
                    <a:moveTo>
                      <a:pt x="0" y="33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5" name="Rectangle 310"/>
              <p:cNvSpPr>
                <a:spLocks noChangeArrowheads="1"/>
              </p:cNvSpPr>
              <p:nvPr/>
            </p:nvSpPr>
            <p:spPr bwMode="auto">
              <a:xfrm>
                <a:off x="3614738" y="4701353"/>
                <a:ext cx="1278014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250</a:t>
                </a:r>
              </a:p>
            </p:txBody>
          </p:sp>
          <p:sp>
            <p:nvSpPr>
              <p:cNvPr id="486" name="Freeform 311"/>
              <p:cNvSpPr>
                <a:spLocks/>
              </p:cNvSpPr>
              <p:nvPr/>
            </p:nvSpPr>
            <p:spPr bwMode="auto">
              <a:xfrm>
                <a:off x="3513138" y="4730750"/>
                <a:ext cx="96838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61" y="33"/>
                  </a:cxn>
                </a:cxnLst>
                <a:rect l="0" t="0" r="r" b="b"/>
                <a:pathLst>
                  <a:path w="61" h="33">
                    <a:moveTo>
                      <a:pt x="0" y="0"/>
                    </a:moveTo>
                    <a:lnTo>
                      <a:pt x="0" y="33"/>
                    </a:lnTo>
                    <a:lnTo>
                      <a:pt x="61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7" name="Freeform 312"/>
              <p:cNvSpPr>
                <a:spLocks/>
              </p:cNvSpPr>
              <p:nvPr/>
            </p:nvSpPr>
            <p:spPr bwMode="auto">
              <a:xfrm>
                <a:off x="1360487" y="4573588"/>
                <a:ext cx="2152650" cy="1524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96"/>
                  </a:cxn>
                  <a:cxn ang="0">
                    <a:pos x="1356" y="96"/>
                  </a:cxn>
                </a:cxnLst>
                <a:rect l="0" t="0" r="r" b="b"/>
                <a:pathLst>
                  <a:path w="1356" h="96">
                    <a:moveTo>
                      <a:pt x="0" y="0"/>
                    </a:moveTo>
                    <a:lnTo>
                      <a:pt x="0" y="96"/>
                    </a:lnTo>
                    <a:lnTo>
                      <a:pt x="1356" y="9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8" name="Freeform 313"/>
              <p:cNvSpPr>
                <a:spLocks/>
              </p:cNvSpPr>
              <p:nvPr/>
            </p:nvSpPr>
            <p:spPr bwMode="auto">
              <a:xfrm>
                <a:off x="1081087" y="4568825"/>
                <a:ext cx="279400" cy="160338"/>
              </a:xfrm>
              <a:custGeom>
                <a:avLst/>
                <a:gdLst/>
                <a:ahLst/>
                <a:cxnLst>
                  <a:cxn ang="0">
                    <a:pos x="0" y="101"/>
                  </a:cxn>
                  <a:cxn ang="0">
                    <a:pos x="0" y="0"/>
                  </a:cxn>
                  <a:cxn ang="0">
                    <a:pos x="176" y="0"/>
                  </a:cxn>
                </a:cxnLst>
                <a:rect l="0" t="0" r="r" b="b"/>
                <a:pathLst>
                  <a:path w="176" h="101">
                    <a:moveTo>
                      <a:pt x="0" y="101"/>
                    </a:moveTo>
                    <a:lnTo>
                      <a:pt x="0" y="0"/>
                    </a:lnTo>
                    <a:lnTo>
                      <a:pt x="17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89" name="Rectangle 314"/>
              <p:cNvSpPr>
                <a:spLocks noChangeArrowheads="1"/>
              </p:cNvSpPr>
              <p:nvPr/>
            </p:nvSpPr>
            <p:spPr bwMode="auto">
              <a:xfrm>
                <a:off x="2566989" y="4815653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80</a:t>
                </a:r>
              </a:p>
            </p:txBody>
          </p:sp>
          <p:sp>
            <p:nvSpPr>
              <p:cNvPr id="490" name="Freeform 315"/>
              <p:cNvSpPr>
                <a:spLocks/>
              </p:cNvSpPr>
              <p:nvPr/>
            </p:nvSpPr>
            <p:spPr bwMode="auto">
              <a:xfrm>
                <a:off x="1081087" y="4738688"/>
                <a:ext cx="1481138" cy="1587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00"/>
                  </a:cxn>
                  <a:cxn ang="0">
                    <a:pos x="933" y="100"/>
                  </a:cxn>
                </a:cxnLst>
                <a:rect l="0" t="0" r="r" b="b"/>
                <a:pathLst>
                  <a:path w="933" h="100">
                    <a:moveTo>
                      <a:pt x="0" y="0"/>
                    </a:moveTo>
                    <a:lnTo>
                      <a:pt x="0" y="100"/>
                    </a:lnTo>
                    <a:lnTo>
                      <a:pt x="933" y="10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91" name="Freeform 316"/>
              <p:cNvSpPr>
                <a:spLocks/>
              </p:cNvSpPr>
              <p:nvPr/>
            </p:nvSpPr>
            <p:spPr bwMode="auto">
              <a:xfrm>
                <a:off x="817562" y="4733925"/>
                <a:ext cx="263525" cy="230188"/>
              </a:xfrm>
              <a:custGeom>
                <a:avLst/>
                <a:gdLst/>
                <a:ahLst/>
                <a:cxnLst>
                  <a:cxn ang="0">
                    <a:pos x="0" y="145"/>
                  </a:cxn>
                  <a:cxn ang="0">
                    <a:pos x="0" y="0"/>
                  </a:cxn>
                  <a:cxn ang="0">
                    <a:pos x="166" y="0"/>
                  </a:cxn>
                </a:cxnLst>
                <a:rect l="0" t="0" r="r" b="b"/>
                <a:pathLst>
                  <a:path w="166" h="145">
                    <a:moveTo>
                      <a:pt x="0" y="145"/>
                    </a:moveTo>
                    <a:lnTo>
                      <a:pt x="0" y="0"/>
                    </a:lnTo>
                    <a:lnTo>
                      <a:pt x="16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92" name="Rectangle 317"/>
              <p:cNvSpPr>
                <a:spLocks noChangeArrowheads="1"/>
              </p:cNvSpPr>
              <p:nvPr/>
            </p:nvSpPr>
            <p:spPr bwMode="auto">
              <a:xfrm>
                <a:off x="4814087" y="4915611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330</a:t>
                </a:r>
              </a:p>
            </p:txBody>
          </p:sp>
          <p:sp>
            <p:nvSpPr>
              <p:cNvPr id="493" name="Freeform 318"/>
              <p:cNvSpPr>
                <a:spLocks/>
              </p:cNvSpPr>
              <p:nvPr/>
            </p:nvSpPr>
            <p:spPr bwMode="auto">
              <a:xfrm>
                <a:off x="4165600" y="5011738"/>
                <a:ext cx="623888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393" y="0"/>
                  </a:cxn>
                </a:cxnLst>
                <a:rect l="0" t="0" r="r" b="b"/>
                <a:pathLst>
                  <a:path w="393" h="33">
                    <a:moveTo>
                      <a:pt x="0" y="33"/>
                    </a:moveTo>
                    <a:lnTo>
                      <a:pt x="0" y="0"/>
                    </a:lnTo>
                    <a:lnTo>
                      <a:pt x="39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94" name="Rectangle 319"/>
              <p:cNvSpPr>
                <a:spLocks noChangeArrowheads="1"/>
              </p:cNvSpPr>
              <p:nvPr/>
            </p:nvSpPr>
            <p:spPr bwMode="auto">
              <a:xfrm>
                <a:off x="4224592" y="5030157"/>
                <a:ext cx="1278014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190</a:t>
                </a:r>
              </a:p>
            </p:txBody>
          </p:sp>
          <p:sp>
            <p:nvSpPr>
              <p:cNvPr id="495" name="Freeform 320"/>
              <p:cNvSpPr>
                <a:spLocks/>
              </p:cNvSpPr>
              <p:nvPr/>
            </p:nvSpPr>
            <p:spPr bwMode="auto">
              <a:xfrm>
                <a:off x="4165600" y="5073650"/>
                <a:ext cx="9525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6" y="33"/>
                  </a:cxn>
                </a:cxnLst>
                <a:rect l="0" t="0" r="r" b="b"/>
                <a:pathLst>
                  <a:path w="6" h="33">
                    <a:moveTo>
                      <a:pt x="0" y="0"/>
                    </a:moveTo>
                    <a:lnTo>
                      <a:pt x="0" y="33"/>
                    </a:lnTo>
                    <a:lnTo>
                      <a:pt x="6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96" name="Freeform 321"/>
              <p:cNvSpPr>
                <a:spLocks/>
              </p:cNvSpPr>
              <p:nvPr/>
            </p:nvSpPr>
            <p:spPr bwMode="auto">
              <a:xfrm>
                <a:off x="1233487" y="5068888"/>
                <a:ext cx="2932113" cy="131763"/>
              </a:xfrm>
              <a:custGeom>
                <a:avLst/>
                <a:gdLst/>
                <a:ahLst/>
                <a:cxnLst>
                  <a:cxn ang="0">
                    <a:pos x="0" y="83"/>
                  </a:cxn>
                  <a:cxn ang="0">
                    <a:pos x="0" y="0"/>
                  </a:cxn>
                  <a:cxn ang="0">
                    <a:pos x="1847" y="0"/>
                  </a:cxn>
                </a:cxnLst>
                <a:rect l="0" t="0" r="r" b="b"/>
                <a:pathLst>
                  <a:path w="1847" h="83">
                    <a:moveTo>
                      <a:pt x="0" y="83"/>
                    </a:moveTo>
                    <a:lnTo>
                      <a:pt x="0" y="0"/>
                    </a:lnTo>
                    <a:lnTo>
                      <a:pt x="184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497" name="Rectangle 322"/>
              <p:cNvSpPr>
                <a:spLocks noChangeArrowheads="1"/>
              </p:cNvSpPr>
              <p:nvPr/>
            </p:nvSpPr>
            <p:spPr bwMode="auto">
              <a:xfrm>
                <a:off x="3465514" y="5154968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300</a:t>
                </a:r>
              </a:p>
            </p:txBody>
          </p:sp>
          <p:sp>
            <p:nvSpPr>
              <p:cNvPr id="501" name="Freeform 323"/>
              <p:cNvSpPr>
                <a:spLocks/>
              </p:cNvSpPr>
              <p:nvPr/>
            </p:nvSpPr>
            <p:spPr bwMode="auto">
              <a:xfrm>
                <a:off x="1470025" y="5240338"/>
                <a:ext cx="1990725" cy="95250"/>
              </a:xfrm>
              <a:custGeom>
                <a:avLst/>
                <a:gdLst/>
                <a:ahLst/>
                <a:cxnLst>
                  <a:cxn ang="0">
                    <a:pos x="0" y="60"/>
                  </a:cxn>
                  <a:cxn ang="0">
                    <a:pos x="0" y="0"/>
                  </a:cxn>
                  <a:cxn ang="0">
                    <a:pos x="1254" y="0"/>
                  </a:cxn>
                </a:cxnLst>
                <a:rect l="0" t="0" r="r" b="b"/>
                <a:pathLst>
                  <a:path w="1254" h="60">
                    <a:moveTo>
                      <a:pt x="0" y="60"/>
                    </a:moveTo>
                    <a:lnTo>
                      <a:pt x="0" y="0"/>
                    </a:lnTo>
                    <a:lnTo>
                      <a:pt x="125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02" name="Rectangle 324"/>
              <p:cNvSpPr>
                <a:spLocks noChangeArrowheads="1"/>
              </p:cNvSpPr>
              <p:nvPr/>
            </p:nvSpPr>
            <p:spPr bwMode="auto">
              <a:xfrm>
                <a:off x="4191000" y="5272854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60</a:t>
                </a:r>
              </a:p>
            </p:txBody>
          </p:sp>
          <p:sp>
            <p:nvSpPr>
              <p:cNvPr id="503" name="Freeform 325"/>
              <p:cNvSpPr>
                <a:spLocks/>
              </p:cNvSpPr>
              <p:nvPr/>
            </p:nvSpPr>
            <p:spPr bwMode="auto">
              <a:xfrm>
                <a:off x="1914525" y="5354638"/>
                <a:ext cx="2271713" cy="80963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1431" y="0"/>
                  </a:cxn>
                </a:cxnLst>
                <a:rect l="0" t="0" r="r" b="b"/>
                <a:pathLst>
                  <a:path w="1431" h="51">
                    <a:moveTo>
                      <a:pt x="0" y="51"/>
                    </a:moveTo>
                    <a:lnTo>
                      <a:pt x="0" y="0"/>
                    </a:lnTo>
                    <a:lnTo>
                      <a:pt x="143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04" name="Rectangle 326"/>
              <p:cNvSpPr>
                <a:spLocks noChangeArrowheads="1"/>
              </p:cNvSpPr>
              <p:nvPr/>
            </p:nvSpPr>
            <p:spPr bwMode="auto">
              <a:xfrm>
                <a:off x="5724486" y="5390739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90</a:t>
                </a:r>
              </a:p>
            </p:txBody>
          </p:sp>
          <p:sp>
            <p:nvSpPr>
              <p:cNvPr id="505" name="Freeform 327"/>
              <p:cNvSpPr>
                <a:spLocks/>
              </p:cNvSpPr>
              <p:nvPr/>
            </p:nvSpPr>
            <p:spPr bwMode="auto">
              <a:xfrm>
                <a:off x="3295651" y="5468938"/>
                <a:ext cx="2472965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1682" y="0"/>
                  </a:cxn>
                </a:cxnLst>
                <a:rect l="0" t="0" r="r" b="b"/>
                <a:pathLst>
                  <a:path w="1682" h="33">
                    <a:moveTo>
                      <a:pt x="0" y="33"/>
                    </a:moveTo>
                    <a:lnTo>
                      <a:pt x="0" y="0"/>
                    </a:lnTo>
                    <a:lnTo>
                      <a:pt x="168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06" name="Rectangle 328"/>
              <p:cNvSpPr>
                <a:spLocks noChangeArrowheads="1"/>
              </p:cNvSpPr>
              <p:nvPr/>
            </p:nvSpPr>
            <p:spPr bwMode="auto">
              <a:xfrm>
                <a:off x="4151313" y="5487110"/>
                <a:ext cx="1278014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210</a:t>
                </a:r>
              </a:p>
            </p:txBody>
          </p:sp>
          <p:sp>
            <p:nvSpPr>
              <p:cNvPr id="507" name="Freeform 329"/>
              <p:cNvSpPr>
                <a:spLocks/>
              </p:cNvSpPr>
              <p:nvPr/>
            </p:nvSpPr>
            <p:spPr bwMode="auto">
              <a:xfrm>
                <a:off x="3295650" y="5530850"/>
                <a:ext cx="850900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536" y="33"/>
                  </a:cxn>
                </a:cxnLst>
                <a:rect l="0" t="0" r="r" b="b"/>
                <a:pathLst>
                  <a:path w="536" h="33">
                    <a:moveTo>
                      <a:pt x="0" y="0"/>
                    </a:moveTo>
                    <a:lnTo>
                      <a:pt x="0" y="33"/>
                    </a:lnTo>
                    <a:lnTo>
                      <a:pt x="536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08" name="Freeform 330"/>
              <p:cNvSpPr>
                <a:spLocks/>
              </p:cNvSpPr>
              <p:nvPr/>
            </p:nvSpPr>
            <p:spPr bwMode="auto">
              <a:xfrm>
                <a:off x="1914525" y="5445125"/>
                <a:ext cx="1381125" cy="809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870" y="51"/>
                  </a:cxn>
                </a:cxnLst>
                <a:rect l="0" t="0" r="r" b="b"/>
                <a:pathLst>
                  <a:path w="870" h="51">
                    <a:moveTo>
                      <a:pt x="0" y="0"/>
                    </a:moveTo>
                    <a:lnTo>
                      <a:pt x="0" y="51"/>
                    </a:lnTo>
                    <a:lnTo>
                      <a:pt x="870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09" name="Freeform 331"/>
              <p:cNvSpPr>
                <a:spLocks/>
              </p:cNvSpPr>
              <p:nvPr/>
            </p:nvSpPr>
            <p:spPr bwMode="auto">
              <a:xfrm>
                <a:off x="1470025" y="5345113"/>
                <a:ext cx="444500" cy="952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0"/>
                  </a:cxn>
                  <a:cxn ang="0">
                    <a:pos x="280" y="60"/>
                  </a:cxn>
                </a:cxnLst>
                <a:rect l="0" t="0" r="r" b="b"/>
                <a:pathLst>
                  <a:path w="280" h="60">
                    <a:moveTo>
                      <a:pt x="0" y="0"/>
                    </a:moveTo>
                    <a:lnTo>
                      <a:pt x="0" y="60"/>
                    </a:lnTo>
                    <a:lnTo>
                      <a:pt x="280" y="6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10" name="Freeform 332"/>
              <p:cNvSpPr>
                <a:spLocks/>
              </p:cNvSpPr>
              <p:nvPr/>
            </p:nvSpPr>
            <p:spPr bwMode="auto">
              <a:xfrm>
                <a:off x="1233487" y="5210175"/>
                <a:ext cx="236538" cy="1301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2"/>
                  </a:cxn>
                  <a:cxn ang="0">
                    <a:pos x="149" y="82"/>
                  </a:cxn>
                </a:cxnLst>
                <a:rect l="0" t="0" r="r" b="b"/>
                <a:pathLst>
                  <a:path w="149" h="82">
                    <a:moveTo>
                      <a:pt x="0" y="0"/>
                    </a:moveTo>
                    <a:lnTo>
                      <a:pt x="0" y="82"/>
                    </a:lnTo>
                    <a:lnTo>
                      <a:pt x="149" y="8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11" name="Freeform 333"/>
              <p:cNvSpPr>
                <a:spLocks/>
              </p:cNvSpPr>
              <p:nvPr/>
            </p:nvSpPr>
            <p:spPr bwMode="auto">
              <a:xfrm>
                <a:off x="817562" y="4973638"/>
                <a:ext cx="415925" cy="2317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46"/>
                  </a:cxn>
                  <a:cxn ang="0">
                    <a:pos x="262" y="146"/>
                  </a:cxn>
                </a:cxnLst>
                <a:rect l="0" t="0" r="r" b="b"/>
                <a:pathLst>
                  <a:path w="262" h="146">
                    <a:moveTo>
                      <a:pt x="0" y="0"/>
                    </a:moveTo>
                    <a:lnTo>
                      <a:pt x="0" y="146"/>
                    </a:lnTo>
                    <a:lnTo>
                      <a:pt x="262" y="14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12" name="Freeform 334"/>
              <p:cNvSpPr>
                <a:spLocks/>
              </p:cNvSpPr>
              <p:nvPr/>
            </p:nvSpPr>
            <p:spPr bwMode="auto">
              <a:xfrm>
                <a:off x="808037" y="4968875"/>
                <a:ext cx="9525" cy="533400"/>
              </a:xfrm>
              <a:custGeom>
                <a:avLst/>
                <a:gdLst/>
                <a:ahLst/>
                <a:cxnLst>
                  <a:cxn ang="0">
                    <a:pos x="0" y="336"/>
                  </a:cxn>
                  <a:cxn ang="0">
                    <a:pos x="0" y="0"/>
                  </a:cxn>
                  <a:cxn ang="0">
                    <a:pos x="6" y="0"/>
                  </a:cxn>
                </a:cxnLst>
                <a:rect l="0" t="0" r="r" b="b"/>
                <a:pathLst>
                  <a:path w="6" h="336">
                    <a:moveTo>
                      <a:pt x="0" y="336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13" name="Rectangle 335"/>
              <p:cNvSpPr>
                <a:spLocks noChangeArrowheads="1"/>
              </p:cNvSpPr>
              <p:nvPr/>
            </p:nvSpPr>
            <p:spPr bwMode="auto">
              <a:xfrm>
                <a:off x="3613150" y="5612168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00</a:t>
                </a:r>
              </a:p>
            </p:txBody>
          </p:sp>
          <p:sp>
            <p:nvSpPr>
              <p:cNvPr id="514" name="Freeform 336"/>
              <p:cNvSpPr>
                <a:spLocks/>
              </p:cNvSpPr>
              <p:nvPr/>
            </p:nvSpPr>
            <p:spPr bwMode="auto">
              <a:xfrm>
                <a:off x="2638425" y="5697538"/>
                <a:ext cx="969963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611" y="0"/>
                  </a:cxn>
                </a:cxnLst>
                <a:rect l="0" t="0" r="r" b="b"/>
                <a:pathLst>
                  <a:path w="611" h="33">
                    <a:moveTo>
                      <a:pt x="0" y="33"/>
                    </a:moveTo>
                    <a:lnTo>
                      <a:pt x="0" y="0"/>
                    </a:lnTo>
                    <a:lnTo>
                      <a:pt x="61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15" name="Rectangle 337"/>
              <p:cNvSpPr>
                <a:spLocks noChangeArrowheads="1"/>
              </p:cNvSpPr>
              <p:nvPr/>
            </p:nvSpPr>
            <p:spPr bwMode="auto">
              <a:xfrm>
                <a:off x="3813175" y="5726469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160</a:t>
                </a:r>
              </a:p>
            </p:txBody>
          </p:sp>
          <p:sp>
            <p:nvSpPr>
              <p:cNvPr id="516" name="Freeform 338"/>
              <p:cNvSpPr>
                <a:spLocks/>
              </p:cNvSpPr>
              <p:nvPr/>
            </p:nvSpPr>
            <p:spPr bwMode="auto">
              <a:xfrm>
                <a:off x="2638425" y="5759450"/>
                <a:ext cx="1169988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737" y="33"/>
                  </a:cxn>
                </a:cxnLst>
                <a:rect l="0" t="0" r="r" b="b"/>
                <a:pathLst>
                  <a:path w="737" h="33">
                    <a:moveTo>
                      <a:pt x="0" y="0"/>
                    </a:moveTo>
                    <a:lnTo>
                      <a:pt x="0" y="33"/>
                    </a:lnTo>
                    <a:lnTo>
                      <a:pt x="737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17" name="Freeform 339"/>
              <p:cNvSpPr>
                <a:spLocks/>
              </p:cNvSpPr>
              <p:nvPr/>
            </p:nvSpPr>
            <p:spPr bwMode="auto">
              <a:xfrm>
                <a:off x="1028700" y="5754688"/>
                <a:ext cx="1609725" cy="80963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1014" y="0"/>
                  </a:cxn>
                </a:cxnLst>
                <a:rect l="0" t="0" r="r" b="b"/>
                <a:pathLst>
                  <a:path w="1014" h="51">
                    <a:moveTo>
                      <a:pt x="0" y="51"/>
                    </a:moveTo>
                    <a:lnTo>
                      <a:pt x="0" y="0"/>
                    </a:lnTo>
                    <a:lnTo>
                      <a:pt x="101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18" name="Rectangle 340"/>
              <p:cNvSpPr>
                <a:spLocks noChangeArrowheads="1"/>
              </p:cNvSpPr>
              <p:nvPr/>
            </p:nvSpPr>
            <p:spPr bwMode="auto">
              <a:xfrm>
                <a:off x="3467100" y="5844354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190</a:t>
                </a:r>
              </a:p>
            </p:txBody>
          </p:sp>
          <p:sp>
            <p:nvSpPr>
              <p:cNvPr id="519" name="Freeform 341"/>
              <p:cNvSpPr>
                <a:spLocks/>
              </p:cNvSpPr>
              <p:nvPr/>
            </p:nvSpPr>
            <p:spPr bwMode="auto">
              <a:xfrm>
                <a:off x="1028700" y="5845175"/>
                <a:ext cx="2433638" cy="809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1533" y="51"/>
                  </a:cxn>
                </a:cxnLst>
                <a:rect l="0" t="0" r="r" b="b"/>
                <a:pathLst>
                  <a:path w="1533" h="51">
                    <a:moveTo>
                      <a:pt x="0" y="0"/>
                    </a:moveTo>
                    <a:lnTo>
                      <a:pt x="0" y="51"/>
                    </a:lnTo>
                    <a:lnTo>
                      <a:pt x="1533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20" name="Freeform 342"/>
              <p:cNvSpPr>
                <a:spLocks/>
              </p:cNvSpPr>
              <p:nvPr/>
            </p:nvSpPr>
            <p:spPr bwMode="auto">
              <a:xfrm>
                <a:off x="817562" y="5840413"/>
                <a:ext cx="211138" cy="203200"/>
              </a:xfrm>
              <a:custGeom>
                <a:avLst/>
                <a:gdLst/>
                <a:ahLst/>
                <a:cxnLst>
                  <a:cxn ang="0">
                    <a:pos x="0" y="128"/>
                  </a:cxn>
                  <a:cxn ang="0">
                    <a:pos x="0" y="0"/>
                  </a:cxn>
                  <a:cxn ang="0">
                    <a:pos x="133" y="0"/>
                  </a:cxn>
                </a:cxnLst>
                <a:rect l="0" t="0" r="r" b="b"/>
                <a:pathLst>
                  <a:path w="133" h="128">
                    <a:moveTo>
                      <a:pt x="0" y="128"/>
                    </a:moveTo>
                    <a:lnTo>
                      <a:pt x="0" y="0"/>
                    </a:lnTo>
                    <a:lnTo>
                      <a:pt x="13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21" name="Rectangle 343"/>
              <p:cNvSpPr>
                <a:spLocks noChangeArrowheads="1"/>
              </p:cNvSpPr>
              <p:nvPr/>
            </p:nvSpPr>
            <p:spPr bwMode="auto">
              <a:xfrm>
                <a:off x="3895726" y="5962239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380</a:t>
                </a:r>
              </a:p>
            </p:txBody>
          </p:sp>
          <p:sp>
            <p:nvSpPr>
              <p:cNvPr id="522" name="Freeform 344"/>
              <p:cNvSpPr>
                <a:spLocks/>
              </p:cNvSpPr>
              <p:nvPr/>
            </p:nvSpPr>
            <p:spPr bwMode="auto">
              <a:xfrm>
                <a:off x="3881438" y="6040438"/>
                <a:ext cx="9525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6" y="0"/>
                  </a:cxn>
                </a:cxnLst>
                <a:rect l="0" t="0" r="r" b="b"/>
                <a:pathLst>
                  <a:path w="6" h="33">
                    <a:moveTo>
                      <a:pt x="0" y="33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23" name="Rectangle 345"/>
              <p:cNvSpPr>
                <a:spLocks noChangeArrowheads="1"/>
              </p:cNvSpPr>
              <p:nvPr/>
            </p:nvSpPr>
            <p:spPr bwMode="auto">
              <a:xfrm>
                <a:off x="3984625" y="6083712"/>
                <a:ext cx="1278014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240</a:t>
                </a:r>
              </a:p>
            </p:txBody>
          </p:sp>
          <p:sp>
            <p:nvSpPr>
              <p:cNvPr id="524" name="Freeform 346"/>
              <p:cNvSpPr>
                <a:spLocks/>
              </p:cNvSpPr>
              <p:nvPr/>
            </p:nvSpPr>
            <p:spPr bwMode="auto">
              <a:xfrm>
                <a:off x="3881438" y="6102350"/>
                <a:ext cx="98425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62" y="33"/>
                  </a:cxn>
                </a:cxnLst>
                <a:rect l="0" t="0" r="r" b="b"/>
                <a:pathLst>
                  <a:path w="62" h="33">
                    <a:moveTo>
                      <a:pt x="0" y="0"/>
                    </a:moveTo>
                    <a:lnTo>
                      <a:pt x="0" y="33"/>
                    </a:lnTo>
                    <a:lnTo>
                      <a:pt x="62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25" name="Freeform 347"/>
              <p:cNvSpPr>
                <a:spLocks/>
              </p:cNvSpPr>
              <p:nvPr/>
            </p:nvSpPr>
            <p:spPr bwMode="auto">
              <a:xfrm>
                <a:off x="1117600" y="6097588"/>
                <a:ext cx="2763838" cy="152400"/>
              </a:xfrm>
              <a:custGeom>
                <a:avLst/>
                <a:gdLst/>
                <a:ahLst/>
                <a:cxnLst>
                  <a:cxn ang="0">
                    <a:pos x="0" y="96"/>
                  </a:cxn>
                  <a:cxn ang="0">
                    <a:pos x="0" y="0"/>
                  </a:cxn>
                  <a:cxn ang="0">
                    <a:pos x="1741" y="0"/>
                  </a:cxn>
                </a:cxnLst>
                <a:rect l="0" t="0" r="r" b="b"/>
                <a:pathLst>
                  <a:path w="1741" h="96">
                    <a:moveTo>
                      <a:pt x="0" y="96"/>
                    </a:moveTo>
                    <a:lnTo>
                      <a:pt x="0" y="0"/>
                    </a:lnTo>
                    <a:lnTo>
                      <a:pt x="174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26" name="Rectangle 348"/>
              <p:cNvSpPr>
                <a:spLocks noChangeArrowheads="1"/>
              </p:cNvSpPr>
              <p:nvPr/>
            </p:nvSpPr>
            <p:spPr bwMode="auto">
              <a:xfrm>
                <a:off x="3576637" y="6205184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180</a:t>
                </a:r>
              </a:p>
            </p:txBody>
          </p:sp>
          <p:sp>
            <p:nvSpPr>
              <p:cNvPr id="527" name="Freeform 349"/>
              <p:cNvSpPr>
                <a:spLocks/>
              </p:cNvSpPr>
              <p:nvPr/>
            </p:nvSpPr>
            <p:spPr bwMode="auto">
              <a:xfrm>
                <a:off x="1574800" y="6269038"/>
                <a:ext cx="1997075" cy="138113"/>
              </a:xfrm>
              <a:custGeom>
                <a:avLst/>
                <a:gdLst/>
                <a:ahLst/>
                <a:cxnLst>
                  <a:cxn ang="0">
                    <a:pos x="0" y="87"/>
                  </a:cxn>
                  <a:cxn ang="0">
                    <a:pos x="0" y="0"/>
                  </a:cxn>
                  <a:cxn ang="0">
                    <a:pos x="1258" y="0"/>
                  </a:cxn>
                </a:cxnLst>
                <a:rect l="0" t="0" r="r" b="b"/>
                <a:pathLst>
                  <a:path w="1258" h="87">
                    <a:moveTo>
                      <a:pt x="0" y="87"/>
                    </a:moveTo>
                    <a:lnTo>
                      <a:pt x="0" y="0"/>
                    </a:lnTo>
                    <a:lnTo>
                      <a:pt x="125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28" name="Rectangle 350"/>
              <p:cNvSpPr>
                <a:spLocks noChangeArrowheads="1"/>
              </p:cNvSpPr>
              <p:nvPr/>
            </p:nvSpPr>
            <p:spPr bwMode="auto">
              <a:xfrm>
                <a:off x="4405575" y="6312311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310</a:t>
                </a:r>
              </a:p>
            </p:txBody>
          </p:sp>
          <p:sp>
            <p:nvSpPr>
              <p:cNvPr id="529" name="Freeform 351"/>
              <p:cNvSpPr>
                <a:spLocks/>
              </p:cNvSpPr>
              <p:nvPr/>
            </p:nvSpPr>
            <p:spPr bwMode="auto">
              <a:xfrm>
                <a:off x="2146300" y="6383338"/>
                <a:ext cx="2247900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1416" y="0"/>
                  </a:cxn>
                </a:cxnLst>
                <a:rect l="0" t="0" r="r" b="b"/>
                <a:pathLst>
                  <a:path w="1416" h="33">
                    <a:moveTo>
                      <a:pt x="0" y="33"/>
                    </a:moveTo>
                    <a:lnTo>
                      <a:pt x="0" y="0"/>
                    </a:lnTo>
                    <a:lnTo>
                      <a:pt x="141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0" name="Rectangle 352"/>
              <p:cNvSpPr>
                <a:spLocks noChangeArrowheads="1"/>
              </p:cNvSpPr>
              <p:nvPr/>
            </p:nvSpPr>
            <p:spPr bwMode="auto">
              <a:xfrm>
                <a:off x="3702312" y="6430198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40</a:t>
                </a:r>
              </a:p>
            </p:txBody>
          </p:sp>
          <p:sp>
            <p:nvSpPr>
              <p:cNvPr id="531" name="Freeform 353"/>
              <p:cNvSpPr>
                <a:spLocks/>
              </p:cNvSpPr>
              <p:nvPr/>
            </p:nvSpPr>
            <p:spPr bwMode="auto">
              <a:xfrm>
                <a:off x="2146300" y="6445250"/>
                <a:ext cx="1544638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973" y="33"/>
                  </a:cxn>
                </a:cxnLst>
                <a:rect l="0" t="0" r="r" b="b"/>
                <a:pathLst>
                  <a:path w="973" h="33">
                    <a:moveTo>
                      <a:pt x="0" y="0"/>
                    </a:moveTo>
                    <a:lnTo>
                      <a:pt x="0" y="33"/>
                    </a:lnTo>
                    <a:lnTo>
                      <a:pt x="973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2" name="Freeform 354"/>
              <p:cNvSpPr>
                <a:spLocks/>
              </p:cNvSpPr>
              <p:nvPr/>
            </p:nvSpPr>
            <p:spPr bwMode="auto">
              <a:xfrm>
                <a:off x="1785937" y="6440488"/>
                <a:ext cx="360363" cy="109538"/>
              </a:xfrm>
              <a:custGeom>
                <a:avLst/>
                <a:gdLst/>
                <a:ahLst/>
                <a:cxnLst>
                  <a:cxn ang="0">
                    <a:pos x="0" y="69"/>
                  </a:cxn>
                  <a:cxn ang="0">
                    <a:pos x="0" y="0"/>
                  </a:cxn>
                  <a:cxn ang="0">
                    <a:pos x="227" y="0"/>
                  </a:cxn>
                </a:cxnLst>
                <a:rect l="0" t="0" r="r" b="b"/>
                <a:pathLst>
                  <a:path w="227" h="69">
                    <a:moveTo>
                      <a:pt x="0" y="69"/>
                    </a:moveTo>
                    <a:lnTo>
                      <a:pt x="0" y="0"/>
                    </a:lnTo>
                    <a:lnTo>
                      <a:pt x="22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3" name="Rectangle 355"/>
              <p:cNvSpPr>
                <a:spLocks noChangeArrowheads="1"/>
              </p:cNvSpPr>
              <p:nvPr/>
            </p:nvSpPr>
            <p:spPr bwMode="auto">
              <a:xfrm>
                <a:off x="4140722" y="6548083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320</a:t>
                </a:r>
              </a:p>
            </p:txBody>
          </p:sp>
          <p:sp>
            <p:nvSpPr>
              <p:cNvPr id="534" name="Freeform 356"/>
              <p:cNvSpPr>
                <a:spLocks/>
              </p:cNvSpPr>
              <p:nvPr/>
            </p:nvSpPr>
            <p:spPr bwMode="auto">
              <a:xfrm>
                <a:off x="4113213" y="6611938"/>
                <a:ext cx="9525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6" y="0"/>
                  </a:cxn>
                </a:cxnLst>
                <a:rect l="0" t="0" r="r" b="b"/>
                <a:pathLst>
                  <a:path w="6" h="33">
                    <a:moveTo>
                      <a:pt x="0" y="33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5" name="Rectangle 357"/>
              <p:cNvSpPr>
                <a:spLocks noChangeArrowheads="1"/>
              </p:cNvSpPr>
              <p:nvPr/>
            </p:nvSpPr>
            <p:spPr bwMode="auto">
              <a:xfrm>
                <a:off x="4147334" y="6665970"/>
                <a:ext cx="1278014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180</a:t>
                </a:r>
              </a:p>
            </p:txBody>
          </p:sp>
          <p:sp>
            <p:nvSpPr>
              <p:cNvPr id="536" name="Freeform 358"/>
              <p:cNvSpPr>
                <a:spLocks/>
              </p:cNvSpPr>
              <p:nvPr/>
            </p:nvSpPr>
            <p:spPr bwMode="auto">
              <a:xfrm>
                <a:off x="4113213" y="6673850"/>
                <a:ext cx="9525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6" y="33"/>
                  </a:cxn>
                </a:cxnLst>
                <a:rect l="0" t="0" r="r" b="b"/>
                <a:pathLst>
                  <a:path w="6" h="33">
                    <a:moveTo>
                      <a:pt x="0" y="0"/>
                    </a:moveTo>
                    <a:lnTo>
                      <a:pt x="0" y="33"/>
                    </a:lnTo>
                    <a:lnTo>
                      <a:pt x="6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7" name="Freeform 359"/>
              <p:cNvSpPr>
                <a:spLocks/>
              </p:cNvSpPr>
              <p:nvPr/>
            </p:nvSpPr>
            <p:spPr bwMode="auto">
              <a:xfrm>
                <a:off x="1785937" y="6559550"/>
                <a:ext cx="2327275" cy="10953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9"/>
                  </a:cxn>
                  <a:cxn ang="0">
                    <a:pos x="1466" y="69"/>
                  </a:cxn>
                </a:cxnLst>
                <a:rect l="0" t="0" r="r" b="b"/>
                <a:pathLst>
                  <a:path w="1466" h="69">
                    <a:moveTo>
                      <a:pt x="0" y="0"/>
                    </a:moveTo>
                    <a:lnTo>
                      <a:pt x="0" y="69"/>
                    </a:lnTo>
                    <a:lnTo>
                      <a:pt x="1466" y="6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8" name="Freeform 360"/>
              <p:cNvSpPr>
                <a:spLocks/>
              </p:cNvSpPr>
              <p:nvPr/>
            </p:nvSpPr>
            <p:spPr bwMode="auto">
              <a:xfrm>
                <a:off x="1574800" y="6416675"/>
                <a:ext cx="211138" cy="1381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7"/>
                  </a:cxn>
                  <a:cxn ang="0">
                    <a:pos x="133" y="87"/>
                  </a:cxn>
                </a:cxnLst>
                <a:rect l="0" t="0" r="r" b="b"/>
                <a:pathLst>
                  <a:path w="133" h="87">
                    <a:moveTo>
                      <a:pt x="0" y="0"/>
                    </a:moveTo>
                    <a:lnTo>
                      <a:pt x="0" y="87"/>
                    </a:lnTo>
                    <a:lnTo>
                      <a:pt x="133" y="8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39" name="Freeform 361"/>
              <p:cNvSpPr>
                <a:spLocks/>
              </p:cNvSpPr>
              <p:nvPr/>
            </p:nvSpPr>
            <p:spPr bwMode="auto">
              <a:xfrm>
                <a:off x="1117600" y="6259513"/>
                <a:ext cx="457200" cy="1524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96"/>
                  </a:cxn>
                  <a:cxn ang="0">
                    <a:pos x="288" y="96"/>
                  </a:cxn>
                </a:cxnLst>
                <a:rect l="0" t="0" r="r" b="b"/>
                <a:pathLst>
                  <a:path w="288" h="96">
                    <a:moveTo>
                      <a:pt x="0" y="0"/>
                    </a:moveTo>
                    <a:lnTo>
                      <a:pt x="0" y="96"/>
                    </a:lnTo>
                    <a:lnTo>
                      <a:pt x="288" y="96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0" name="Freeform 362"/>
              <p:cNvSpPr>
                <a:spLocks/>
              </p:cNvSpPr>
              <p:nvPr/>
            </p:nvSpPr>
            <p:spPr bwMode="auto">
              <a:xfrm>
                <a:off x="817562" y="6053138"/>
                <a:ext cx="300038" cy="20161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27"/>
                  </a:cxn>
                  <a:cxn ang="0">
                    <a:pos x="189" y="127"/>
                  </a:cxn>
                </a:cxnLst>
                <a:rect l="0" t="0" r="r" b="b"/>
                <a:pathLst>
                  <a:path w="189" h="127">
                    <a:moveTo>
                      <a:pt x="0" y="0"/>
                    </a:moveTo>
                    <a:lnTo>
                      <a:pt x="0" y="127"/>
                    </a:lnTo>
                    <a:lnTo>
                      <a:pt x="189" y="127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1" name="Freeform 363"/>
              <p:cNvSpPr>
                <a:spLocks/>
              </p:cNvSpPr>
              <p:nvPr/>
            </p:nvSpPr>
            <p:spPr bwMode="auto">
              <a:xfrm>
                <a:off x="808037" y="5511800"/>
                <a:ext cx="9525" cy="5365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8"/>
                  </a:cxn>
                  <a:cxn ang="0">
                    <a:pos x="6" y="338"/>
                  </a:cxn>
                </a:cxnLst>
                <a:rect l="0" t="0" r="r" b="b"/>
                <a:pathLst>
                  <a:path w="6" h="338">
                    <a:moveTo>
                      <a:pt x="0" y="0"/>
                    </a:moveTo>
                    <a:lnTo>
                      <a:pt x="0" y="338"/>
                    </a:lnTo>
                    <a:lnTo>
                      <a:pt x="6" y="33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2" name="Freeform 364"/>
              <p:cNvSpPr>
                <a:spLocks/>
              </p:cNvSpPr>
              <p:nvPr/>
            </p:nvSpPr>
            <p:spPr bwMode="auto">
              <a:xfrm>
                <a:off x="709612" y="5507038"/>
                <a:ext cx="98425" cy="714375"/>
              </a:xfrm>
              <a:custGeom>
                <a:avLst/>
                <a:gdLst/>
                <a:ahLst/>
                <a:cxnLst>
                  <a:cxn ang="0">
                    <a:pos x="0" y="450"/>
                  </a:cxn>
                  <a:cxn ang="0">
                    <a:pos x="0" y="0"/>
                  </a:cxn>
                  <a:cxn ang="0">
                    <a:pos x="62" y="0"/>
                  </a:cxn>
                </a:cxnLst>
                <a:rect l="0" t="0" r="r" b="b"/>
                <a:pathLst>
                  <a:path w="62" h="450">
                    <a:moveTo>
                      <a:pt x="0" y="450"/>
                    </a:moveTo>
                    <a:lnTo>
                      <a:pt x="0" y="0"/>
                    </a:lnTo>
                    <a:lnTo>
                      <a:pt x="6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3" name="Rectangle 365"/>
              <p:cNvSpPr>
                <a:spLocks noChangeArrowheads="1"/>
              </p:cNvSpPr>
              <p:nvPr/>
            </p:nvSpPr>
            <p:spPr bwMode="auto">
              <a:xfrm>
                <a:off x="1914525" y="6765926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400</a:t>
                </a:r>
              </a:p>
            </p:txBody>
          </p:sp>
          <p:sp>
            <p:nvSpPr>
              <p:cNvPr id="544" name="Freeform 366"/>
              <p:cNvSpPr>
                <a:spLocks/>
              </p:cNvSpPr>
              <p:nvPr/>
            </p:nvSpPr>
            <p:spPr bwMode="auto">
              <a:xfrm>
                <a:off x="938212" y="6840538"/>
                <a:ext cx="971550" cy="103188"/>
              </a:xfrm>
              <a:custGeom>
                <a:avLst/>
                <a:gdLst/>
                <a:ahLst/>
                <a:cxnLst>
                  <a:cxn ang="0">
                    <a:pos x="0" y="65"/>
                  </a:cxn>
                  <a:cxn ang="0">
                    <a:pos x="0" y="0"/>
                  </a:cxn>
                  <a:cxn ang="0">
                    <a:pos x="612" y="0"/>
                  </a:cxn>
                </a:cxnLst>
                <a:rect l="0" t="0" r="r" b="b"/>
                <a:pathLst>
                  <a:path w="612" h="65">
                    <a:moveTo>
                      <a:pt x="0" y="65"/>
                    </a:moveTo>
                    <a:lnTo>
                      <a:pt x="0" y="0"/>
                    </a:lnTo>
                    <a:lnTo>
                      <a:pt x="61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5" name="Rectangle 367"/>
              <p:cNvSpPr>
                <a:spLocks noChangeArrowheads="1"/>
              </p:cNvSpPr>
              <p:nvPr/>
            </p:nvSpPr>
            <p:spPr bwMode="auto">
              <a:xfrm>
                <a:off x="4127499" y="6880226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410</a:t>
                </a:r>
              </a:p>
            </p:txBody>
          </p:sp>
          <p:sp>
            <p:nvSpPr>
              <p:cNvPr id="546" name="Freeform 368"/>
              <p:cNvSpPr>
                <a:spLocks/>
              </p:cNvSpPr>
              <p:nvPr/>
            </p:nvSpPr>
            <p:spPr bwMode="auto">
              <a:xfrm>
                <a:off x="1128712" y="6954838"/>
                <a:ext cx="2994025" cy="95250"/>
              </a:xfrm>
              <a:custGeom>
                <a:avLst/>
                <a:gdLst/>
                <a:ahLst/>
                <a:cxnLst>
                  <a:cxn ang="0">
                    <a:pos x="0" y="60"/>
                  </a:cxn>
                  <a:cxn ang="0">
                    <a:pos x="0" y="0"/>
                  </a:cxn>
                  <a:cxn ang="0">
                    <a:pos x="1886" y="0"/>
                  </a:cxn>
                </a:cxnLst>
                <a:rect l="0" t="0" r="r" b="b"/>
                <a:pathLst>
                  <a:path w="1886" h="60">
                    <a:moveTo>
                      <a:pt x="0" y="60"/>
                    </a:moveTo>
                    <a:lnTo>
                      <a:pt x="0" y="0"/>
                    </a:lnTo>
                    <a:lnTo>
                      <a:pt x="188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7" name="Rectangle 369"/>
              <p:cNvSpPr>
                <a:spLocks noChangeArrowheads="1"/>
              </p:cNvSpPr>
              <p:nvPr/>
            </p:nvSpPr>
            <p:spPr bwMode="auto">
              <a:xfrm>
                <a:off x="3833814" y="6994526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430</a:t>
                </a:r>
              </a:p>
            </p:txBody>
          </p:sp>
          <p:sp>
            <p:nvSpPr>
              <p:cNvPr id="548" name="Freeform 370"/>
              <p:cNvSpPr>
                <a:spLocks/>
              </p:cNvSpPr>
              <p:nvPr/>
            </p:nvSpPr>
            <p:spPr bwMode="auto">
              <a:xfrm>
                <a:off x="1819275" y="7069138"/>
                <a:ext cx="2009775" cy="80963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1266" y="0"/>
                  </a:cxn>
                </a:cxnLst>
                <a:rect l="0" t="0" r="r" b="b"/>
                <a:pathLst>
                  <a:path w="1266" h="51">
                    <a:moveTo>
                      <a:pt x="0" y="51"/>
                    </a:moveTo>
                    <a:lnTo>
                      <a:pt x="0" y="0"/>
                    </a:lnTo>
                    <a:lnTo>
                      <a:pt x="126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49" name="Rectangle 371"/>
              <p:cNvSpPr>
                <a:spLocks noChangeArrowheads="1"/>
              </p:cNvSpPr>
              <p:nvPr/>
            </p:nvSpPr>
            <p:spPr bwMode="auto">
              <a:xfrm>
                <a:off x="2433637" y="7108826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420</a:t>
                </a:r>
              </a:p>
            </p:txBody>
          </p:sp>
          <p:sp>
            <p:nvSpPr>
              <p:cNvPr id="550" name="Freeform 372"/>
              <p:cNvSpPr>
                <a:spLocks/>
              </p:cNvSpPr>
              <p:nvPr/>
            </p:nvSpPr>
            <p:spPr bwMode="auto">
              <a:xfrm>
                <a:off x="2233612" y="7183438"/>
                <a:ext cx="195263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123" y="0"/>
                  </a:cxn>
                </a:cxnLst>
                <a:rect l="0" t="0" r="r" b="b"/>
                <a:pathLst>
                  <a:path w="123" h="33">
                    <a:moveTo>
                      <a:pt x="0" y="33"/>
                    </a:moveTo>
                    <a:lnTo>
                      <a:pt x="0" y="0"/>
                    </a:lnTo>
                    <a:lnTo>
                      <a:pt x="12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1" name="Rectangle 373"/>
              <p:cNvSpPr>
                <a:spLocks noChangeArrowheads="1"/>
              </p:cNvSpPr>
              <p:nvPr/>
            </p:nvSpPr>
            <p:spPr bwMode="auto">
              <a:xfrm>
                <a:off x="2447925" y="7223126"/>
                <a:ext cx="1278013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260</a:t>
                </a:r>
              </a:p>
            </p:txBody>
          </p:sp>
          <p:sp>
            <p:nvSpPr>
              <p:cNvPr id="552" name="Freeform 374"/>
              <p:cNvSpPr>
                <a:spLocks/>
              </p:cNvSpPr>
              <p:nvPr/>
            </p:nvSpPr>
            <p:spPr bwMode="auto">
              <a:xfrm>
                <a:off x="2233612" y="7245350"/>
                <a:ext cx="209550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132" y="33"/>
                  </a:cxn>
                </a:cxnLst>
                <a:rect l="0" t="0" r="r" b="b"/>
                <a:pathLst>
                  <a:path w="132" h="33">
                    <a:moveTo>
                      <a:pt x="0" y="0"/>
                    </a:moveTo>
                    <a:lnTo>
                      <a:pt x="0" y="33"/>
                    </a:lnTo>
                    <a:lnTo>
                      <a:pt x="132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3" name="Freeform 375"/>
              <p:cNvSpPr>
                <a:spLocks/>
              </p:cNvSpPr>
              <p:nvPr/>
            </p:nvSpPr>
            <p:spPr bwMode="auto">
              <a:xfrm>
                <a:off x="1819275" y="7159625"/>
                <a:ext cx="414338" cy="809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261" y="51"/>
                  </a:cxn>
                </a:cxnLst>
                <a:rect l="0" t="0" r="r" b="b"/>
                <a:pathLst>
                  <a:path w="261" h="51">
                    <a:moveTo>
                      <a:pt x="0" y="0"/>
                    </a:moveTo>
                    <a:lnTo>
                      <a:pt x="0" y="51"/>
                    </a:lnTo>
                    <a:lnTo>
                      <a:pt x="261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4" name="Freeform 376"/>
              <p:cNvSpPr>
                <a:spLocks/>
              </p:cNvSpPr>
              <p:nvPr/>
            </p:nvSpPr>
            <p:spPr bwMode="auto">
              <a:xfrm>
                <a:off x="1128712" y="7059613"/>
                <a:ext cx="690563" cy="952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0"/>
                  </a:cxn>
                  <a:cxn ang="0">
                    <a:pos x="435" y="60"/>
                  </a:cxn>
                </a:cxnLst>
                <a:rect l="0" t="0" r="r" b="b"/>
                <a:pathLst>
                  <a:path w="435" h="60">
                    <a:moveTo>
                      <a:pt x="0" y="0"/>
                    </a:moveTo>
                    <a:lnTo>
                      <a:pt x="0" y="60"/>
                    </a:lnTo>
                    <a:lnTo>
                      <a:pt x="435" y="6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5" name="Freeform 377"/>
              <p:cNvSpPr>
                <a:spLocks/>
              </p:cNvSpPr>
              <p:nvPr/>
            </p:nvSpPr>
            <p:spPr bwMode="auto">
              <a:xfrm>
                <a:off x="938212" y="6953250"/>
                <a:ext cx="190500" cy="1016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4"/>
                  </a:cxn>
                  <a:cxn ang="0">
                    <a:pos x="120" y="64"/>
                  </a:cxn>
                </a:cxnLst>
                <a:rect l="0" t="0" r="r" b="b"/>
                <a:pathLst>
                  <a:path w="120" h="64">
                    <a:moveTo>
                      <a:pt x="0" y="0"/>
                    </a:moveTo>
                    <a:lnTo>
                      <a:pt x="0" y="64"/>
                    </a:lnTo>
                    <a:lnTo>
                      <a:pt x="120" y="64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6" name="Freeform 378"/>
              <p:cNvSpPr>
                <a:spLocks/>
              </p:cNvSpPr>
              <p:nvPr/>
            </p:nvSpPr>
            <p:spPr bwMode="auto">
              <a:xfrm>
                <a:off x="709612" y="6230938"/>
                <a:ext cx="228600" cy="7175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52"/>
                  </a:cxn>
                  <a:cxn ang="0">
                    <a:pos x="144" y="452"/>
                  </a:cxn>
                </a:cxnLst>
                <a:rect l="0" t="0" r="r" b="b"/>
                <a:pathLst>
                  <a:path w="144" h="452">
                    <a:moveTo>
                      <a:pt x="0" y="0"/>
                    </a:moveTo>
                    <a:lnTo>
                      <a:pt x="0" y="452"/>
                    </a:lnTo>
                    <a:lnTo>
                      <a:pt x="144" y="45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7" name="Freeform 379"/>
              <p:cNvSpPr>
                <a:spLocks/>
              </p:cNvSpPr>
              <p:nvPr/>
            </p:nvSpPr>
            <p:spPr bwMode="auto">
              <a:xfrm>
                <a:off x="700087" y="6226175"/>
                <a:ext cx="9525" cy="684213"/>
              </a:xfrm>
              <a:custGeom>
                <a:avLst/>
                <a:gdLst/>
                <a:ahLst/>
                <a:cxnLst>
                  <a:cxn ang="0">
                    <a:pos x="0" y="431"/>
                  </a:cxn>
                  <a:cxn ang="0">
                    <a:pos x="0" y="0"/>
                  </a:cxn>
                  <a:cxn ang="0">
                    <a:pos x="6" y="0"/>
                  </a:cxn>
                </a:cxnLst>
                <a:rect l="0" t="0" r="r" b="b"/>
                <a:pathLst>
                  <a:path w="6" h="431">
                    <a:moveTo>
                      <a:pt x="0" y="431"/>
                    </a:moveTo>
                    <a:lnTo>
                      <a:pt x="0" y="0"/>
                    </a:lnTo>
                    <a:lnTo>
                      <a:pt x="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58" name="Rectangle 380"/>
              <p:cNvSpPr>
                <a:spLocks noChangeArrowheads="1"/>
              </p:cNvSpPr>
              <p:nvPr/>
            </p:nvSpPr>
            <p:spPr bwMode="auto">
              <a:xfrm>
                <a:off x="4014788" y="7337426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350</a:t>
                </a:r>
              </a:p>
            </p:txBody>
          </p:sp>
          <p:sp>
            <p:nvSpPr>
              <p:cNvPr id="559" name="Freeform 381"/>
              <p:cNvSpPr>
                <a:spLocks/>
              </p:cNvSpPr>
              <p:nvPr/>
            </p:nvSpPr>
            <p:spPr bwMode="auto">
              <a:xfrm>
                <a:off x="1489075" y="7412038"/>
                <a:ext cx="2520950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1588" y="0"/>
                  </a:cxn>
                </a:cxnLst>
                <a:rect l="0" t="0" r="r" b="b"/>
                <a:pathLst>
                  <a:path w="1588" h="33">
                    <a:moveTo>
                      <a:pt x="0" y="33"/>
                    </a:moveTo>
                    <a:lnTo>
                      <a:pt x="0" y="0"/>
                    </a:lnTo>
                    <a:lnTo>
                      <a:pt x="1588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0" name="Rectangle 382"/>
              <p:cNvSpPr>
                <a:spLocks noChangeArrowheads="1"/>
              </p:cNvSpPr>
              <p:nvPr/>
            </p:nvSpPr>
            <p:spPr bwMode="auto">
              <a:xfrm>
                <a:off x="4000500" y="7451727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50</a:t>
                </a:r>
              </a:p>
            </p:txBody>
          </p:sp>
          <p:sp>
            <p:nvSpPr>
              <p:cNvPr id="561" name="Freeform 383"/>
              <p:cNvSpPr>
                <a:spLocks/>
              </p:cNvSpPr>
              <p:nvPr/>
            </p:nvSpPr>
            <p:spPr bwMode="auto">
              <a:xfrm>
                <a:off x="1489075" y="7473950"/>
                <a:ext cx="2506663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1579" y="33"/>
                  </a:cxn>
                </a:cxnLst>
                <a:rect l="0" t="0" r="r" b="b"/>
                <a:pathLst>
                  <a:path w="1579" h="33">
                    <a:moveTo>
                      <a:pt x="0" y="0"/>
                    </a:moveTo>
                    <a:lnTo>
                      <a:pt x="0" y="33"/>
                    </a:lnTo>
                    <a:lnTo>
                      <a:pt x="1579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2" name="Freeform 384"/>
              <p:cNvSpPr>
                <a:spLocks/>
              </p:cNvSpPr>
              <p:nvPr/>
            </p:nvSpPr>
            <p:spPr bwMode="auto">
              <a:xfrm>
                <a:off x="800100" y="7469188"/>
                <a:ext cx="688975" cy="131763"/>
              </a:xfrm>
              <a:custGeom>
                <a:avLst/>
                <a:gdLst/>
                <a:ahLst/>
                <a:cxnLst>
                  <a:cxn ang="0">
                    <a:pos x="0" y="83"/>
                  </a:cxn>
                  <a:cxn ang="0">
                    <a:pos x="0" y="0"/>
                  </a:cxn>
                  <a:cxn ang="0">
                    <a:pos x="434" y="0"/>
                  </a:cxn>
                </a:cxnLst>
                <a:rect l="0" t="0" r="r" b="b"/>
                <a:pathLst>
                  <a:path w="434" h="83">
                    <a:moveTo>
                      <a:pt x="0" y="83"/>
                    </a:moveTo>
                    <a:lnTo>
                      <a:pt x="0" y="0"/>
                    </a:lnTo>
                    <a:lnTo>
                      <a:pt x="43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3" name="Rectangle 385"/>
              <p:cNvSpPr>
                <a:spLocks noChangeArrowheads="1"/>
              </p:cNvSpPr>
              <p:nvPr/>
            </p:nvSpPr>
            <p:spPr bwMode="auto">
              <a:xfrm>
                <a:off x="2608262" y="7566026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170</a:t>
                </a:r>
              </a:p>
            </p:txBody>
          </p:sp>
          <p:sp>
            <p:nvSpPr>
              <p:cNvPr id="564" name="Freeform 386"/>
              <p:cNvSpPr>
                <a:spLocks/>
              </p:cNvSpPr>
              <p:nvPr/>
            </p:nvSpPr>
            <p:spPr bwMode="auto">
              <a:xfrm>
                <a:off x="1198562" y="7640638"/>
                <a:ext cx="1404938" cy="95250"/>
              </a:xfrm>
              <a:custGeom>
                <a:avLst/>
                <a:gdLst/>
                <a:ahLst/>
                <a:cxnLst>
                  <a:cxn ang="0">
                    <a:pos x="0" y="60"/>
                  </a:cxn>
                  <a:cxn ang="0">
                    <a:pos x="0" y="0"/>
                  </a:cxn>
                  <a:cxn ang="0">
                    <a:pos x="885" y="0"/>
                  </a:cxn>
                </a:cxnLst>
                <a:rect l="0" t="0" r="r" b="b"/>
                <a:pathLst>
                  <a:path w="885" h="60">
                    <a:moveTo>
                      <a:pt x="0" y="60"/>
                    </a:moveTo>
                    <a:lnTo>
                      <a:pt x="0" y="0"/>
                    </a:lnTo>
                    <a:lnTo>
                      <a:pt x="885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5" name="Rectangle 387"/>
              <p:cNvSpPr>
                <a:spLocks noChangeArrowheads="1"/>
              </p:cNvSpPr>
              <p:nvPr/>
            </p:nvSpPr>
            <p:spPr bwMode="auto">
              <a:xfrm>
                <a:off x="3032126" y="7680326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30</a:t>
                </a:r>
              </a:p>
            </p:txBody>
          </p:sp>
          <p:sp>
            <p:nvSpPr>
              <p:cNvPr id="566" name="Freeform 388"/>
              <p:cNvSpPr>
                <a:spLocks/>
              </p:cNvSpPr>
              <p:nvPr/>
            </p:nvSpPr>
            <p:spPr bwMode="auto">
              <a:xfrm>
                <a:off x="1804987" y="7754938"/>
                <a:ext cx="1222375" cy="80963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770" y="0"/>
                  </a:cxn>
                </a:cxnLst>
                <a:rect l="0" t="0" r="r" b="b"/>
                <a:pathLst>
                  <a:path w="770" h="51">
                    <a:moveTo>
                      <a:pt x="0" y="51"/>
                    </a:moveTo>
                    <a:lnTo>
                      <a:pt x="0" y="0"/>
                    </a:lnTo>
                    <a:lnTo>
                      <a:pt x="77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7" name="Rectangle 389"/>
              <p:cNvSpPr>
                <a:spLocks noChangeArrowheads="1"/>
              </p:cNvSpPr>
              <p:nvPr/>
            </p:nvSpPr>
            <p:spPr bwMode="auto">
              <a:xfrm>
                <a:off x="3319462" y="7802602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20</a:t>
                </a:r>
              </a:p>
            </p:txBody>
          </p:sp>
          <p:sp>
            <p:nvSpPr>
              <p:cNvPr id="568" name="Freeform 390"/>
              <p:cNvSpPr>
                <a:spLocks/>
              </p:cNvSpPr>
              <p:nvPr/>
            </p:nvSpPr>
            <p:spPr bwMode="auto">
              <a:xfrm>
                <a:off x="3022600" y="7869238"/>
                <a:ext cx="292100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184" y="0"/>
                  </a:cxn>
                </a:cxnLst>
                <a:rect l="0" t="0" r="r" b="b"/>
                <a:pathLst>
                  <a:path w="184" h="33">
                    <a:moveTo>
                      <a:pt x="0" y="33"/>
                    </a:moveTo>
                    <a:lnTo>
                      <a:pt x="0" y="0"/>
                    </a:lnTo>
                    <a:lnTo>
                      <a:pt x="18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69" name="Rectangle 391"/>
              <p:cNvSpPr>
                <a:spLocks noChangeArrowheads="1"/>
              </p:cNvSpPr>
              <p:nvPr/>
            </p:nvSpPr>
            <p:spPr bwMode="auto">
              <a:xfrm>
                <a:off x="3124199" y="7924878"/>
                <a:ext cx="1441516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210</a:t>
                </a:r>
              </a:p>
            </p:txBody>
          </p:sp>
          <p:sp>
            <p:nvSpPr>
              <p:cNvPr id="570" name="Freeform 392"/>
              <p:cNvSpPr>
                <a:spLocks/>
              </p:cNvSpPr>
              <p:nvPr/>
            </p:nvSpPr>
            <p:spPr bwMode="auto">
              <a:xfrm>
                <a:off x="3022600" y="7931150"/>
                <a:ext cx="96838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61" y="33"/>
                  </a:cxn>
                </a:cxnLst>
                <a:rect l="0" t="0" r="r" b="b"/>
                <a:pathLst>
                  <a:path w="61" h="33">
                    <a:moveTo>
                      <a:pt x="0" y="0"/>
                    </a:moveTo>
                    <a:lnTo>
                      <a:pt x="0" y="33"/>
                    </a:lnTo>
                    <a:lnTo>
                      <a:pt x="61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71" name="Freeform 393"/>
              <p:cNvSpPr>
                <a:spLocks/>
              </p:cNvSpPr>
              <p:nvPr/>
            </p:nvSpPr>
            <p:spPr bwMode="auto">
              <a:xfrm>
                <a:off x="1804987" y="7845425"/>
                <a:ext cx="1217613" cy="809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767" y="51"/>
                  </a:cxn>
                </a:cxnLst>
                <a:rect l="0" t="0" r="r" b="b"/>
                <a:pathLst>
                  <a:path w="767" h="51">
                    <a:moveTo>
                      <a:pt x="0" y="0"/>
                    </a:moveTo>
                    <a:lnTo>
                      <a:pt x="0" y="51"/>
                    </a:lnTo>
                    <a:lnTo>
                      <a:pt x="767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72" name="Freeform 394"/>
              <p:cNvSpPr>
                <a:spLocks/>
              </p:cNvSpPr>
              <p:nvPr/>
            </p:nvSpPr>
            <p:spPr bwMode="auto">
              <a:xfrm>
                <a:off x="1198562" y="7745413"/>
                <a:ext cx="606425" cy="952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60"/>
                  </a:cxn>
                  <a:cxn ang="0">
                    <a:pos x="382" y="60"/>
                  </a:cxn>
                </a:cxnLst>
                <a:rect l="0" t="0" r="r" b="b"/>
                <a:pathLst>
                  <a:path w="382" h="60">
                    <a:moveTo>
                      <a:pt x="0" y="0"/>
                    </a:moveTo>
                    <a:lnTo>
                      <a:pt x="0" y="60"/>
                    </a:lnTo>
                    <a:lnTo>
                      <a:pt x="382" y="6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73" name="Freeform 395"/>
              <p:cNvSpPr>
                <a:spLocks/>
              </p:cNvSpPr>
              <p:nvPr/>
            </p:nvSpPr>
            <p:spPr bwMode="auto">
              <a:xfrm>
                <a:off x="800100" y="7610475"/>
                <a:ext cx="398463" cy="13017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82"/>
                  </a:cxn>
                  <a:cxn ang="0">
                    <a:pos x="251" y="82"/>
                  </a:cxn>
                </a:cxnLst>
                <a:rect l="0" t="0" r="r" b="b"/>
                <a:pathLst>
                  <a:path w="251" h="82">
                    <a:moveTo>
                      <a:pt x="0" y="0"/>
                    </a:moveTo>
                    <a:lnTo>
                      <a:pt x="0" y="82"/>
                    </a:lnTo>
                    <a:lnTo>
                      <a:pt x="251" y="8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74" name="Freeform 396"/>
              <p:cNvSpPr>
                <a:spLocks/>
              </p:cNvSpPr>
              <p:nvPr/>
            </p:nvSpPr>
            <p:spPr bwMode="auto">
              <a:xfrm>
                <a:off x="700087" y="6919913"/>
                <a:ext cx="100013" cy="68580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432"/>
                  </a:cxn>
                  <a:cxn ang="0">
                    <a:pos x="63" y="432"/>
                  </a:cxn>
                </a:cxnLst>
                <a:rect l="0" t="0" r="r" b="b"/>
                <a:pathLst>
                  <a:path w="63" h="432">
                    <a:moveTo>
                      <a:pt x="0" y="0"/>
                    </a:moveTo>
                    <a:lnTo>
                      <a:pt x="0" y="432"/>
                    </a:lnTo>
                    <a:lnTo>
                      <a:pt x="63" y="43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75" name="Freeform 397"/>
              <p:cNvSpPr>
                <a:spLocks/>
              </p:cNvSpPr>
              <p:nvPr/>
            </p:nvSpPr>
            <p:spPr bwMode="auto">
              <a:xfrm>
                <a:off x="252412" y="6915150"/>
                <a:ext cx="447675" cy="614363"/>
              </a:xfrm>
              <a:custGeom>
                <a:avLst/>
                <a:gdLst/>
                <a:ahLst/>
                <a:cxnLst>
                  <a:cxn ang="0">
                    <a:pos x="0" y="387"/>
                  </a:cxn>
                  <a:cxn ang="0">
                    <a:pos x="0" y="0"/>
                  </a:cxn>
                  <a:cxn ang="0">
                    <a:pos x="282" y="0"/>
                  </a:cxn>
                </a:cxnLst>
                <a:rect l="0" t="0" r="r" b="b"/>
                <a:pathLst>
                  <a:path w="282" h="387">
                    <a:moveTo>
                      <a:pt x="0" y="387"/>
                    </a:moveTo>
                    <a:lnTo>
                      <a:pt x="0" y="0"/>
                    </a:lnTo>
                    <a:lnTo>
                      <a:pt x="28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76" name="Rectangle 398"/>
              <p:cNvSpPr>
                <a:spLocks noChangeArrowheads="1"/>
              </p:cNvSpPr>
              <p:nvPr/>
            </p:nvSpPr>
            <p:spPr bwMode="auto">
              <a:xfrm>
                <a:off x="1747838" y="8023227"/>
                <a:ext cx="1278014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0260</a:t>
                </a:r>
              </a:p>
            </p:txBody>
          </p:sp>
          <p:sp>
            <p:nvSpPr>
              <p:cNvPr id="577" name="Freeform 399"/>
              <p:cNvSpPr>
                <a:spLocks/>
              </p:cNvSpPr>
              <p:nvPr/>
            </p:nvSpPr>
            <p:spPr bwMode="auto">
              <a:xfrm>
                <a:off x="946150" y="8097838"/>
                <a:ext cx="796925" cy="52388"/>
              </a:xfrm>
              <a:custGeom>
                <a:avLst/>
                <a:gdLst/>
                <a:ahLst/>
                <a:cxnLst>
                  <a:cxn ang="0">
                    <a:pos x="0" y="33"/>
                  </a:cxn>
                  <a:cxn ang="0">
                    <a:pos x="0" y="0"/>
                  </a:cxn>
                  <a:cxn ang="0">
                    <a:pos x="502" y="0"/>
                  </a:cxn>
                </a:cxnLst>
                <a:rect l="0" t="0" r="r" b="b"/>
                <a:pathLst>
                  <a:path w="502" h="33">
                    <a:moveTo>
                      <a:pt x="0" y="33"/>
                    </a:moveTo>
                    <a:lnTo>
                      <a:pt x="0" y="0"/>
                    </a:lnTo>
                    <a:lnTo>
                      <a:pt x="50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78" name="Rectangle 400"/>
              <p:cNvSpPr>
                <a:spLocks noChangeArrowheads="1"/>
              </p:cNvSpPr>
              <p:nvPr/>
            </p:nvSpPr>
            <p:spPr bwMode="auto">
              <a:xfrm>
                <a:off x="2465387" y="8153479"/>
                <a:ext cx="1278014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0250</a:t>
                </a:r>
              </a:p>
            </p:txBody>
          </p:sp>
          <p:sp>
            <p:nvSpPr>
              <p:cNvPr id="579" name="Freeform 401"/>
              <p:cNvSpPr>
                <a:spLocks/>
              </p:cNvSpPr>
              <p:nvPr/>
            </p:nvSpPr>
            <p:spPr bwMode="auto">
              <a:xfrm>
                <a:off x="946150" y="8159750"/>
                <a:ext cx="1514475" cy="5238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3"/>
                  </a:cxn>
                  <a:cxn ang="0">
                    <a:pos x="954" y="33"/>
                  </a:cxn>
                </a:cxnLst>
                <a:rect l="0" t="0" r="r" b="b"/>
                <a:pathLst>
                  <a:path w="954" h="33">
                    <a:moveTo>
                      <a:pt x="0" y="0"/>
                    </a:moveTo>
                    <a:lnTo>
                      <a:pt x="0" y="33"/>
                    </a:lnTo>
                    <a:lnTo>
                      <a:pt x="954" y="3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0" name="Freeform 402"/>
              <p:cNvSpPr>
                <a:spLocks/>
              </p:cNvSpPr>
              <p:nvPr/>
            </p:nvSpPr>
            <p:spPr bwMode="auto">
              <a:xfrm>
                <a:off x="252412" y="7539038"/>
                <a:ext cx="693738" cy="615950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88"/>
                  </a:cxn>
                  <a:cxn ang="0">
                    <a:pos x="437" y="388"/>
                  </a:cxn>
                </a:cxnLst>
                <a:rect l="0" t="0" r="r" b="b"/>
                <a:pathLst>
                  <a:path w="437" h="388">
                    <a:moveTo>
                      <a:pt x="0" y="0"/>
                    </a:moveTo>
                    <a:lnTo>
                      <a:pt x="0" y="388"/>
                    </a:lnTo>
                    <a:lnTo>
                      <a:pt x="437" y="38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1" name="Line 403"/>
              <p:cNvSpPr>
                <a:spLocks noChangeShapeType="1"/>
              </p:cNvSpPr>
              <p:nvPr/>
            </p:nvSpPr>
            <p:spPr bwMode="auto">
              <a:xfrm>
                <a:off x="14287" y="7534275"/>
                <a:ext cx="238125" cy="158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2" name="Rectangle 404"/>
              <p:cNvSpPr>
                <a:spLocks noChangeArrowheads="1"/>
              </p:cNvSpPr>
              <p:nvPr/>
            </p:nvSpPr>
            <p:spPr bwMode="auto">
              <a:xfrm>
                <a:off x="690557" y="8156486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8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3" name="Rectangle 405"/>
              <p:cNvSpPr>
                <a:spLocks noChangeArrowheads="1"/>
              </p:cNvSpPr>
              <p:nvPr/>
            </p:nvSpPr>
            <p:spPr bwMode="auto">
              <a:xfrm>
                <a:off x="2767009" y="7920720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9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4" name="Rectangle 406"/>
              <p:cNvSpPr>
                <a:spLocks noChangeArrowheads="1"/>
              </p:cNvSpPr>
              <p:nvPr/>
            </p:nvSpPr>
            <p:spPr bwMode="auto">
              <a:xfrm>
                <a:off x="1549396" y="7834995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2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5" name="Rectangle 407"/>
              <p:cNvSpPr>
                <a:spLocks noChangeArrowheads="1"/>
              </p:cNvSpPr>
              <p:nvPr/>
            </p:nvSpPr>
            <p:spPr bwMode="auto">
              <a:xfrm>
                <a:off x="942970" y="7734983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3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6" name="Rectangle 408"/>
              <p:cNvSpPr>
                <a:spLocks noChangeArrowheads="1"/>
              </p:cNvSpPr>
              <p:nvPr/>
            </p:nvSpPr>
            <p:spPr bwMode="auto">
              <a:xfrm>
                <a:off x="1249651" y="7327128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3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7" name="Rectangle 409"/>
              <p:cNvSpPr>
                <a:spLocks noChangeArrowheads="1"/>
              </p:cNvSpPr>
              <p:nvPr/>
            </p:nvSpPr>
            <p:spPr bwMode="auto">
              <a:xfrm>
                <a:off x="544507" y="7605624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77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8" name="Rectangle 410"/>
              <p:cNvSpPr>
                <a:spLocks noChangeArrowheads="1"/>
              </p:cNvSpPr>
              <p:nvPr/>
            </p:nvSpPr>
            <p:spPr bwMode="auto">
              <a:xfrm>
                <a:off x="2007409" y="7220588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1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89" name="Rectangle 411"/>
              <p:cNvSpPr>
                <a:spLocks noChangeArrowheads="1"/>
              </p:cNvSpPr>
              <p:nvPr/>
            </p:nvSpPr>
            <p:spPr bwMode="auto">
              <a:xfrm>
                <a:off x="1540198" y="7134863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6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0" name="Rectangle 412"/>
              <p:cNvSpPr>
                <a:spLocks noChangeArrowheads="1"/>
              </p:cNvSpPr>
              <p:nvPr/>
            </p:nvSpPr>
            <p:spPr bwMode="auto">
              <a:xfrm>
                <a:off x="902508" y="7049184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1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1" name="Rectangle 413"/>
              <p:cNvSpPr>
                <a:spLocks noChangeArrowheads="1"/>
              </p:cNvSpPr>
              <p:nvPr/>
            </p:nvSpPr>
            <p:spPr bwMode="auto">
              <a:xfrm>
                <a:off x="712009" y="6941233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7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2" name="Rectangle 414"/>
              <p:cNvSpPr>
                <a:spLocks noChangeArrowheads="1"/>
              </p:cNvSpPr>
              <p:nvPr/>
            </p:nvSpPr>
            <p:spPr bwMode="auto">
              <a:xfrm>
                <a:off x="1923045" y="6312762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7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3" name="Rectangle 415"/>
              <p:cNvSpPr>
                <a:spLocks noChangeArrowheads="1"/>
              </p:cNvSpPr>
              <p:nvPr/>
            </p:nvSpPr>
            <p:spPr bwMode="auto">
              <a:xfrm>
                <a:off x="3734357" y="6656256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4" name="Rectangle 416"/>
              <p:cNvSpPr>
                <a:spLocks noChangeArrowheads="1"/>
              </p:cNvSpPr>
              <p:nvPr/>
            </p:nvSpPr>
            <p:spPr bwMode="auto">
              <a:xfrm>
                <a:off x="1526923" y="6592116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5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5" name="Rectangle 417"/>
              <p:cNvSpPr>
                <a:spLocks noChangeArrowheads="1"/>
              </p:cNvSpPr>
              <p:nvPr/>
            </p:nvSpPr>
            <p:spPr bwMode="auto">
              <a:xfrm>
                <a:off x="1311890" y="6434910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1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6" name="Rectangle 418"/>
              <p:cNvSpPr>
                <a:spLocks noChangeArrowheads="1"/>
              </p:cNvSpPr>
              <p:nvPr/>
            </p:nvSpPr>
            <p:spPr bwMode="auto">
              <a:xfrm>
                <a:off x="3519246" y="5977028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7" name="Rectangle 419"/>
              <p:cNvSpPr>
                <a:spLocks noChangeArrowheads="1"/>
              </p:cNvSpPr>
              <p:nvPr/>
            </p:nvSpPr>
            <p:spPr bwMode="auto">
              <a:xfrm>
                <a:off x="854691" y="6277748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1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8" name="Rectangle 420"/>
              <p:cNvSpPr>
                <a:spLocks noChangeArrowheads="1"/>
              </p:cNvSpPr>
              <p:nvPr/>
            </p:nvSpPr>
            <p:spPr bwMode="auto">
              <a:xfrm>
                <a:off x="2388735" y="5626962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9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599" name="Rectangle 421"/>
              <p:cNvSpPr>
                <a:spLocks noChangeArrowheads="1"/>
              </p:cNvSpPr>
              <p:nvPr/>
            </p:nvSpPr>
            <p:spPr bwMode="auto">
              <a:xfrm>
                <a:off x="816450" y="5685224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4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0" name="Rectangle 422"/>
              <p:cNvSpPr>
                <a:spLocks noChangeArrowheads="1"/>
              </p:cNvSpPr>
              <p:nvPr/>
            </p:nvSpPr>
            <p:spPr bwMode="auto">
              <a:xfrm>
                <a:off x="830497" y="6009234"/>
                <a:ext cx="260860" cy="13893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77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1" name="Rectangle 423"/>
              <p:cNvSpPr>
                <a:spLocks noChangeArrowheads="1"/>
              </p:cNvSpPr>
              <p:nvPr/>
            </p:nvSpPr>
            <p:spPr bwMode="auto">
              <a:xfrm>
                <a:off x="2946203" y="5513255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2" name="Rectangle 424"/>
              <p:cNvSpPr>
                <a:spLocks noChangeArrowheads="1"/>
              </p:cNvSpPr>
              <p:nvPr/>
            </p:nvSpPr>
            <p:spPr bwMode="auto">
              <a:xfrm>
                <a:off x="1622228" y="5427530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4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3" name="Rectangle 425"/>
              <p:cNvSpPr>
                <a:spLocks noChangeArrowheads="1"/>
              </p:cNvSpPr>
              <p:nvPr/>
            </p:nvSpPr>
            <p:spPr bwMode="auto">
              <a:xfrm>
                <a:off x="1243821" y="5327519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4" name="Rectangle 426"/>
              <p:cNvSpPr>
                <a:spLocks noChangeArrowheads="1"/>
              </p:cNvSpPr>
              <p:nvPr/>
            </p:nvSpPr>
            <p:spPr bwMode="auto">
              <a:xfrm>
                <a:off x="3807367" y="4939961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5" name="Rectangle 427"/>
              <p:cNvSpPr>
                <a:spLocks noChangeArrowheads="1"/>
              </p:cNvSpPr>
              <p:nvPr/>
            </p:nvSpPr>
            <p:spPr bwMode="auto">
              <a:xfrm>
                <a:off x="1007282" y="5190993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1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6" name="Rectangle 428"/>
              <p:cNvSpPr>
                <a:spLocks noChangeArrowheads="1"/>
              </p:cNvSpPr>
              <p:nvPr/>
            </p:nvSpPr>
            <p:spPr bwMode="auto">
              <a:xfrm>
                <a:off x="3108340" y="4588971"/>
                <a:ext cx="153888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7" name="Rectangle 429"/>
              <p:cNvSpPr>
                <a:spLocks noChangeArrowheads="1"/>
              </p:cNvSpPr>
              <p:nvPr/>
            </p:nvSpPr>
            <p:spPr bwMode="auto">
              <a:xfrm>
                <a:off x="3331136" y="4026762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6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8" name="Rectangle 430"/>
              <p:cNvSpPr>
                <a:spLocks noChangeArrowheads="1"/>
              </p:cNvSpPr>
              <p:nvPr/>
            </p:nvSpPr>
            <p:spPr bwMode="auto">
              <a:xfrm>
                <a:off x="4269605" y="4255600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9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09" name="Rectangle 431"/>
              <p:cNvSpPr>
                <a:spLocks noChangeArrowheads="1"/>
              </p:cNvSpPr>
              <p:nvPr/>
            </p:nvSpPr>
            <p:spPr bwMode="auto">
              <a:xfrm>
                <a:off x="2428119" y="4141061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1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0" name="Rectangle 432"/>
              <p:cNvSpPr>
                <a:spLocks noChangeArrowheads="1"/>
              </p:cNvSpPr>
              <p:nvPr/>
            </p:nvSpPr>
            <p:spPr bwMode="auto">
              <a:xfrm>
                <a:off x="1817707" y="4283936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5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1" name="Rectangle 433"/>
              <p:cNvSpPr>
                <a:spLocks noChangeArrowheads="1"/>
              </p:cNvSpPr>
              <p:nvPr/>
            </p:nvSpPr>
            <p:spPr bwMode="auto">
              <a:xfrm>
                <a:off x="1122273" y="4429168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0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2" name="Rectangle 434"/>
              <p:cNvSpPr>
                <a:spLocks noChangeArrowheads="1"/>
              </p:cNvSpPr>
              <p:nvPr/>
            </p:nvSpPr>
            <p:spPr bwMode="auto">
              <a:xfrm>
                <a:off x="842872" y="4594268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9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3" name="Rectangle 435"/>
              <p:cNvSpPr>
                <a:spLocks noChangeArrowheads="1"/>
              </p:cNvSpPr>
              <p:nvPr/>
            </p:nvSpPr>
            <p:spPr bwMode="auto">
              <a:xfrm>
                <a:off x="596918" y="4841149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3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4" name="Rectangle 436"/>
              <p:cNvSpPr>
                <a:spLocks noChangeArrowheads="1"/>
              </p:cNvSpPr>
              <p:nvPr/>
            </p:nvSpPr>
            <p:spPr bwMode="auto">
              <a:xfrm>
                <a:off x="555396" y="5336315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5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5" name="Rectangle 437"/>
              <p:cNvSpPr>
                <a:spLocks noChangeArrowheads="1"/>
              </p:cNvSpPr>
              <p:nvPr/>
            </p:nvSpPr>
            <p:spPr bwMode="auto">
              <a:xfrm>
                <a:off x="593369" y="6111974"/>
                <a:ext cx="51295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6" name="Rectangle 438"/>
              <p:cNvSpPr>
                <a:spLocks noChangeArrowheads="1"/>
              </p:cNvSpPr>
              <p:nvPr/>
            </p:nvSpPr>
            <p:spPr bwMode="auto">
              <a:xfrm>
                <a:off x="460665" y="6751593"/>
                <a:ext cx="102593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5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7" name="Line 439"/>
              <p:cNvSpPr>
                <a:spLocks noChangeShapeType="1"/>
              </p:cNvSpPr>
              <p:nvPr/>
            </p:nvSpPr>
            <p:spPr bwMode="auto">
              <a:xfrm>
                <a:off x="728661" y="8426363"/>
                <a:ext cx="623888" cy="158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8" name="Line 440"/>
              <p:cNvSpPr>
                <a:spLocks noChangeShapeType="1"/>
              </p:cNvSpPr>
              <p:nvPr/>
            </p:nvSpPr>
            <p:spPr bwMode="auto">
              <a:xfrm>
                <a:off x="728661" y="8388263"/>
                <a:ext cx="1588" cy="7620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19" name="Line 441"/>
              <p:cNvSpPr>
                <a:spLocks noChangeShapeType="1"/>
              </p:cNvSpPr>
              <p:nvPr/>
            </p:nvSpPr>
            <p:spPr bwMode="auto">
              <a:xfrm>
                <a:off x="1352550" y="8388263"/>
                <a:ext cx="1588" cy="76200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0" name="Rectangle 442"/>
              <p:cNvSpPr>
                <a:spLocks noChangeArrowheads="1"/>
              </p:cNvSpPr>
              <p:nvPr/>
            </p:nvSpPr>
            <p:spPr bwMode="auto">
              <a:xfrm>
                <a:off x="941387" y="8464464"/>
                <a:ext cx="179536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0.01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621" name="Group 446"/>
            <p:cNvGrpSpPr>
              <a:grpSpLocks noChangeAspect="1"/>
            </p:cNvGrpSpPr>
            <p:nvPr/>
          </p:nvGrpSpPr>
          <p:grpSpPr bwMode="auto">
            <a:xfrm>
              <a:off x="3805239" y="817066"/>
              <a:ext cx="2906712" cy="2876550"/>
              <a:chOff x="521" y="676"/>
              <a:chExt cx="2238" cy="2484"/>
            </a:xfrm>
          </p:grpSpPr>
          <p:sp>
            <p:nvSpPr>
              <p:cNvPr id="622" name="AutoShape 445"/>
              <p:cNvSpPr>
                <a:spLocks noChangeAspect="1" noChangeArrowheads="1" noTextEdit="1"/>
              </p:cNvSpPr>
              <p:nvPr/>
            </p:nvSpPr>
            <p:spPr bwMode="auto">
              <a:xfrm>
                <a:off x="521" y="676"/>
                <a:ext cx="2238" cy="248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3" name="Rectangle 447"/>
              <p:cNvSpPr>
                <a:spLocks noChangeArrowheads="1"/>
              </p:cNvSpPr>
              <p:nvPr/>
            </p:nvSpPr>
            <p:spPr bwMode="auto">
              <a:xfrm>
                <a:off x="2011" y="744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110</a:t>
                </a:r>
              </a:p>
            </p:txBody>
          </p:sp>
          <p:sp>
            <p:nvSpPr>
              <p:cNvPr id="624" name="Freeform 448"/>
              <p:cNvSpPr>
                <a:spLocks/>
              </p:cNvSpPr>
              <p:nvPr/>
            </p:nvSpPr>
            <p:spPr bwMode="auto">
              <a:xfrm>
                <a:off x="2006" y="791"/>
                <a:ext cx="2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2" y="0"/>
                  </a:cxn>
                </a:cxnLst>
                <a:rect l="0" t="0" r="r" b="b"/>
                <a:pathLst>
                  <a:path w="2" h="51">
                    <a:moveTo>
                      <a:pt x="0" y="51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5" name="Rectangle 449"/>
              <p:cNvSpPr>
                <a:spLocks noChangeArrowheads="1"/>
              </p:cNvSpPr>
              <p:nvPr/>
            </p:nvSpPr>
            <p:spPr bwMode="auto">
              <a:xfrm>
                <a:off x="2011" y="852"/>
                <a:ext cx="485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8Ck00080</a:t>
                </a:r>
                <a:endParaRPr kumimoji="0" lang="fr-FR" sz="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6" name="Line 450"/>
              <p:cNvSpPr>
                <a:spLocks noChangeShapeType="1"/>
              </p:cNvSpPr>
              <p:nvPr/>
            </p:nvSpPr>
            <p:spPr bwMode="auto">
              <a:xfrm flipH="1">
                <a:off x="2008" y="899"/>
                <a:ext cx="1" cy="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7" name="Line 451"/>
              <p:cNvSpPr>
                <a:spLocks noChangeShapeType="1"/>
              </p:cNvSpPr>
              <p:nvPr/>
            </p:nvSpPr>
            <p:spPr bwMode="auto">
              <a:xfrm>
                <a:off x="2006" y="848"/>
                <a:ext cx="1" cy="5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8" name="Freeform 452"/>
              <p:cNvSpPr>
                <a:spLocks/>
              </p:cNvSpPr>
              <p:nvPr/>
            </p:nvSpPr>
            <p:spPr bwMode="auto">
              <a:xfrm>
                <a:off x="1807" y="845"/>
                <a:ext cx="199" cy="78"/>
              </a:xfrm>
              <a:custGeom>
                <a:avLst/>
                <a:gdLst/>
                <a:ahLst/>
                <a:cxnLst>
                  <a:cxn ang="0">
                    <a:pos x="0" y="78"/>
                  </a:cxn>
                  <a:cxn ang="0">
                    <a:pos x="0" y="0"/>
                  </a:cxn>
                  <a:cxn ang="0">
                    <a:pos x="199" y="0"/>
                  </a:cxn>
                </a:cxnLst>
                <a:rect l="0" t="0" r="r" b="b"/>
                <a:pathLst>
                  <a:path w="199" h="78">
                    <a:moveTo>
                      <a:pt x="0" y="78"/>
                    </a:moveTo>
                    <a:lnTo>
                      <a:pt x="0" y="0"/>
                    </a:lnTo>
                    <a:lnTo>
                      <a:pt x="19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29" name="Rectangle 453"/>
              <p:cNvSpPr>
                <a:spLocks noChangeArrowheads="1"/>
              </p:cNvSpPr>
              <p:nvPr/>
            </p:nvSpPr>
            <p:spPr bwMode="auto">
              <a:xfrm>
                <a:off x="1982" y="960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120</a:t>
                </a:r>
              </a:p>
            </p:txBody>
          </p:sp>
          <p:sp>
            <p:nvSpPr>
              <p:cNvPr id="630" name="Freeform 454"/>
              <p:cNvSpPr>
                <a:spLocks/>
              </p:cNvSpPr>
              <p:nvPr/>
            </p:nvSpPr>
            <p:spPr bwMode="auto">
              <a:xfrm>
                <a:off x="1807" y="929"/>
                <a:ext cx="172" cy="7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78"/>
                  </a:cxn>
                  <a:cxn ang="0">
                    <a:pos x="172" y="78"/>
                  </a:cxn>
                </a:cxnLst>
                <a:rect l="0" t="0" r="r" b="b"/>
                <a:pathLst>
                  <a:path w="172" h="78">
                    <a:moveTo>
                      <a:pt x="0" y="0"/>
                    </a:moveTo>
                    <a:lnTo>
                      <a:pt x="0" y="78"/>
                    </a:lnTo>
                    <a:lnTo>
                      <a:pt x="172" y="7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1" name="Freeform 455"/>
              <p:cNvSpPr>
                <a:spLocks/>
              </p:cNvSpPr>
              <p:nvPr/>
            </p:nvSpPr>
            <p:spPr bwMode="auto">
              <a:xfrm>
                <a:off x="1463" y="926"/>
                <a:ext cx="344" cy="119"/>
              </a:xfrm>
              <a:custGeom>
                <a:avLst/>
                <a:gdLst/>
                <a:ahLst/>
                <a:cxnLst>
                  <a:cxn ang="0">
                    <a:pos x="0" y="119"/>
                  </a:cxn>
                  <a:cxn ang="0">
                    <a:pos x="0" y="0"/>
                  </a:cxn>
                  <a:cxn ang="0">
                    <a:pos x="344" y="0"/>
                  </a:cxn>
                </a:cxnLst>
                <a:rect l="0" t="0" r="r" b="b"/>
                <a:pathLst>
                  <a:path w="344" h="119">
                    <a:moveTo>
                      <a:pt x="0" y="119"/>
                    </a:moveTo>
                    <a:lnTo>
                      <a:pt x="0" y="0"/>
                    </a:lnTo>
                    <a:lnTo>
                      <a:pt x="34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2" name="Rectangle 456"/>
              <p:cNvSpPr>
                <a:spLocks noChangeArrowheads="1"/>
              </p:cNvSpPr>
              <p:nvPr/>
            </p:nvSpPr>
            <p:spPr bwMode="auto">
              <a:xfrm>
                <a:off x="2054" y="1068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100</a:t>
                </a:r>
              </a:p>
            </p:txBody>
          </p:sp>
          <p:sp>
            <p:nvSpPr>
              <p:cNvPr id="633" name="Freeform 457"/>
              <p:cNvSpPr>
                <a:spLocks/>
              </p:cNvSpPr>
              <p:nvPr/>
            </p:nvSpPr>
            <p:spPr bwMode="auto">
              <a:xfrm>
                <a:off x="2050" y="1115"/>
                <a:ext cx="1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1" y="0"/>
                  </a:cxn>
                </a:cxnLst>
                <a:rect l="0" t="0" r="r" b="b"/>
                <a:pathLst>
                  <a:path w="1" h="51">
                    <a:moveTo>
                      <a:pt x="0" y="51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4" name="Rectangle 458"/>
              <p:cNvSpPr>
                <a:spLocks noChangeArrowheads="1"/>
              </p:cNvSpPr>
              <p:nvPr/>
            </p:nvSpPr>
            <p:spPr bwMode="auto">
              <a:xfrm>
                <a:off x="2054" y="1176"/>
                <a:ext cx="485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8Ck00090</a:t>
                </a:r>
                <a:endParaRPr kumimoji="0" lang="fr-FR" sz="800" b="1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5" name="Line 459"/>
              <p:cNvSpPr>
                <a:spLocks noChangeShapeType="1"/>
              </p:cNvSpPr>
              <p:nvPr/>
            </p:nvSpPr>
            <p:spPr bwMode="auto">
              <a:xfrm flipH="1">
                <a:off x="2051" y="1223"/>
                <a:ext cx="2" cy="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6" name="Line 460"/>
              <p:cNvSpPr>
                <a:spLocks noChangeShapeType="1"/>
              </p:cNvSpPr>
              <p:nvPr/>
            </p:nvSpPr>
            <p:spPr bwMode="auto">
              <a:xfrm>
                <a:off x="2050" y="1172"/>
                <a:ext cx="1" cy="5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7" name="Freeform 461"/>
              <p:cNvSpPr>
                <a:spLocks/>
              </p:cNvSpPr>
              <p:nvPr/>
            </p:nvSpPr>
            <p:spPr bwMode="auto">
              <a:xfrm>
                <a:off x="1463" y="1051"/>
                <a:ext cx="587" cy="118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18"/>
                  </a:cxn>
                  <a:cxn ang="0">
                    <a:pos x="587" y="118"/>
                  </a:cxn>
                </a:cxnLst>
                <a:rect l="0" t="0" r="r" b="b"/>
                <a:pathLst>
                  <a:path w="587" h="118">
                    <a:moveTo>
                      <a:pt x="0" y="0"/>
                    </a:moveTo>
                    <a:lnTo>
                      <a:pt x="0" y="118"/>
                    </a:lnTo>
                    <a:lnTo>
                      <a:pt x="587" y="118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8" name="Freeform 462"/>
              <p:cNvSpPr>
                <a:spLocks/>
              </p:cNvSpPr>
              <p:nvPr/>
            </p:nvSpPr>
            <p:spPr bwMode="auto">
              <a:xfrm>
                <a:off x="1183" y="1048"/>
                <a:ext cx="280" cy="165"/>
              </a:xfrm>
              <a:custGeom>
                <a:avLst/>
                <a:gdLst/>
                <a:ahLst/>
                <a:cxnLst>
                  <a:cxn ang="0">
                    <a:pos x="0" y="165"/>
                  </a:cxn>
                  <a:cxn ang="0">
                    <a:pos x="0" y="0"/>
                  </a:cxn>
                  <a:cxn ang="0">
                    <a:pos x="280" y="0"/>
                  </a:cxn>
                </a:cxnLst>
                <a:rect l="0" t="0" r="r" b="b"/>
                <a:pathLst>
                  <a:path w="280" h="165">
                    <a:moveTo>
                      <a:pt x="0" y="165"/>
                    </a:moveTo>
                    <a:lnTo>
                      <a:pt x="0" y="0"/>
                    </a:lnTo>
                    <a:lnTo>
                      <a:pt x="28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39" name="Rectangle 463"/>
              <p:cNvSpPr>
                <a:spLocks noChangeArrowheads="1"/>
              </p:cNvSpPr>
              <p:nvPr/>
            </p:nvSpPr>
            <p:spPr bwMode="auto">
              <a:xfrm>
                <a:off x="1891" y="1284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090</a:t>
                </a:r>
              </a:p>
            </p:txBody>
          </p:sp>
          <p:sp>
            <p:nvSpPr>
              <p:cNvPr id="640" name="Freeform 464"/>
              <p:cNvSpPr>
                <a:spLocks/>
              </p:cNvSpPr>
              <p:nvPr/>
            </p:nvSpPr>
            <p:spPr bwMode="auto">
              <a:xfrm>
                <a:off x="1886" y="1331"/>
                <a:ext cx="2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2" y="0"/>
                  </a:cxn>
                </a:cxnLst>
                <a:rect l="0" t="0" r="r" b="b"/>
                <a:pathLst>
                  <a:path w="2" h="51">
                    <a:moveTo>
                      <a:pt x="0" y="51"/>
                    </a:moveTo>
                    <a:lnTo>
                      <a:pt x="0" y="0"/>
                    </a:lnTo>
                    <a:lnTo>
                      <a:pt x="2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1" name="Rectangle 465"/>
              <p:cNvSpPr>
                <a:spLocks noChangeArrowheads="1"/>
              </p:cNvSpPr>
              <p:nvPr/>
            </p:nvSpPr>
            <p:spPr bwMode="auto">
              <a:xfrm>
                <a:off x="1891" y="1392"/>
                <a:ext cx="485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8Ck00100</a:t>
                </a:r>
                <a:endParaRPr kumimoji="0" lang="fr-FR" sz="800" b="1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2" name="Line 466"/>
              <p:cNvSpPr>
                <a:spLocks noChangeShapeType="1"/>
              </p:cNvSpPr>
              <p:nvPr/>
            </p:nvSpPr>
            <p:spPr bwMode="auto">
              <a:xfrm flipH="1">
                <a:off x="1888" y="1439"/>
                <a:ext cx="1" cy="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3" name="Line 467"/>
              <p:cNvSpPr>
                <a:spLocks noChangeShapeType="1"/>
              </p:cNvSpPr>
              <p:nvPr/>
            </p:nvSpPr>
            <p:spPr bwMode="auto">
              <a:xfrm>
                <a:off x="1886" y="1388"/>
                <a:ext cx="1" cy="5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4" name="Line 468"/>
              <p:cNvSpPr>
                <a:spLocks noChangeShapeType="1"/>
              </p:cNvSpPr>
              <p:nvPr/>
            </p:nvSpPr>
            <p:spPr bwMode="auto">
              <a:xfrm>
                <a:off x="1186" y="1385"/>
                <a:ext cx="700" cy="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5" name="Line 469"/>
              <p:cNvSpPr>
                <a:spLocks noChangeShapeType="1"/>
              </p:cNvSpPr>
              <p:nvPr/>
            </p:nvSpPr>
            <p:spPr bwMode="auto">
              <a:xfrm>
                <a:off x="1183" y="1219"/>
                <a:ext cx="1" cy="166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6" name="Freeform 470"/>
              <p:cNvSpPr>
                <a:spLocks/>
              </p:cNvSpPr>
              <p:nvPr/>
            </p:nvSpPr>
            <p:spPr bwMode="auto">
              <a:xfrm>
                <a:off x="940" y="1216"/>
                <a:ext cx="243" cy="162"/>
              </a:xfrm>
              <a:custGeom>
                <a:avLst/>
                <a:gdLst/>
                <a:ahLst/>
                <a:cxnLst>
                  <a:cxn ang="0">
                    <a:pos x="0" y="162"/>
                  </a:cxn>
                  <a:cxn ang="0">
                    <a:pos x="0" y="0"/>
                  </a:cxn>
                  <a:cxn ang="0">
                    <a:pos x="243" y="0"/>
                  </a:cxn>
                </a:cxnLst>
                <a:rect l="0" t="0" r="r" b="b"/>
                <a:pathLst>
                  <a:path w="243" h="162">
                    <a:moveTo>
                      <a:pt x="0" y="162"/>
                    </a:moveTo>
                    <a:lnTo>
                      <a:pt x="0" y="0"/>
                    </a:lnTo>
                    <a:lnTo>
                      <a:pt x="24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7" name="Rectangle 471"/>
              <p:cNvSpPr>
                <a:spLocks noChangeArrowheads="1"/>
              </p:cNvSpPr>
              <p:nvPr/>
            </p:nvSpPr>
            <p:spPr bwMode="auto">
              <a:xfrm>
                <a:off x="1652" y="1500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080</a:t>
                </a:r>
              </a:p>
            </p:txBody>
          </p:sp>
          <p:sp>
            <p:nvSpPr>
              <p:cNvPr id="648" name="Freeform 472"/>
              <p:cNvSpPr>
                <a:spLocks/>
              </p:cNvSpPr>
              <p:nvPr/>
            </p:nvSpPr>
            <p:spPr bwMode="auto">
              <a:xfrm>
                <a:off x="940" y="1384"/>
                <a:ext cx="709" cy="1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63"/>
                  </a:cxn>
                  <a:cxn ang="0">
                    <a:pos x="709" y="163"/>
                  </a:cxn>
                </a:cxnLst>
                <a:rect l="0" t="0" r="r" b="b"/>
                <a:pathLst>
                  <a:path w="709" h="163">
                    <a:moveTo>
                      <a:pt x="0" y="0"/>
                    </a:moveTo>
                    <a:lnTo>
                      <a:pt x="0" y="163"/>
                    </a:lnTo>
                    <a:lnTo>
                      <a:pt x="709" y="16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49" name="Freeform 473"/>
              <p:cNvSpPr>
                <a:spLocks/>
              </p:cNvSpPr>
              <p:nvPr/>
            </p:nvSpPr>
            <p:spPr bwMode="auto">
              <a:xfrm>
                <a:off x="781" y="1381"/>
                <a:ext cx="159" cy="160"/>
              </a:xfrm>
              <a:custGeom>
                <a:avLst/>
                <a:gdLst/>
                <a:ahLst/>
                <a:cxnLst>
                  <a:cxn ang="0">
                    <a:pos x="0" y="160"/>
                  </a:cxn>
                  <a:cxn ang="0">
                    <a:pos x="0" y="0"/>
                  </a:cxn>
                  <a:cxn ang="0">
                    <a:pos x="159" y="0"/>
                  </a:cxn>
                </a:cxnLst>
                <a:rect l="0" t="0" r="r" b="b"/>
                <a:pathLst>
                  <a:path w="159" h="160">
                    <a:moveTo>
                      <a:pt x="0" y="160"/>
                    </a:moveTo>
                    <a:lnTo>
                      <a:pt x="0" y="0"/>
                    </a:lnTo>
                    <a:lnTo>
                      <a:pt x="159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0" name="Rectangle 474"/>
              <p:cNvSpPr>
                <a:spLocks noChangeArrowheads="1"/>
              </p:cNvSpPr>
              <p:nvPr/>
            </p:nvSpPr>
            <p:spPr bwMode="auto">
              <a:xfrm>
                <a:off x="1528" y="1608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030</a:t>
                </a:r>
              </a:p>
            </p:txBody>
          </p:sp>
          <p:sp>
            <p:nvSpPr>
              <p:cNvPr id="651" name="Freeform 475"/>
              <p:cNvSpPr>
                <a:spLocks/>
              </p:cNvSpPr>
              <p:nvPr/>
            </p:nvSpPr>
            <p:spPr bwMode="auto">
              <a:xfrm>
                <a:off x="1499" y="1655"/>
                <a:ext cx="26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26" y="0"/>
                  </a:cxn>
                </a:cxnLst>
                <a:rect l="0" t="0" r="r" b="b"/>
                <a:pathLst>
                  <a:path w="26" h="51">
                    <a:moveTo>
                      <a:pt x="0" y="51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2" name="Rectangle 476"/>
              <p:cNvSpPr>
                <a:spLocks noChangeArrowheads="1"/>
              </p:cNvSpPr>
              <p:nvPr/>
            </p:nvSpPr>
            <p:spPr bwMode="auto">
              <a:xfrm>
                <a:off x="1576" y="1716"/>
                <a:ext cx="47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130</a:t>
                </a:r>
              </a:p>
            </p:txBody>
          </p:sp>
          <p:sp>
            <p:nvSpPr>
              <p:cNvPr id="653" name="Freeform 477"/>
              <p:cNvSpPr>
                <a:spLocks/>
              </p:cNvSpPr>
              <p:nvPr/>
            </p:nvSpPr>
            <p:spPr bwMode="auto">
              <a:xfrm>
                <a:off x="1499" y="1712"/>
                <a:ext cx="74" cy="5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74" y="51"/>
                  </a:cxn>
                </a:cxnLst>
                <a:rect l="0" t="0" r="r" b="b"/>
                <a:pathLst>
                  <a:path w="74" h="51">
                    <a:moveTo>
                      <a:pt x="0" y="0"/>
                    </a:moveTo>
                    <a:lnTo>
                      <a:pt x="0" y="51"/>
                    </a:lnTo>
                    <a:lnTo>
                      <a:pt x="74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4" name="Freeform 478"/>
              <p:cNvSpPr>
                <a:spLocks/>
              </p:cNvSpPr>
              <p:nvPr/>
            </p:nvSpPr>
            <p:spPr bwMode="auto">
              <a:xfrm>
                <a:off x="781" y="1547"/>
                <a:ext cx="718" cy="162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62"/>
                  </a:cxn>
                  <a:cxn ang="0">
                    <a:pos x="718" y="162"/>
                  </a:cxn>
                </a:cxnLst>
                <a:rect l="0" t="0" r="r" b="b"/>
                <a:pathLst>
                  <a:path w="718" h="162">
                    <a:moveTo>
                      <a:pt x="0" y="0"/>
                    </a:moveTo>
                    <a:lnTo>
                      <a:pt x="0" y="162"/>
                    </a:lnTo>
                    <a:lnTo>
                      <a:pt x="718" y="162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5" name="Freeform 479"/>
              <p:cNvSpPr>
                <a:spLocks/>
              </p:cNvSpPr>
              <p:nvPr/>
            </p:nvSpPr>
            <p:spPr bwMode="auto">
              <a:xfrm>
                <a:off x="758" y="1544"/>
                <a:ext cx="23" cy="242"/>
              </a:xfrm>
              <a:custGeom>
                <a:avLst/>
                <a:gdLst/>
                <a:ahLst/>
                <a:cxnLst>
                  <a:cxn ang="0">
                    <a:pos x="0" y="242"/>
                  </a:cxn>
                  <a:cxn ang="0">
                    <a:pos x="0" y="0"/>
                  </a:cxn>
                  <a:cxn ang="0">
                    <a:pos x="23" y="0"/>
                  </a:cxn>
                </a:cxnLst>
                <a:rect l="0" t="0" r="r" b="b"/>
                <a:pathLst>
                  <a:path w="23" h="242">
                    <a:moveTo>
                      <a:pt x="0" y="242"/>
                    </a:moveTo>
                    <a:lnTo>
                      <a:pt x="0" y="0"/>
                    </a:lnTo>
                    <a:lnTo>
                      <a:pt x="2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6" name="Rectangle 480"/>
              <p:cNvSpPr>
                <a:spLocks noChangeArrowheads="1"/>
              </p:cNvSpPr>
              <p:nvPr/>
            </p:nvSpPr>
            <p:spPr bwMode="auto">
              <a:xfrm>
                <a:off x="1508" y="1824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020</a:t>
                </a:r>
              </a:p>
            </p:txBody>
          </p:sp>
          <p:sp>
            <p:nvSpPr>
              <p:cNvPr id="657" name="Freeform 481"/>
              <p:cNvSpPr>
                <a:spLocks/>
              </p:cNvSpPr>
              <p:nvPr/>
            </p:nvSpPr>
            <p:spPr bwMode="auto">
              <a:xfrm>
                <a:off x="1504" y="1871"/>
                <a:ext cx="1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1" y="0"/>
                  </a:cxn>
                </a:cxnLst>
                <a:rect l="0" t="0" r="r" b="b"/>
                <a:pathLst>
                  <a:path w="1" h="51">
                    <a:moveTo>
                      <a:pt x="0" y="51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58" name="Rectangle 482"/>
              <p:cNvSpPr>
                <a:spLocks noChangeArrowheads="1"/>
              </p:cNvSpPr>
              <p:nvPr/>
            </p:nvSpPr>
            <p:spPr bwMode="auto">
              <a:xfrm>
                <a:off x="1555" y="1932"/>
                <a:ext cx="47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120</a:t>
                </a:r>
              </a:p>
            </p:txBody>
          </p:sp>
          <p:sp>
            <p:nvSpPr>
              <p:cNvPr id="659" name="Freeform 483"/>
              <p:cNvSpPr>
                <a:spLocks/>
              </p:cNvSpPr>
              <p:nvPr/>
            </p:nvSpPr>
            <p:spPr bwMode="auto">
              <a:xfrm>
                <a:off x="1504" y="1928"/>
                <a:ext cx="48" cy="5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48" y="51"/>
                  </a:cxn>
                </a:cxnLst>
                <a:rect l="0" t="0" r="r" b="b"/>
                <a:pathLst>
                  <a:path w="48" h="51">
                    <a:moveTo>
                      <a:pt x="0" y="0"/>
                    </a:moveTo>
                    <a:lnTo>
                      <a:pt x="0" y="51"/>
                    </a:lnTo>
                    <a:lnTo>
                      <a:pt x="48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0" name="Freeform 484"/>
              <p:cNvSpPr>
                <a:spLocks/>
              </p:cNvSpPr>
              <p:nvPr/>
            </p:nvSpPr>
            <p:spPr bwMode="auto">
              <a:xfrm>
                <a:off x="833" y="1925"/>
                <a:ext cx="671" cy="105"/>
              </a:xfrm>
              <a:custGeom>
                <a:avLst/>
                <a:gdLst/>
                <a:ahLst/>
                <a:cxnLst>
                  <a:cxn ang="0">
                    <a:pos x="0" y="105"/>
                  </a:cxn>
                  <a:cxn ang="0">
                    <a:pos x="0" y="0"/>
                  </a:cxn>
                  <a:cxn ang="0">
                    <a:pos x="671" y="0"/>
                  </a:cxn>
                </a:cxnLst>
                <a:rect l="0" t="0" r="r" b="b"/>
                <a:pathLst>
                  <a:path w="671" h="105">
                    <a:moveTo>
                      <a:pt x="0" y="105"/>
                    </a:moveTo>
                    <a:lnTo>
                      <a:pt x="0" y="0"/>
                    </a:lnTo>
                    <a:lnTo>
                      <a:pt x="67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1" name="Rectangle 485"/>
              <p:cNvSpPr>
                <a:spLocks noChangeArrowheads="1"/>
              </p:cNvSpPr>
              <p:nvPr/>
            </p:nvSpPr>
            <p:spPr bwMode="auto">
              <a:xfrm>
                <a:off x="1862" y="2040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040</a:t>
                </a:r>
              </a:p>
            </p:txBody>
          </p:sp>
          <p:sp>
            <p:nvSpPr>
              <p:cNvPr id="662" name="Freeform 486"/>
              <p:cNvSpPr>
                <a:spLocks/>
              </p:cNvSpPr>
              <p:nvPr/>
            </p:nvSpPr>
            <p:spPr bwMode="auto">
              <a:xfrm>
                <a:off x="1858" y="2087"/>
                <a:ext cx="1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1" y="0"/>
                  </a:cxn>
                </a:cxnLst>
                <a:rect l="0" t="0" r="r" b="b"/>
                <a:pathLst>
                  <a:path w="1" h="51">
                    <a:moveTo>
                      <a:pt x="0" y="51"/>
                    </a:moveTo>
                    <a:lnTo>
                      <a:pt x="0" y="0"/>
                    </a:lnTo>
                    <a:lnTo>
                      <a:pt x="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3" name="Rectangle 487"/>
              <p:cNvSpPr>
                <a:spLocks noChangeArrowheads="1"/>
              </p:cNvSpPr>
              <p:nvPr/>
            </p:nvSpPr>
            <p:spPr bwMode="auto">
              <a:xfrm>
                <a:off x="1909" y="2148"/>
                <a:ext cx="47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140</a:t>
                </a:r>
              </a:p>
            </p:txBody>
          </p:sp>
          <p:sp>
            <p:nvSpPr>
              <p:cNvPr id="664" name="Freeform 488"/>
              <p:cNvSpPr>
                <a:spLocks/>
              </p:cNvSpPr>
              <p:nvPr/>
            </p:nvSpPr>
            <p:spPr bwMode="auto">
              <a:xfrm>
                <a:off x="1858" y="2144"/>
                <a:ext cx="48" cy="5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48" y="51"/>
                  </a:cxn>
                </a:cxnLst>
                <a:rect l="0" t="0" r="r" b="b"/>
                <a:pathLst>
                  <a:path w="48" h="51">
                    <a:moveTo>
                      <a:pt x="0" y="0"/>
                    </a:moveTo>
                    <a:lnTo>
                      <a:pt x="0" y="51"/>
                    </a:lnTo>
                    <a:lnTo>
                      <a:pt x="48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5" name="Freeform 489"/>
              <p:cNvSpPr>
                <a:spLocks/>
              </p:cNvSpPr>
              <p:nvPr/>
            </p:nvSpPr>
            <p:spPr bwMode="auto">
              <a:xfrm>
                <a:off x="833" y="2036"/>
                <a:ext cx="1025" cy="10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05"/>
                  </a:cxn>
                  <a:cxn ang="0">
                    <a:pos x="1025" y="105"/>
                  </a:cxn>
                </a:cxnLst>
                <a:rect l="0" t="0" r="r" b="b"/>
                <a:pathLst>
                  <a:path w="1025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025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6" name="Freeform 490"/>
              <p:cNvSpPr>
                <a:spLocks/>
              </p:cNvSpPr>
              <p:nvPr/>
            </p:nvSpPr>
            <p:spPr bwMode="auto">
              <a:xfrm>
                <a:off x="758" y="1792"/>
                <a:ext cx="75" cy="24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241"/>
                  </a:cxn>
                  <a:cxn ang="0">
                    <a:pos x="75" y="241"/>
                  </a:cxn>
                </a:cxnLst>
                <a:rect l="0" t="0" r="r" b="b"/>
                <a:pathLst>
                  <a:path w="75" h="241">
                    <a:moveTo>
                      <a:pt x="0" y="0"/>
                    </a:moveTo>
                    <a:lnTo>
                      <a:pt x="0" y="241"/>
                    </a:lnTo>
                    <a:lnTo>
                      <a:pt x="75" y="24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7" name="Freeform 491"/>
              <p:cNvSpPr>
                <a:spLocks/>
              </p:cNvSpPr>
              <p:nvPr/>
            </p:nvSpPr>
            <p:spPr bwMode="auto">
              <a:xfrm>
                <a:off x="731" y="1789"/>
                <a:ext cx="27" cy="361"/>
              </a:xfrm>
              <a:custGeom>
                <a:avLst/>
                <a:gdLst/>
                <a:ahLst/>
                <a:cxnLst>
                  <a:cxn ang="0">
                    <a:pos x="0" y="361"/>
                  </a:cxn>
                  <a:cxn ang="0">
                    <a:pos x="0" y="0"/>
                  </a:cxn>
                  <a:cxn ang="0">
                    <a:pos x="27" y="0"/>
                  </a:cxn>
                </a:cxnLst>
                <a:rect l="0" t="0" r="r" b="b"/>
                <a:pathLst>
                  <a:path w="27" h="361">
                    <a:moveTo>
                      <a:pt x="0" y="361"/>
                    </a:moveTo>
                    <a:lnTo>
                      <a:pt x="0" y="0"/>
                    </a:lnTo>
                    <a:lnTo>
                      <a:pt x="27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68" name="Rectangle 492"/>
              <p:cNvSpPr>
                <a:spLocks noChangeArrowheads="1"/>
              </p:cNvSpPr>
              <p:nvPr/>
            </p:nvSpPr>
            <p:spPr bwMode="auto">
              <a:xfrm>
                <a:off x="1594" y="2256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050</a:t>
                </a:r>
              </a:p>
            </p:txBody>
          </p:sp>
          <p:sp>
            <p:nvSpPr>
              <p:cNvPr id="669" name="Freeform 493"/>
              <p:cNvSpPr>
                <a:spLocks/>
              </p:cNvSpPr>
              <p:nvPr/>
            </p:nvSpPr>
            <p:spPr bwMode="auto">
              <a:xfrm>
                <a:off x="1588" y="2303"/>
                <a:ext cx="3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3" y="0"/>
                  </a:cxn>
                </a:cxnLst>
                <a:rect l="0" t="0" r="r" b="b"/>
                <a:pathLst>
                  <a:path w="3" h="51">
                    <a:moveTo>
                      <a:pt x="0" y="51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0" name="Rectangle 494"/>
              <p:cNvSpPr>
                <a:spLocks noChangeArrowheads="1"/>
              </p:cNvSpPr>
              <p:nvPr/>
            </p:nvSpPr>
            <p:spPr bwMode="auto">
              <a:xfrm>
                <a:off x="1639" y="2364"/>
                <a:ext cx="47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150</a:t>
                </a:r>
              </a:p>
            </p:txBody>
          </p:sp>
          <p:sp>
            <p:nvSpPr>
              <p:cNvPr id="671" name="Freeform 495"/>
              <p:cNvSpPr>
                <a:spLocks/>
              </p:cNvSpPr>
              <p:nvPr/>
            </p:nvSpPr>
            <p:spPr bwMode="auto">
              <a:xfrm>
                <a:off x="1588" y="2360"/>
                <a:ext cx="48" cy="5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48" y="51"/>
                  </a:cxn>
                </a:cxnLst>
                <a:rect l="0" t="0" r="r" b="b"/>
                <a:pathLst>
                  <a:path w="48" h="51">
                    <a:moveTo>
                      <a:pt x="0" y="0"/>
                    </a:moveTo>
                    <a:lnTo>
                      <a:pt x="0" y="51"/>
                    </a:lnTo>
                    <a:lnTo>
                      <a:pt x="48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2" name="Freeform 496"/>
              <p:cNvSpPr>
                <a:spLocks/>
              </p:cNvSpPr>
              <p:nvPr/>
            </p:nvSpPr>
            <p:spPr bwMode="auto">
              <a:xfrm>
                <a:off x="784" y="2357"/>
                <a:ext cx="804" cy="159"/>
              </a:xfrm>
              <a:custGeom>
                <a:avLst/>
                <a:gdLst/>
                <a:ahLst/>
                <a:cxnLst>
                  <a:cxn ang="0">
                    <a:pos x="0" y="159"/>
                  </a:cxn>
                  <a:cxn ang="0">
                    <a:pos x="0" y="0"/>
                  </a:cxn>
                  <a:cxn ang="0">
                    <a:pos x="804" y="0"/>
                  </a:cxn>
                </a:cxnLst>
                <a:rect l="0" t="0" r="r" b="b"/>
                <a:pathLst>
                  <a:path w="804" h="159">
                    <a:moveTo>
                      <a:pt x="0" y="159"/>
                    </a:moveTo>
                    <a:lnTo>
                      <a:pt x="0" y="0"/>
                    </a:lnTo>
                    <a:lnTo>
                      <a:pt x="804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3" name="Rectangle 497"/>
              <p:cNvSpPr>
                <a:spLocks noChangeArrowheads="1"/>
              </p:cNvSpPr>
              <p:nvPr/>
            </p:nvSpPr>
            <p:spPr bwMode="auto">
              <a:xfrm>
                <a:off x="1786" y="2472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060</a:t>
                </a:r>
              </a:p>
            </p:txBody>
          </p:sp>
          <p:sp>
            <p:nvSpPr>
              <p:cNvPr id="674" name="Freeform 498"/>
              <p:cNvSpPr>
                <a:spLocks/>
              </p:cNvSpPr>
              <p:nvPr/>
            </p:nvSpPr>
            <p:spPr bwMode="auto">
              <a:xfrm>
                <a:off x="1762" y="2519"/>
                <a:ext cx="21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21" y="0"/>
                  </a:cxn>
                </a:cxnLst>
                <a:rect l="0" t="0" r="r" b="b"/>
                <a:pathLst>
                  <a:path w="21" h="51">
                    <a:moveTo>
                      <a:pt x="0" y="51"/>
                    </a:moveTo>
                    <a:lnTo>
                      <a:pt x="0" y="0"/>
                    </a:lnTo>
                    <a:lnTo>
                      <a:pt x="21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5" name="Rectangle 499"/>
              <p:cNvSpPr>
                <a:spLocks noChangeArrowheads="1"/>
              </p:cNvSpPr>
              <p:nvPr/>
            </p:nvSpPr>
            <p:spPr bwMode="auto">
              <a:xfrm>
                <a:off x="1769" y="2580"/>
                <a:ext cx="47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160</a:t>
                </a:r>
              </a:p>
            </p:txBody>
          </p:sp>
          <p:sp>
            <p:nvSpPr>
              <p:cNvPr id="676" name="Freeform 500"/>
              <p:cNvSpPr>
                <a:spLocks/>
              </p:cNvSpPr>
              <p:nvPr/>
            </p:nvSpPr>
            <p:spPr bwMode="auto">
              <a:xfrm>
                <a:off x="1762" y="2576"/>
                <a:ext cx="4" cy="5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4" y="51"/>
                  </a:cxn>
                </a:cxnLst>
                <a:rect l="0" t="0" r="r" b="b"/>
                <a:pathLst>
                  <a:path w="4" h="51">
                    <a:moveTo>
                      <a:pt x="0" y="0"/>
                    </a:moveTo>
                    <a:lnTo>
                      <a:pt x="0" y="51"/>
                    </a:lnTo>
                    <a:lnTo>
                      <a:pt x="4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7" name="Freeform 501"/>
              <p:cNvSpPr>
                <a:spLocks/>
              </p:cNvSpPr>
              <p:nvPr/>
            </p:nvSpPr>
            <p:spPr bwMode="auto">
              <a:xfrm>
                <a:off x="842" y="2573"/>
                <a:ext cx="920" cy="105"/>
              </a:xfrm>
              <a:custGeom>
                <a:avLst/>
                <a:gdLst/>
                <a:ahLst/>
                <a:cxnLst>
                  <a:cxn ang="0">
                    <a:pos x="0" y="105"/>
                  </a:cxn>
                  <a:cxn ang="0">
                    <a:pos x="0" y="0"/>
                  </a:cxn>
                  <a:cxn ang="0">
                    <a:pos x="920" y="0"/>
                  </a:cxn>
                </a:cxnLst>
                <a:rect l="0" t="0" r="r" b="b"/>
                <a:pathLst>
                  <a:path w="920" h="105">
                    <a:moveTo>
                      <a:pt x="0" y="105"/>
                    </a:moveTo>
                    <a:lnTo>
                      <a:pt x="0" y="0"/>
                    </a:lnTo>
                    <a:lnTo>
                      <a:pt x="920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78" name="Rectangle 502"/>
              <p:cNvSpPr>
                <a:spLocks noChangeArrowheads="1"/>
              </p:cNvSpPr>
              <p:nvPr/>
            </p:nvSpPr>
            <p:spPr bwMode="auto">
              <a:xfrm>
                <a:off x="1897" y="2688"/>
                <a:ext cx="53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A05Ak00070</a:t>
                </a:r>
              </a:p>
            </p:txBody>
          </p:sp>
          <p:sp>
            <p:nvSpPr>
              <p:cNvPr id="679" name="Freeform 503"/>
              <p:cNvSpPr>
                <a:spLocks/>
              </p:cNvSpPr>
              <p:nvPr/>
            </p:nvSpPr>
            <p:spPr bwMode="auto">
              <a:xfrm>
                <a:off x="1891" y="2735"/>
                <a:ext cx="3" cy="51"/>
              </a:xfrm>
              <a:custGeom>
                <a:avLst/>
                <a:gdLst/>
                <a:ahLst/>
                <a:cxnLst>
                  <a:cxn ang="0">
                    <a:pos x="0" y="51"/>
                  </a:cxn>
                  <a:cxn ang="0">
                    <a:pos x="0" y="0"/>
                  </a:cxn>
                  <a:cxn ang="0">
                    <a:pos x="3" y="0"/>
                  </a:cxn>
                </a:cxnLst>
                <a:rect l="0" t="0" r="r" b="b"/>
                <a:pathLst>
                  <a:path w="3" h="51">
                    <a:moveTo>
                      <a:pt x="0" y="51"/>
                    </a:moveTo>
                    <a:lnTo>
                      <a:pt x="0" y="0"/>
                    </a:lnTo>
                    <a:lnTo>
                      <a:pt x="3" y="0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0" name="Rectangle 504"/>
              <p:cNvSpPr>
                <a:spLocks noChangeArrowheads="1"/>
              </p:cNvSpPr>
              <p:nvPr/>
            </p:nvSpPr>
            <p:spPr bwMode="auto">
              <a:xfrm>
                <a:off x="1942" y="2796"/>
                <a:ext cx="473" cy="10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1" i="0" u="sng" strike="noStrike" cap="none" normalizeH="0" baseline="0" dirty="0" smtClean="0">
                    <a:ln>
                      <a:noFill/>
                    </a:ln>
                    <a:solidFill>
                      <a:srgbClr val="FF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 Pv05Sk01170</a:t>
                </a:r>
              </a:p>
            </p:txBody>
          </p:sp>
          <p:sp>
            <p:nvSpPr>
              <p:cNvPr id="681" name="Freeform 505"/>
              <p:cNvSpPr>
                <a:spLocks/>
              </p:cNvSpPr>
              <p:nvPr/>
            </p:nvSpPr>
            <p:spPr bwMode="auto">
              <a:xfrm>
                <a:off x="1891" y="2792"/>
                <a:ext cx="48" cy="51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51"/>
                  </a:cxn>
                  <a:cxn ang="0">
                    <a:pos x="48" y="51"/>
                  </a:cxn>
                </a:cxnLst>
                <a:rect l="0" t="0" r="r" b="b"/>
                <a:pathLst>
                  <a:path w="48" h="51">
                    <a:moveTo>
                      <a:pt x="0" y="0"/>
                    </a:moveTo>
                    <a:lnTo>
                      <a:pt x="0" y="51"/>
                    </a:lnTo>
                    <a:lnTo>
                      <a:pt x="48" y="51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2" name="Freeform 506"/>
              <p:cNvSpPr>
                <a:spLocks/>
              </p:cNvSpPr>
              <p:nvPr/>
            </p:nvSpPr>
            <p:spPr bwMode="auto">
              <a:xfrm>
                <a:off x="842" y="2684"/>
                <a:ext cx="1049" cy="105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05"/>
                  </a:cxn>
                  <a:cxn ang="0">
                    <a:pos x="1049" y="105"/>
                  </a:cxn>
                </a:cxnLst>
                <a:rect l="0" t="0" r="r" b="b"/>
                <a:pathLst>
                  <a:path w="1049" h="105">
                    <a:moveTo>
                      <a:pt x="0" y="0"/>
                    </a:moveTo>
                    <a:lnTo>
                      <a:pt x="0" y="105"/>
                    </a:lnTo>
                    <a:lnTo>
                      <a:pt x="1049" y="105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3" name="Freeform 507"/>
              <p:cNvSpPr>
                <a:spLocks/>
              </p:cNvSpPr>
              <p:nvPr/>
            </p:nvSpPr>
            <p:spPr bwMode="auto">
              <a:xfrm>
                <a:off x="784" y="2522"/>
                <a:ext cx="58" cy="159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159"/>
                  </a:cxn>
                  <a:cxn ang="0">
                    <a:pos x="58" y="159"/>
                  </a:cxn>
                </a:cxnLst>
                <a:rect l="0" t="0" r="r" b="b"/>
                <a:pathLst>
                  <a:path w="58" h="159">
                    <a:moveTo>
                      <a:pt x="0" y="0"/>
                    </a:moveTo>
                    <a:lnTo>
                      <a:pt x="0" y="159"/>
                    </a:lnTo>
                    <a:lnTo>
                      <a:pt x="58" y="159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4" name="Freeform 508"/>
              <p:cNvSpPr>
                <a:spLocks/>
              </p:cNvSpPr>
              <p:nvPr/>
            </p:nvSpPr>
            <p:spPr bwMode="auto">
              <a:xfrm>
                <a:off x="731" y="2156"/>
                <a:ext cx="53" cy="363"/>
              </a:xfrm>
              <a:custGeom>
                <a:avLst/>
                <a:gdLst/>
                <a:ahLst/>
                <a:cxnLst>
                  <a:cxn ang="0">
                    <a:pos x="0" y="0"/>
                  </a:cxn>
                  <a:cxn ang="0">
                    <a:pos x="0" y="363"/>
                  </a:cxn>
                  <a:cxn ang="0">
                    <a:pos x="53" y="363"/>
                  </a:cxn>
                </a:cxnLst>
                <a:rect l="0" t="0" r="r" b="b"/>
                <a:pathLst>
                  <a:path w="53" h="363">
                    <a:moveTo>
                      <a:pt x="0" y="0"/>
                    </a:moveTo>
                    <a:lnTo>
                      <a:pt x="0" y="363"/>
                    </a:lnTo>
                    <a:lnTo>
                      <a:pt x="53" y="363"/>
                    </a:lnTo>
                  </a:path>
                </a:pathLst>
              </a:cu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5" name="Line 509"/>
              <p:cNvSpPr>
                <a:spLocks noChangeShapeType="1"/>
              </p:cNvSpPr>
              <p:nvPr/>
            </p:nvSpPr>
            <p:spPr bwMode="auto">
              <a:xfrm>
                <a:off x="581" y="2153"/>
                <a:ext cx="150" cy="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miter lim="800000"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6" name="Rectangle 510"/>
              <p:cNvSpPr>
                <a:spLocks noChangeArrowheads="1"/>
              </p:cNvSpPr>
              <p:nvPr/>
            </p:nvSpPr>
            <p:spPr bwMode="auto">
              <a:xfrm>
                <a:off x="1627" y="2479"/>
                <a:ext cx="97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7" name="Rectangle 511"/>
              <p:cNvSpPr>
                <a:spLocks noChangeArrowheads="1"/>
              </p:cNvSpPr>
              <p:nvPr/>
            </p:nvSpPr>
            <p:spPr bwMode="auto">
              <a:xfrm>
                <a:off x="1741" y="2792"/>
                <a:ext cx="97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8" name="Rectangle 512"/>
              <p:cNvSpPr>
                <a:spLocks noChangeArrowheads="1"/>
              </p:cNvSpPr>
              <p:nvPr/>
            </p:nvSpPr>
            <p:spPr bwMode="auto">
              <a:xfrm>
                <a:off x="743" y="2700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20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89" name="Rectangle 513"/>
              <p:cNvSpPr>
                <a:spLocks noChangeArrowheads="1"/>
              </p:cNvSpPr>
              <p:nvPr/>
            </p:nvSpPr>
            <p:spPr bwMode="auto">
              <a:xfrm>
                <a:off x="1453" y="2263"/>
                <a:ext cx="97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0" name="Rectangle 514"/>
              <p:cNvSpPr>
                <a:spLocks noChangeArrowheads="1"/>
              </p:cNvSpPr>
              <p:nvPr/>
            </p:nvSpPr>
            <p:spPr bwMode="auto">
              <a:xfrm>
                <a:off x="685" y="2538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80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1" name="Rectangle 515"/>
              <p:cNvSpPr>
                <a:spLocks noChangeArrowheads="1"/>
              </p:cNvSpPr>
              <p:nvPr/>
            </p:nvSpPr>
            <p:spPr bwMode="auto">
              <a:xfrm>
                <a:off x="1369" y="1831"/>
                <a:ext cx="97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2" name="Rectangle 516"/>
              <p:cNvSpPr>
                <a:spLocks noChangeArrowheads="1"/>
              </p:cNvSpPr>
              <p:nvPr/>
            </p:nvSpPr>
            <p:spPr bwMode="auto">
              <a:xfrm>
                <a:off x="1718" y="2138"/>
                <a:ext cx="97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3" name="Rectangle 517"/>
              <p:cNvSpPr>
                <a:spLocks noChangeArrowheads="1"/>
              </p:cNvSpPr>
              <p:nvPr/>
            </p:nvSpPr>
            <p:spPr bwMode="auto">
              <a:xfrm>
                <a:off x="734" y="2052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44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4" name="Rectangle 518"/>
              <p:cNvSpPr>
                <a:spLocks noChangeArrowheads="1"/>
              </p:cNvSpPr>
              <p:nvPr/>
            </p:nvSpPr>
            <p:spPr bwMode="auto">
              <a:xfrm>
                <a:off x="1364" y="1728"/>
                <a:ext cx="97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5" name="Rectangle 519"/>
              <p:cNvSpPr>
                <a:spLocks noChangeArrowheads="1"/>
              </p:cNvSpPr>
              <p:nvPr/>
            </p:nvSpPr>
            <p:spPr bwMode="auto">
              <a:xfrm>
                <a:off x="1736" y="1388"/>
                <a:ext cx="97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6" name="Rectangle 520"/>
              <p:cNvSpPr>
                <a:spLocks noChangeArrowheads="1"/>
              </p:cNvSpPr>
              <p:nvPr/>
            </p:nvSpPr>
            <p:spPr bwMode="auto">
              <a:xfrm>
                <a:off x="1900" y="1172"/>
                <a:ext cx="97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100</a:t>
                </a:r>
                <a:endParaRPr kumimoji="0" lang="fr-FR" sz="800" b="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7" name="Rectangle 521"/>
              <p:cNvSpPr>
                <a:spLocks noChangeArrowheads="1"/>
              </p:cNvSpPr>
              <p:nvPr/>
            </p:nvSpPr>
            <p:spPr bwMode="auto">
              <a:xfrm>
                <a:off x="1907" y="751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9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8" name="Rectangle 522"/>
              <p:cNvSpPr>
                <a:spLocks noChangeArrowheads="1"/>
              </p:cNvSpPr>
              <p:nvPr/>
            </p:nvSpPr>
            <p:spPr bwMode="auto">
              <a:xfrm>
                <a:off x="1708" y="832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9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699" name="Rectangle 523"/>
              <p:cNvSpPr>
                <a:spLocks noChangeArrowheads="1"/>
              </p:cNvSpPr>
              <p:nvPr/>
            </p:nvSpPr>
            <p:spPr bwMode="auto">
              <a:xfrm>
                <a:off x="1364" y="954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8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0" name="Rectangle 524"/>
              <p:cNvSpPr>
                <a:spLocks noChangeArrowheads="1"/>
              </p:cNvSpPr>
              <p:nvPr/>
            </p:nvSpPr>
            <p:spPr bwMode="auto">
              <a:xfrm>
                <a:off x="1084" y="1122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8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1" name="Rectangle 525"/>
              <p:cNvSpPr>
                <a:spLocks noChangeArrowheads="1"/>
              </p:cNvSpPr>
              <p:nvPr/>
            </p:nvSpPr>
            <p:spPr bwMode="auto">
              <a:xfrm>
                <a:off x="841" y="1287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94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2" name="Rectangle 526"/>
              <p:cNvSpPr>
                <a:spLocks noChangeArrowheads="1"/>
              </p:cNvSpPr>
              <p:nvPr/>
            </p:nvSpPr>
            <p:spPr bwMode="auto">
              <a:xfrm>
                <a:off x="682" y="1450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70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3" name="Rectangle 527"/>
              <p:cNvSpPr>
                <a:spLocks noChangeArrowheads="1"/>
              </p:cNvSpPr>
              <p:nvPr/>
            </p:nvSpPr>
            <p:spPr bwMode="auto">
              <a:xfrm>
                <a:off x="659" y="1695"/>
                <a:ext cx="65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72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4" name="Line 528"/>
              <p:cNvSpPr>
                <a:spLocks noChangeShapeType="1"/>
              </p:cNvSpPr>
              <p:nvPr/>
            </p:nvSpPr>
            <p:spPr bwMode="auto">
              <a:xfrm>
                <a:off x="1031" y="2888"/>
                <a:ext cx="156" cy="1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5" name="Line 529"/>
              <p:cNvSpPr>
                <a:spLocks noChangeShapeType="1"/>
              </p:cNvSpPr>
              <p:nvPr/>
            </p:nvSpPr>
            <p:spPr bwMode="auto">
              <a:xfrm>
                <a:off x="1031" y="2864"/>
                <a:ext cx="1" cy="4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6" name="Line 530"/>
              <p:cNvSpPr>
                <a:spLocks noChangeShapeType="1"/>
              </p:cNvSpPr>
              <p:nvPr/>
            </p:nvSpPr>
            <p:spPr bwMode="auto">
              <a:xfrm>
                <a:off x="1187" y="2864"/>
                <a:ext cx="1" cy="48"/>
              </a:xfrm>
              <a:prstGeom prst="line">
                <a:avLst/>
              </a:prstGeom>
              <a:noFill/>
              <a:ln w="9525" cap="sq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80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707" name="Rectangle 531"/>
              <p:cNvSpPr>
                <a:spLocks noChangeArrowheads="1"/>
              </p:cNvSpPr>
              <p:nvPr/>
            </p:nvSpPr>
            <p:spPr bwMode="auto">
              <a:xfrm>
                <a:off x="1046" y="2912"/>
                <a:ext cx="113" cy="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/>
              <a:p>
                <a:pPr marL="0" marR="0" lvl="0" indent="0" algn="l" defTabSz="914400" rtl="0" eaLnBrk="1" fontAlgn="base" latinLnBrk="0" hangingPunct="1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fr-FR" sz="800" b="0" i="0" u="none" strike="noStrike" cap="none" normalizeH="0" baseline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itchFamily="18" charset="0"/>
                    <a:cs typeface="Times New Roman" pitchFamily="18" charset="0"/>
                  </a:rPr>
                  <a:t>0.01</a:t>
                </a:r>
                <a:endParaRPr kumimoji="0" lang="fr-FR" sz="800" b="0" i="0" u="none" strike="noStrike" cap="none" normalizeH="0" baseline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88" name="ZoneTexte 87"/>
            <p:cNvSpPr txBox="1"/>
            <p:nvPr/>
          </p:nvSpPr>
          <p:spPr>
            <a:xfrm>
              <a:off x="84667" y="1602335"/>
              <a:ext cx="897745" cy="577081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fr-FR" sz="700" spc="-50" dirty="0" smtClean="0">
                  <a:solidFill>
                    <a:schemeClr val="bg1">
                      <a:lumMod val="50000"/>
                    </a:schemeClr>
                  </a:solidFill>
                  <a:latin typeface="Times New Roman" pitchFamily="18" charset="0"/>
                  <a:cs typeface="Times New Roman" pitchFamily="18" charset="0"/>
                </a:rPr>
                <a:t>PvA05Ak00010</a:t>
              </a:r>
              <a:endParaRPr lang="fr-FR" sz="700" spc="-50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02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03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04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05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06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07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08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09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10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11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120</a:t>
              </a:r>
            </a:p>
            <a:p>
              <a:pPr algn="r"/>
              <a:r>
                <a:rPr lang="fr-FR" sz="700" spc="-50" dirty="0" smtClean="0">
                  <a:solidFill>
                    <a:schemeClr val="bg1">
                      <a:lumMod val="50000"/>
                    </a:schemeClr>
                  </a:solidFill>
                  <a:latin typeface="Times New Roman" pitchFamily="18" charset="0"/>
                  <a:cs typeface="Times New Roman" pitchFamily="18" charset="0"/>
                </a:rPr>
                <a:t>PvA05Ak00130</a:t>
              </a:r>
            </a:p>
            <a:p>
              <a:pPr algn="r"/>
              <a:r>
                <a:rPr lang="fr-FR" sz="700" spc="-50" dirty="0" smtClean="0">
                  <a:solidFill>
                    <a:schemeClr val="bg1">
                      <a:lumMod val="50000"/>
                    </a:schemeClr>
                  </a:solidFill>
                  <a:latin typeface="Times New Roman" pitchFamily="18" charset="0"/>
                  <a:cs typeface="Times New Roman" pitchFamily="18" charset="0"/>
                </a:rPr>
                <a:t>PvA05Ak00140</a:t>
              </a:r>
            </a:p>
            <a:p>
              <a:pPr algn="r"/>
              <a:r>
                <a:rPr lang="fr-FR" sz="700" spc="-50" dirty="0" smtClean="0">
                  <a:solidFill>
                    <a:schemeClr val="bg1">
                      <a:lumMod val="50000"/>
                    </a:schemeClr>
                  </a:solidFill>
                  <a:latin typeface="Times New Roman" pitchFamily="18" charset="0"/>
                  <a:cs typeface="Times New Roman" pitchFamily="18" charset="0"/>
                </a:rPr>
                <a:t>PvA05Ak00150</a:t>
              </a:r>
              <a:endParaRPr lang="fr-FR" sz="800" spc="-50" dirty="0" smtClean="0">
                <a:solidFill>
                  <a:schemeClr val="bg1">
                    <a:lumMod val="50000"/>
                  </a:schemeClr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16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17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18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19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0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1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2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3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4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5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6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7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8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29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30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31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32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33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34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350</a:t>
              </a:r>
            </a:p>
            <a:p>
              <a:pPr algn="r"/>
              <a:endParaRPr lang="fr-FR" sz="800" spc="-50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/>
              <a:endParaRPr lang="fr-FR" sz="800" spc="-50" dirty="0" smtClean="0">
                <a:solidFill>
                  <a:schemeClr val="bg1">
                    <a:lumMod val="50000"/>
                  </a:schemeClr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360</a:t>
              </a:r>
            </a:p>
            <a:p>
              <a:pPr algn="r"/>
              <a:r>
                <a:rPr lang="fr-FR" sz="700" spc="-50" dirty="0" smtClean="0">
                  <a:solidFill>
                    <a:schemeClr val="bg1">
                      <a:lumMod val="50000"/>
                    </a:schemeClr>
                  </a:solidFill>
                  <a:latin typeface="Times New Roman" pitchFamily="18" charset="0"/>
                  <a:cs typeface="Times New Roman" pitchFamily="18" charset="0"/>
                </a:rPr>
                <a:t>PvA05Ak00370</a:t>
              </a:r>
              <a:endParaRPr lang="fr-FR" sz="800" spc="-50" dirty="0" smtClean="0">
                <a:latin typeface="Times New Roman" pitchFamily="18" charset="0"/>
                <a:cs typeface="Times New Roman" pitchFamily="18" charset="0"/>
              </a:endParaRP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38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39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40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410</a:t>
              </a: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420</a:t>
              </a:r>
            </a:p>
            <a:p>
              <a:pPr algn="r"/>
              <a:endParaRPr lang="fr-FR" sz="600" spc="-50" dirty="0" smtClean="0">
                <a:solidFill>
                  <a:srgbClr val="FF0000"/>
                </a:solidFill>
                <a:latin typeface="Times New Roman" pitchFamily="18" charset="0"/>
                <a:cs typeface="Times New Roman" pitchFamily="18" charset="0"/>
              </a:endParaRPr>
            </a:p>
            <a:p>
              <a:pPr algn="r"/>
              <a:r>
                <a:rPr lang="fr-FR" sz="800" spc="-50" dirty="0" smtClean="0">
                  <a:solidFill>
                    <a:srgbClr val="FF0000"/>
                  </a:solidFill>
                  <a:latin typeface="Times New Roman" pitchFamily="18" charset="0"/>
                  <a:cs typeface="Times New Roman" pitchFamily="18" charset="0"/>
                </a:rPr>
                <a:t>PvA05Ak00430</a:t>
              </a:r>
            </a:p>
            <a:p>
              <a:endParaRPr lang="fr-FR" sz="800" spc="-50" dirty="0"/>
            </a:p>
          </p:txBody>
        </p:sp>
      </p:grp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>Upload</StageName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1.PPTX</DocumentId>
    <DocumentType xmlns="370fed10-a368-469c-a864-2e77a9536334">Presentation</DocumentType>
    <TitleName xmlns="370fed10-a368-469c-a864-2e77a9536334">Presentation 1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F5FA9354-4446-470C-B328-213F005AA51C}"/>
</file>

<file path=customXml/itemProps2.xml><?xml version="1.0" encoding="utf-8"?>
<ds:datastoreItem xmlns:ds="http://schemas.openxmlformats.org/officeDocument/2006/customXml" ds:itemID="{6FB2728B-C0BB-4D6C-8E5A-68F807D6F25F}"/>
</file>

<file path=customXml/itemProps3.xml><?xml version="1.0" encoding="utf-8"?>
<ds:datastoreItem xmlns:ds="http://schemas.openxmlformats.org/officeDocument/2006/customXml" ds:itemID="{0131268E-767C-45FC-BDBA-B326C035BF16}"/>
</file>

<file path=docProps/app.xml><?xml version="1.0" encoding="utf-8"?>
<Properties xmlns="http://schemas.openxmlformats.org/officeDocument/2006/extended-properties" xmlns:vt="http://schemas.openxmlformats.org/officeDocument/2006/docPropsVTypes">
  <TotalTime>186</TotalTime>
  <Words>265</Words>
  <Application>Microsoft Macintosh PowerPoint</Application>
  <PresentationFormat>On-screen Show (4:3)</PresentationFormat>
  <Paragraphs>225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hème Offic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manon.richard</dc:creator>
  <cp:lastModifiedBy>Johanna Reichen</cp:lastModifiedBy>
  <cp:revision>20</cp:revision>
  <dcterms:created xsi:type="dcterms:W3CDTF">2013-03-25T16:55:22Z</dcterms:created>
  <dcterms:modified xsi:type="dcterms:W3CDTF">2013-04-18T09:34:25Z</dcterms:modified>
</cp:coreProperties>
</file>